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62" r:id="rId3"/>
    <p:sldId id="257" r:id="rId4"/>
    <p:sldId id="258" r:id="rId5"/>
  </p:sldIdLst>
  <p:sldSz cx="6858000" cy="9144000" type="letter"/>
  <p:notesSz cx="6950075"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B76851E-49FD-48D9-93AB-02CF62F5D00A}" v="8" dt="2021-12-28T19:00:43.48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022" autoAdjust="0"/>
    <p:restoredTop sz="94660"/>
  </p:normalViewPr>
  <p:slideViewPr>
    <p:cSldViewPr snapToGrid="0">
      <p:cViewPr varScale="1">
        <p:scale>
          <a:sx n="86" d="100"/>
          <a:sy n="86" d="100"/>
        </p:scale>
        <p:origin x="282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erelygina, Ludmila M. (CDC/DDID/NCIRD/DVD)" userId="7d3b25f4-6f80-4483-bceb-5fdc4e1f170d" providerId="ADAL" clId="{169A92FD-8003-4C00-B6F0-FB86B8D32D01}"/>
    <pc:docChg chg="modSld">
      <pc:chgData name="Perelygina, Ludmila M. (CDC/DDID/NCIRD/DVD)" userId="7d3b25f4-6f80-4483-bceb-5fdc4e1f170d" providerId="ADAL" clId="{169A92FD-8003-4C00-B6F0-FB86B8D32D01}" dt="2021-12-07T19:17:25.156" v="1" actId="1076"/>
      <pc:docMkLst>
        <pc:docMk/>
      </pc:docMkLst>
      <pc:sldChg chg="modSp mod">
        <pc:chgData name="Perelygina, Ludmila M. (CDC/DDID/NCIRD/DVD)" userId="7d3b25f4-6f80-4483-bceb-5fdc4e1f170d" providerId="ADAL" clId="{169A92FD-8003-4C00-B6F0-FB86B8D32D01}" dt="2021-12-07T19:17:25.156" v="1" actId="1076"/>
        <pc:sldMkLst>
          <pc:docMk/>
          <pc:sldMk cId="2864907532" sldId="257"/>
        </pc:sldMkLst>
        <pc:spChg chg="mod">
          <ac:chgData name="Perelygina, Ludmila M. (CDC/DDID/NCIRD/DVD)" userId="7d3b25f4-6f80-4483-bceb-5fdc4e1f170d" providerId="ADAL" clId="{169A92FD-8003-4C00-B6F0-FB86B8D32D01}" dt="2021-12-07T19:17:25.156" v="1" actId="1076"/>
          <ac:spMkLst>
            <pc:docMk/>
            <pc:sldMk cId="2864907532" sldId="257"/>
            <ac:spMk id="7" creationId="{25F8C4D2-91FA-45EE-A853-F7E40B93AE51}"/>
          </ac:spMkLst>
        </pc:spChg>
        <pc:graphicFrameChg chg="mod modGraphic">
          <ac:chgData name="Perelygina, Ludmila M. (CDC/DDID/NCIRD/DVD)" userId="7d3b25f4-6f80-4483-bceb-5fdc4e1f170d" providerId="ADAL" clId="{169A92FD-8003-4C00-B6F0-FB86B8D32D01}" dt="2021-12-07T19:17:14.435" v="0" actId="14100"/>
          <ac:graphicFrameMkLst>
            <pc:docMk/>
            <pc:sldMk cId="2864907532" sldId="257"/>
            <ac:graphicFrameMk id="3" creationId="{618FF06B-4D82-408A-B002-DEED8867C78D}"/>
          </ac:graphicFrameMkLst>
        </pc:graphicFrameChg>
      </pc:sldChg>
    </pc:docChg>
  </pc:docChgLst>
  <pc:docChgLst>
    <pc:chgData name="Perelygina, Ludmila M. (CDC/DDID/NCIRD/DVD)" userId="7d3b25f4-6f80-4483-bceb-5fdc4e1f170d" providerId="ADAL" clId="{FB76851E-49FD-48D9-93AB-02CF62F5D00A}"/>
    <pc:docChg chg="undo custSel modSld">
      <pc:chgData name="Perelygina, Ludmila M. (CDC/DDID/NCIRD/DVD)" userId="7d3b25f4-6f80-4483-bceb-5fdc4e1f170d" providerId="ADAL" clId="{FB76851E-49FD-48D9-93AB-02CF62F5D00A}" dt="2021-12-28T19:15:11.919" v="92" actId="20577"/>
      <pc:docMkLst>
        <pc:docMk/>
      </pc:docMkLst>
      <pc:sldChg chg="addSp delSp modSp mod">
        <pc:chgData name="Perelygina, Ludmila M. (CDC/DDID/NCIRD/DVD)" userId="7d3b25f4-6f80-4483-bceb-5fdc4e1f170d" providerId="ADAL" clId="{FB76851E-49FD-48D9-93AB-02CF62F5D00A}" dt="2021-12-28T18:51:42.277" v="39" actId="1076"/>
        <pc:sldMkLst>
          <pc:docMk/>
          <pc:sldMk cId="1726942282" sldId="256"/>
        </pc:sldMkLst>
        <pc:spChg chg="mod">
          <ac:chgData name="Perelygina, Ludmila M. (CDC/DDID/NCIRD/DVD)" userId="7d3b25f4-6f80-4483-bceb-5fdc4e1f170d" providerId="ADAL" clId="{FB76851E-49FD-48D9-93AB-02CF62F5D00A}" dt="2021-12-28T18:51:37.699" v="38" actId="165"/>
          <ac:spMkLst>
            <pc:docMk/>
            <pc:sldMk cId="1726942282" sldId="256"/>
            <ac:spMk id="2" creationId="{CB621483-F3E7-4FEA-A899-E8A6CDC87B17}"/>
          </ac:spMkLst>
        </pc:spChg>
        <pc:spChg chg="mod">
          <ac:chgData name="Perelygina, Ludmila M. (CDC/DDID/NCIRD/DVD)" userId="7d3b25f4-6f80-4483-bceb-5fdc4e1f170d" providerId="ADAL" clId="{FB76851E-49FD-48D9-93AB-02CF62F5D00A}" dt="2021-12-28T18:51:37.699" v="38" actId="165"/>
          <ac:spMkLst>
            <pc:docMk/>
            <pc:sldMk cId="1726942282" sldId="256"/>
            <ac:spMk id="22" creationId="{28E9742F-967C-495B-98AE-B13CDB4433BD}"/>
          </ac:spMkLst>
        </pc:spChg>
        <pc:spChg chg="mod">
          <ac:chgData name="Perelygina, Ludmila M. (CDC/DDID/NCIRD/DVD)" userId="7d3b25f4-6f80-4483-bceb-5fdc4e1f170d" providerId="ADAL" clId="{FB76851E-49FD-48D9-93AB-02CF62F5D00A}" dt="2021-12-28T18:51:37.699" v="38" actId="165"/>
          <ac:spMkLst>
            <pc:docMk/>
            <pc:sldMk cId="1726942282" sldId="256"/>
            <ac:spMk id="23" creationId="{A95AC4B7-55A3-4252-9537-9CAF6E68D90D}"/>
          </ac:spMkLst>
        </pc:spChg>
        <pc:spChg chg="mod">
          <ac:chgData name="Perelygina, Ludmila M. (CDC/DDID/NCIRD/DVD)" userId="7d3b25f4-6f80-4483-bceb-5fdc4e1f170d" providerId="ADAL" clId="{FB76851E-49FD-48D9-93AB-02CF62F5D00A}" dt="2021-12-28T18:51:37.699" v="38" actId="165"/>
          <ac:spMkLst>
            <pc:docMk/>
            <pc:sldMk cId="1726942282" sldId="256"/>
            <ac:spMk id="24" creationId="{2B31BB06-72FE-4ABA-BF93-4E8CF8DA1C22}"/>
          </ac:spMkLst>
        </pc:spChg>
        <pc:spChg chg="mod">
          <ac:chgData name="Perelygina, Ludmila M. (CDC/DDID/NCIRD/DVD)" userId="7d3b25f4-6f80-4483-bceb-5fdc4e1f170d" providerId="ADAL" clId="{FB76851E-49FD-48D9-93AB-02CF62F5D00A}" dt="2021-12-28T18:51:37.699" v="38" actId="165"/>
          <ac:spMkLst>
            <pc:docMk/>
            <pc:sldMk cId="1726942282" sldId="256"/>
            <ac:spMk id="27" creationId="{31081107-8B6E-4854-8798-339AAEE63DB2}"/>
          </ac:spMkLst>
        </pc:spChg>
        <pc:spChg chg="mod topLvl">
          <ac:chgData name="Perelygina, Ludmila M. (CDC/DDID/NCIRD/DVD)" userId="7d3b25f4-6f80-4483-bceb-5fdc4e1f170d" providerId="ADAL" clId="{FB76851E-49FD-48D9-93AB-02CF62F5D00A}" dt="2021-12-28T18:51:42.277" v="39" actId="1076"/>
          <ac:spMkLst>
            <pc:docMk/>
            <pc:sldMk cId="1726942282" sldId="256"/>
            <ac:spMk id="31" creationId="{0FDB5CC8-C87A-401D-BB20-75EED81FE036}"/>
          </ac:spMkLst>
        </pc:spChg>
        <pc:spChg chg="mod">
          <ac:chgData name="Perelygina, Ludmila M. (CDC/DDID/NCIRD/DVD)" userId="7d3b25f4-6f80-4483-bceb-5fdc4e1f170d" providerId="ADAL" clId="{FB76851E-49FD-48D9-93AB-02CF62F5D00A}" dt="2021-12-28T18:51:37.699" v="38" actId="165"/>
          <ac:spMkLst>
            <pc:docMk/>
            <pc:sldMk cId="1726942282" sldId="256"/>
            <ac:spMk id="32" creationId="{0EE872E1-6946-43B9-B775-7BDD4BBBA48E}"/>
          </ac:spMkLst>
        </pc:spChg>
        <pc:spChg chg="mod">
          <ac:chgData name="Perelygina, Ludmila M. (CDC/DDID/NCIRD/DVD)" userId="7d3b25f4-6f80-4483-bceb-5fdc4e1f170d" providerId="ADAL" clId="{FB76851E-49FD-48D9-93AB-02CF62F5D00A}" dt="2021-12-28T18:51:37.699" v="38" actId="165"/>
          <ac:spMkLst>
            <pc:docMk/>
            <pc:sldMk cId="1726942282" sldId="256"/>
            <ac:spMk id="33" creationId="{89308FB0-74C8-499A-BA92-A3B2936A6A60}"/>
          </ac:spMkLst>
        </pc:spChg>
        <pc:spChg chg="mod">
          <ac:chgData name="Perelygina, Ludmila M. (CDC/DDID/NCIRD/DVD)" userId="7d3b25f4-6f80-4483-bceb-5fdc4e1f170d" providerId="ADAL" clId="{FB76851E-49FD-48D9-93AB-02CF62F5D00A}" dt="2021-12-28T18:51:37.699" v="38" actId="165"/>
          <ac:spMkLst>
            <pc:docMk/>
            <pc:sldMk cId="1726942282" sldId="256"/>
            <ac:spMk id="34" creationId="{54953B60-0DDF-490C-944F-15629ECB354E}"/>
          </ac:spMkLst>
        </pc:spChg>
        <pc:spChg chg="mod">
          <ac:chgData name="Perelygina, Ludmila M. (CDC/DDID/NCIRD/DVD)" userId="7d3b25f4-6f80-4483-bceb-5fdc4e1f170d" providerId="ADAL" clId="{FB76851E-49FD-48D9-93AB-02CF62F5D00A}" dt="2021-12-28T18:51:37.699" v="38" actId="165"/>
          <ac:spMkLst>
            <pc:docMk/>
            <pc:sldMk cId="1726942282" sldId="256"/>
            <ac:spMk id="35" creationId="{24B4AFBB-41BA-44FB-A177-5A8F37DAEF4F}"/>
          </ac:spMkLst>
        </pc:spChg>
        <pc:spChg chg="mod">
          <ac:chgData name="Perelygina, Ludmila M. (CDC/DDID/NCIRD/DVD)" userId="7d3b25f4-6f80-4483-bceb-5fdc4e1f170d" providerId="ADAL" clId="{FB76851E-49FD-48D9-93AB-02CF62F5D00A}" dt="2021-12-28T18:51:37.699" v="38" actId="165"/>
          <ac:spMkLst>
            <pc:docMk/>
            <pc:sldMk cId="1726942282" sldId="256"/>
            <ac:spMk id="36" creationId="{0E03541F-E13D-4A27-AF7E-7AA2AF294BE5}"/>
          </ac:spMkLst>
        </pc:spChg>
        <pc:spChg chg="mod">
          <ac:chgData name="Perelygina, Ludmila M. (CDC/DDID/NCIRD/DVD)" userId="7d3b25f4-6f80-4483-bceb-5fdc4e1f170d" providerId="ADAL" clId="{FB76851E-49FD-48D9-93AB-02CF62F5D00A}" dt="2021-12-28T18:51:37.699" v="38" actId="165"/>
          <ac:spMkLst>
            <pc:docMk/>
            <pc:sldMk cId="1726942282" sldId="256"/>
            <ac:spMk id="40" creationId="{029DD118-3494-44A1-AAEA-FFD9800DC169}"/>
          </ac:spMkLst>
        </pc:spChg>
        <pc:spChg chg="mod">
          <ac:chgData name="Perelygina, Ludmila M. (CDC/DDID/NCIRD/DVD)" userId="7d3b25f4-6f80-4483-bceb-5fdc4e1f170d" providerId="ADAL" clId="{FB76851E-49FD-48D9-93AB-02CF62F5D00A}" dt="2021-12-28T18:51:37.699" v="38" actId="165"/>
          <ac:spMkLst>
            <pc:docMk/>
            <pc:sldMk cId="1726942282" sldId="256"/>
            <ac:spMk id="41" creationId="{73889C25-00C8-4042-A28B-ED27F749BFBE}"/>
          </ac:spMkLst>
        </pc:spChg>
        <pc:spChg chg="mod">
          <ac:chgData name="Perelygina, Ludmila M. (CDC/DDID/NCIRD/DVD)" userId="7d3b25f4-6f80-4483-bceb-5fdc4e1f170d" providerId="ADAL" clId="{FB76851E-49FD-48D9-93AB-02CF62F5D00A}" dt="2021-12-28T18:51:37.699" v="38" actId="165"/>
          <ac:spMkLst>
            <pc:docMk/>
            <pc:sldMk cId="1726942282" sldId="256"/>
            <ac:spMk id="42" creationId="{680668E6-0D97-486A-98A4-44A5DEAA6EF4}"/>
          </ac:spMkLst>
        </pc:spChg>
        <pc:spChg chg="mod">
          <ac:chgData name="Perelygina, Ludmila M. (CDC/DDID/NCIRD/DVD)" userId="7d3b25f4-6f80-4483-bceb-5fdc4e1f170d" providerId="ADAL" clId="{FB76851E-49FD-48D9-93AB-02CF62F5D00A}" dt="2021-12-28T18:51:37.699" v="38" actId="165"/>
          <ac:spMkLst>
            <pc:docMk/>
            <pc:sldMk cId="1726942282" sldId="256"/>
            <ac:spMk id="43" creationId="{3575D2A5-95B6-4C1B-BA18-611C66586B18}"/>
          </ac:spMkLst>
        </pc:spChg>
        <pc:spChg chg="mod">
          <ac:chgData name="Perelygina, Ludmila M. (CDC/DDID/NCIRD/DVD)" userId="7d3b25f4-6f80-4483-bceb-5fdc4e1f170d" providerId="ADAL" clId="{FB76851E-49FD-48D9-93AB-02CF62F5D00A}" dt="2021-12-28T18:51:37.699" v="38" actId="165"/>
          <ac:spMkLst>
            <pc:docMk/>
            <pc:sldMk cId="1726942282" sldId="256"/>
            <ac:spMk id="44" creationId="{F62FA2F5-BF11-4CAC-B944-5A7B640D5DCB}"/>
          </ac:spMkLst>
        </pc:spChg>
        <pc:spChg chg="mod">
          <ac:chgData name="Perelygina, Ludmila M. (CDC/DDID/NCIRD/DVD)" userId="7d3b25f4-6f80-4483-bceb-5fdc4e1f170d" providerId="ADAL" clId="{FB76851E-49FD-48D9-93AB-02CF62F5D00A}" dt="2021-12-28T18:51:37.699" v="38" actId="165"/>
          <ac:spMkLst>
            <pc:docMk/>
            <pc:sldMk cId="1726942282" sldId="256"/>
            <ac:spMk id="46" creationId="{1245D63C-8106-4ABD-A366-A82FC1AF8277}"/>
          </ac:spMkLst>
        </pc:spChg>
        <pc:spChg chg="mod">
          <ac:chgData name="Perelygina, Ludmila M. (CDC/DDID/NCIRD/DVD)" userId="7d3b25f4-6f80-4483-bceb-5fdc4e1f170d" providerId="ADAL" clId="{FB76851E-49FD-48D9-93AB-02CF62F5D00A}" dt="2021-12-28T18:51:37.699" v="38" actId="165"/>
          <ac:spMkLst>
            <pc:docMk/>
            <pc:sldMk cId="1726942282" sldId="256"/>
            <ac:spMk id="47" creationId="{A8B50054-1ECA-4343-80AC-F306C02A2399}"/>
          </ac:spMkLst>
        </pc:spChg>
        <pc:spChg chg="mod">
          <ac:chgData name="Perelygina, Ludmila M. (CDC/DDID/NCIRD/DVD)" userId="7d3b25f4-6f80-4483-bceb-5fdc4e1f170d" providerId="ADAL" clId="{FB76851E-49FD-48D9-93AB-02CF62F5D00A}" dt="2021-12-28T18:51:37.699" v="38" actId="165"/>
          <ac:spMkLst>
            <pc:docMk/>
            <pc:sldMk cId="1726942282" sldId="256"/>
            <ac:spMk id="48" creationId="{8C8661DC-EB69-4F80-9A17-1184D31A0D95}"/>
          </ac:spMkLst>
        </pc:spChg>
        <pc:spChg chg="mod">
          <ac:chgData name="Perelygina, Ludmila M. (CDC/DDID/NCIRD/DVD)" userId="7d3b25f4-6f80-4483-bceb-5fdc4e1f170d" providerId="ADAL" clId="{FB76851E-49FD-48D9-93AB-02CF62F5D00A}" dt="2021-12-28T18:51:37.699" v="38" actId="165"/>
          <ac:spMkLst>
            <pc:docMk/>
            <pc:sldMk cId="1726942282" sldId="256"/>
            <ac:spMk id="49" creationId="{409DA022-D94F-4E72-8A3E-2D598B4C724C}"/>
          </ac:spMkLst>
        </pc:spChg>
        <pc:spChg chg="mod">
          <ac:chgData name="Perelygina, Ludmila M. (CDC/DDID/NCIRD/DVD)" userId="7d3b25f4-6f80-4483-bceb-5fdc4e1f170d" providerId="ADAL" clId="{FB76851E-49FD-48D9-93AB-02CF62F5D00A}" dt="2021-12-28T18:51:37.699" v="38" actId="165"/>
          <ac:spMkLst>
            <pc:docMk/>
            <pc:sldMk cId="1726942282" sldId="256"/>
            <ac:spMk id="50" creationId="{E31648D6-11F7-40DC-BD47-DA537BBD3EC6}"/>
          </ac:spMkLst>
        </pc:spChg>
        <pc:spChg chg="mod">
          <ac:chgData name="Perelygina, Ludmila M. (CDC/DDID/NCIRD/DVD)" userId="7d3b25f4-6f80-4483-bceb-5fdc4e1f170d" providerId="ADAL" clId="{FB76851E-49FD-48D9-93AB-02CF62F5D00A}" dt="2021-12-28T18:51:37.699" v="38" actId="165"/>
          <ac:spMkLst>
            <pc:docMk/>
            <pc:sldMk cId="1726942282" sldId="256"/>
            <ac:spMk id="51" creationId="{0A994A50-FE31-4BFF-B233-18D7CD50907A}"/>
          </ac:spMkLst>
        </pc:spChg>
        <pc:spChg chg="mod">
          <ac:chgData name="Perelygina, Ludmila M. (CDC/DDID/NCIRD/DVD)" userId="7d3b25f4-6f80-4483-bceb-5fdc4e1f170d" providerId="ADAL" clId="{FB76851E-49FD-48D9-93AB-02CF62F5D00A}" dt="2021-12-28T18:51:37.699" v="38" actId="165"/>
          <ac:spMkLst>
            <pc:docMk/>
            <pc:sldMk cId="1726942282" sldId="256"/>
            <ac:spMk id="52" creationId="{D91BAFFD-F289-4D70-BB7F-2AA218AF62E1}"/>
          </ac:spMkLst>
        </pc:spChg>
        <pc:spChg chg="mod">
          <ac:chgData name="Perelygina, Ludmila M. (CDC/DDID/NCIRD/DVD)" userId="7d3b25f4-6f80-4483-bceb-5fdc4e1f170d" providerId="ADAL" clId="{FB76851E-49FD-48D9-93AB-02CF62F5D00A}" dt="2021-12-28T18:51:37.699" v="38" actId="165"/>
          <ac:spMkLst>
            <pc:docMk/>
            <pc:sldMk cId="1726942282" sldId="256"/>
            <ac:spMk id="53" creationId="{EDBBFAD3-68D9-47BC-8253-D09410878228}"/>
          </ac:spMkLst>
        </pc:spChg>
        <pc:spChg chg="mod">
          <ac:chgData name="Perelygina, Ludmila M. (CDC/DDID/NCIRD/DVD)" userId="7d3b25f4-6f80-4483-bceb-5fdc4e1f170d" providerId="ADAL" clId="{FB76851E-49FD-48D9-93AB-02CF62F5D00A}" dt="2021-12-28T18:51:37.699" v="38" actId="165"/>
          <ac:spMkLst>
            <pc:docMk/>
            <pc:sldMk cId="1726942282" sldId="256"/>
            <ac:spMk id="54" creationId="{65BECD5D-EDED-4953-A50E-62266878E553}"/>
          </ac:spMkLst>
        </pc:spChg>
        <pc:spChg chg="mod">
          <ac:chgData name="Perelygina, Ludmila M. (CDC/DDID/NCIRD/DVD)" userId="7d3b25f4-6f80-4483-bceb-5fdc4e1f170d" providerId="ADAL" clId="{FB76851E-49FD-48D9-93AB-02CF62F5D00A}" dt="2021-12-28T18:51:37.699" v="38" actId="165"/>
          <ac:spMkLst>
            <pc:docMk/>
            <pc:sldMk cId="1726942282" sldId="256"/>
            <ac:spMk id="55" creationId="{2D4A214B-F315-4126-905C-4AF982500662}"/>
          </ac:spMkLst>
        </pc:spChg>
        <pc:grpChg chg="add del mod">
          <ac:chgData name="Perelygina, Ludmila M. (CDC/DDID/NCIRD/DVD)" userId="7d3b25f4-6f80-4483-bceb-5fdc4e1f170d" providerId="ADAL" clId="{FB76851E-49FD-48D9-93AB-02CF62F5D00A}" dt="2021-12-28T18:51:37.699" v="38" actId="165"/>
          <ac:grpSpMkLst>
            <pc:docMk/>
            <pc:sldMk cId="1726942282" sldId="256"/>
            <ac:grpSpMk id="3" creationId="{97699F5F-8320-4CA9-9352-8996980B238E}"/>
          </ac:grpSpMkLst>
        </pc:grpChg>
        <pc:grpChg chg="mod">
          <ac:chgData name="Perelygina, Ludmila M. (CDC/DDID/NCIRD/DVD)" userId="7d3b25f4-6f80-4483-bceb-5fdc4e1f170d" providerId="ADAL" clId="{FB76851E-49FD-48D9-93AB-02CF62F5D00A}" dt="2021-12-28T18:51:37.699" v="38" actId="165"/>
          <ac:grpSpMkLst>
            <pc:docMk/>
            <pc:sldMk cId="1726942282" sldId="256"/>
            <ac:grpSpMk id="4" creationId="{4E64BF19-809E-447A-AF43-83BDC314167F}"/>
          </ac:grpSpMkLst>
        </pc:grpChg>
        <pc:grpChg chg="mod">
          <ac:chgData name="Perelygina, Ludmila M. (CDC/DDID/NCIRD/DVD)" userId="7d3b25f4-6f80-4483-bceb-5fdc4e1f170d" providerId="ADAL" clId="{FB76851E-49FD-48D9-93AB-02CF62F5D00A}" dt="2021-12-28T18:51:37.699" v="38" actId="165"/>
          <ac:grpSpMkLst>
            <pc:docMk/>
            <pc:sldMk cId="1726942282" sldId="256"/>
            <ac:grpSpMk id="6" creationId="{EF039703-8FD3-4880-9731-4BAA80D2DB6E}"/>
          </ac:grpSpMkLst>
        </pc:grpChg>
        <pc:grpChg chg="mod topLvl">
          <ac:chgData name="Perelygina, Ludmila M. (CDC/DDID/NCIRD/DVD)" userId="7d3b25f4-6f80-4483-bceb-5fdc4e1f170d" providerId="ADAL" clId="{FB76851E-49FD-48D9-93AB-02CF62F5D00A}" dt="2021-12-28T18:51:37.699" v="38" actId="165"/>
          <ac:grpSpMkLst>
            <pc:docMk/>
            <pc:sldMk cId="1726942282" sldId="256"/>
            <ac:grpSpMk id="9" creationId="{1277C819-E894-41B9-AADA-172A3435EE1F}"/>
          </ac:grpSpMkLst>
        </pc:grpChg>
        <pc:graphicFrameChg chg="mod">
          <ac:chgData name="Perelygina, Ludmila M. (CDC/DDID/NCIRD/DVD)" userId="7d3b25f4-6f80-4483-bceb-5fdc4e1f170d" providerId="ADAL" clId="{FB76851E-49FD-48D9-93AB-02CF62F5D00A}" dt="2021-12-28T18:51:37.699" v="38" actId="165"/>
          <ac:graphicFrameMkLst>
            <pc:docMk/>
            <pc:sldMk cId="1726942282" sldId="256"/>
            <ac:graphicFrameMk id="30" creationId="{A8FD380A-76C5-4314-BE01-581E5F08BAA9}"/>
          </ac:graphicFrameMkLst>
        </pc:graphicFrameChg>
      </pc:sldChg>
      <pc:sldChg chg="modSp mod">
        <pc:chgData name="Perelygina, Ludmila M. (CDC/DDID/NCIRD/DVD)" userId="7d3b25f4-6f80-4483-bceb-5fdc4e1f170d" providerId="ADAL" clId="{FB76851E-49FD-48D9-93AB-02CF62F5D00A}" dt="2021-12-28T19:09:43.577" v="77" actId="113"/>
        <pc:sldMkLst>
          <pc:docMk/>
          <pc:sldMk cId="2864907532" sldId="257"/>
        </pc:sldMkLst>
        <pc:spChg chg="mod">
          <ac:chgData name="Perelygina, Ludmila M. (CDC/DDID/NCIRD/DVD)" userId="7d3b25f4-6f80-4483-bceb-5fdc4e1f170d" providerId="ADAL" clId="{FB76851E-49FD-48D9-93AB-02CF62F5D00A}" dt="2021-12-10T22:15:12.348" v="28" actId="1038"/>
          <ac:spMkLst>
            <pc:docMk/>
            <pc:sldMk cId="2864907532" sldId="257"/>
            <ac:spMk id="6" creationId="{4EEBF3E1-EAF0-4182-8D43-6E90DBAB9C72}"/>
          </ac:spMkLst>
        </pc:spChg>
        <pc:spChg chg="mod">
          <ac:chgData name="Perelygina, Ludmila M. (CDC/DDID/NCIRD/DVD)" userId="7d3b25f4-6f80-4483-bceb-5fdc4e1f170d" providerId="ADAL" clId="{FB76851E-49FD-48D9-93AB-02CF62F5D00A}" dt="2021-12-28T19:09:43.577" v="77" actId="113"/>
          <ac:spMkLst>
            <pc:docMk/>
            <pc:sldMk cId="2864907532" sldId="257"/>
            <ac:spMk id="7" creationId="{25F8C4D2-91FA-45EE-A853-F7E40B93AE51}"/>
          </ac:spMkLst>
        </pc:spChg>
        <pc:spChg chg="mod">
          <ac:chgData name="Perelygina, Ludmila M. (CDC/DDID/NCIRD/DVD)" userId="7d3b25f4-6f80-4483-bceb-5fdc4e1f170d" providerId="ADAL" clId="{FB76851E-49FD-48D9-93AB-02CF62F5D00A}" dt="2021-12-10T22:15:12.348" v="28" actId="1038"/>
          <ac:spMkLst>
            <pc:docMk/>
            <pc:sldMk cId="2864907532" sldId="257"/>
            <ac:spMk id="8" creationId="{E5DA449E-F502-42F6-9A3D-E68B41B66CF4}"/>
          </ac:spMkLst>
        </pc:spChg>
        <pc:spChg chg="mod">
          <ac:chgData name="Perelygina, Ludmila M. (CDC/DDID/NCIRD/DVD)" userId="7d3b25f4-6f80-4483-bceb-5fdc4e1f170d" providerId="ADAL" clId="{FB76851E-49FD-48D9-93AB-02CF62F5D00A}" dt="2021-12-10T22:15:12.348" v="28" actId="1038"/>
          <ac:spMkLst>
            <pc:docMk/>
            <pc:sldMk cId="2864907532" sldId="257"/>
            <ac:spMk id="9" creationId="{DA5AA404-9DD0-4DBC-AE09-C74D01F3050A}"/>
          </ac:spMkLst>
        </pc:spChg>
        <pc:graphicFrameChg chg="mod modGraphic">
          <ac:chgData name="Perelygina, Ludmila M. (CDC/DDID/NCIRD/DVD)" userId="7d3b25f4-6f80-4483-bceb-5fdc4e1f170d" providerId="ADAL" clId="{FB76851E-49FD-48D9-93AB-02CF62F5D00A}" dt="2021-12-28T19:08:36.611" v="71" actId="14100"/>
          <ac:graphicFrameMkLst>
            <pc:docMk/>
            <pc:sldMk cId="2864907532" sldId="257"/>
            <ac:graphicFrameMk id="3" creationId="{618FF06B-4D82-408A-B002-DEED8867C78D}"/>
          </ac:graphicFrameMkLst>
        </pc:graphicFrameChg>
        <pc:picChg chg="mod">
          <ac:chgData name="Perelygina, Ludmila M. (CDC/DDID/NCIRD/DVD)" userId="7d3b25f4-6f80-4483-bceb-5fdc4e1f170d" providerId="ADAL" clId="{FB76851E-49FD-48D9-93AB-02CF62F5D00A}" dt="2021-12-10T22:15:12.348" v="28" actId="1038"/>
          <ac:picMkLst>
            <pc:docMk/>
            <pc:sldMk cId="2864907532" sldId="257"/>
            <ac:picMk id="14" creationId="{160A2E07-4B21-4669-8B25-8B49BC1DD09D}"/>
          </ac:picMkLst>
        </pc:picChg>
        <pc:picChg chg="mod">
          <ac:chgData name="Perelygina, Ludmila M. (CDC/DDID/NCIRD/DVD)" userId="7d3b25f4-6f80-4483-bceb-5fdc4e1f170d" providerId="ADAL" clId="{FB76851E-49FD-48D9-93AB-02CF62F5D00A}" dt="2021-12-10T22:15:12.348" v="28" actId="1038"/>
          <ac:picMkLst>
            <pc:docMk/>
            <pc:sldMk cId="2864907532" sldId="257"/>
            <ac:picMk id="18" creationId="{8BD43898-10D6-4518-BDD0-505A854D1829}"/>
          </ac:picMkLst>
        </pc:picChg>
      </pc:sldChg>
      <pc:sldChg chg="modSp mod">
        <pc:chgData name="Perelygina, Ludmila M. (CDC/DDID/NCIRD/DVD)" userId="7d3b25f4-6f80-4483-bceb-5fdc4e1f170d" providerId="ADAL" clId="{FB76851E-49FD-48D9-93AB-02CF62F5D00A}" dt="2021-12-28T19:15:11.919" v="92" actId="20577"/>
        <pc:sldMkLst>
          <pc:docMk/>
          <pc:sldMk cId="1664974692" sldId="258"/>
        </pc:sldMkLst>
        <pc:spChg chg="mod">
          <ac:chgData name="Perelygina, Ludmila M. (CDC/DDID/NCIRD/DVD)" userId="7d3b25f4-6f80-4483-bceb-5fdc4e1f170d" providerId="ADAL" clId="{FB76851E-49FD-48D9-93AB-02CF62F5D00A}" dt="2021-12-28T19:15:11.919" v="92" actId="20577"/>
          <ac:spMkLst>
            <pc:docMk/>
            <pc:sldMk cId="1664974692" sldId="258"/>
            <ac:spMk id="16" creationId="{D7AC37FD-2D02-4B02-BF1A-879A215C3E1B}"/>
          </ac:spMkLst>
        </pc:spChg>
        <pc:spChg chg="mod">
          <ac:chgData name="Perelygina, Ludmila M. (CDC/DDID/NCIRD/DVD)" userId="7d3b25f4-6f80-4483-bceb-5fdc4e1f170d" providerId="ADAL" clId="{FB76851E-49FD-48D9-93AB-02CF62F5D00A}" dt="2021-12-28T19:13:41.259" v="89" actId="1035"/>
          <ac:spMkLst>
            <pc:docMk/>
            <pc:sldMk cId="1664974692" sldId="258"/>
            <ac:spMk id="30" creationId="{F7210DD3-2D86-47FE-A22F-70ACEAE51D2A}"/>
          </ac:spMkLst>
        </pc:spChg>
        <pc:spChg chg="mod">
          <ac:chgData name="Perelygina, Ludmila M. (CDC/DDID/NCIRD/DVD)" userId="7d3b25f4-6f80-4483-bceb-5fdc4e1f170d" providerId="ADAL" clId="{FB76851E-49FD-48D9-93AB-02CF62F5D00A}" dt="2021-12-28T19:13:41.259" v="89" actId="1035"/>
          <ac:spMkLst>
            <pc:docMk/>
            <pc:sldMk cId="1664974692" sldId="258"/>
            <ac:spMk id="32" creationId="{8E94FC1B-4F01-4D77-B3C8-38682C1B1F37}"/>
          </ac:spMkLst>
        </pc:spChg>
        <pc:grpChg chg="mod">
          <ac:chgData name="Perelygina, Ludmila M. (CDC/DDID/NCIRD/DVD)" userId="7d3b25f4-6f80-4483-bceb-5fdc4e1f170d" providerId="ADAL" clId="{FB76851E-49FD-48D9-93AB-02CF62F5D00A}" dt="2021-12-28T19:13:41.259" v="89" actId="1035"/>
          <ac:grpSpMkLst>
            <pc:docMk/>
            <pc:sldMk cId="1664974692" sldId="258"/>
            <ac:grpSpMk id="23" creationId="{68B25D1D-9189-4507-AF5C-7F2B42FDD9B7}"/>
          </ac:grpSpMkLst>
        </pc:grpChg>
        <pc:graphicFrameChg chg="mod">
          <ac:chgData name="Perelygina, Ludmila M. (CDC/DDID/NCIRD/DVD)" userId="7d3b25f4-6f80-4483-bceb-5fdc4e1f170d" providerId="ADAL" clId="{FB76851E-49FD-48D9-93AB-02CF62F5D00A}" dt="2021-12-28T19:13:41.259" v="89" actId="1035"/>
          <ac:graphicFrameMkLst>
            <pc:docMk/>
            <pc:sldMk cId="1664974692" sldId="258"/>
            <ac:graphicFrameMk id="28" creationId="{E9533548-8D9D-400A-A97A-06E3097E32CD}"/>
          </ac:graphicFrameMkLst>
        </pc:graphicFrameChg>
      </pc:sldChg>
      <pc:sldChg chg="addSp delSp modSp mod">
        <pc:chgData name="Perelygina, Ludmila M. (CDC/DDID/NCIRD/DVD)" userId="7d3b25f4-6f80-4483-bceb-5fdc4e1f170d" providerId="ADAL" clId="{FB76851E-49FD-48D9-93AB-02CF62F5D00A}" dt="2021-12-28T19:03:41.638" v="64" actId="113"/>
        <pc:sldMkLst>
          <pc:docMk/>
          <pc:sldMk cId="3513049566" sldId="262"/>
        </pc:sldMkLst>
        <pc:spChg chg="mod topLvl">
          <ac:chgData name="Perelygina, Ludmila M. (CDC/DDID/NCIRD/DVD)" userId="7d3b25f4-6f80-4483-bceb-5fdc4e1f170d" providerId="ADAL" clId="{FB76851E-49FD-48D9-93AB-02CF62F5D00A}" dt="2021-12-28T19:03:41.638" v="64" actId="113"/>
          <ac:spMkLst>
            <pc:docMk/>
            <pc:sldMk cId="3513049566" sldId="262"/>
            <ac:spMk id="3" creationId="{337F8738-E22F-48ED-9EFA-B8F222219FC0}"/>
          </ac:spMkLst>
        </pc:spChg>
        <pc:spChg chg="mod topLvl">
          <ac:chgData name="Perelygina, Ludmila M. (CDC/DDID/NCIRD/DVD)" userId="7d3b25f4-6f80-4483-bceb-5fdc4e1f170d" providerId="ADAL" clId="{FB76851E-49FD-48D9-93AB-02CF62F5D00A}" dt="2021-12-28T18:53:32.971" v="40" actId="165"/>
          <ac:spMkLst>
            <pc:docMk/>
            <pc:sldMk cId="3513049566" sldId="262"/>
            <ac:spMk id="4" creationId="{43C31911-B422-4C9F-BBA0-0BF79E048D5A}"/>
          </ac:spMkLst>
        </pc:spChg>
        <pc:spChg chg="mod topLvl">
          <ac:chgData name="Perelygina, Ludmila M. (CDC/DDID/NCIRD/DVD)" userId="7d3b25f4-6f80-4483-bceb-5fdc4e1f170d" providerId="ADAL" clId="{FB76851E-49FD-48D9-93AB-02CF62F5D00A}" dt="2021-12-28T18:53:32.971" v="40" actId="165"/>
          <ac:spMkLst>
            <pc:docMk/>
            <pc:sldMk cId="3513049566" sldId="262"/>
            <ac:spMk id="5" creationId="{A3744FED-CD44-487E-82D7-7DBE76FAB682}"/>
          </ac:spMkLst>
        </pc:spChg>
        <pc:spChg chg="mod topLvl">
          <ac:chgData name="Perelygina, Ludmila M. (CDC/DDID/NCIRD/DVD)" userId="7d3b25f4-6f80-4483-bceb-5fdc4e1f170d" providerId="ADAL" clId="{FB76851E-49FD-48D9-93AB-02CF62F5D00A}" dt="2021-12-28T18:53:32.971" v="40" actId="165"/>
          <ac:spMkLst>
            <pc:docMk/>
            <pc:sldMk cId="3513049566" sldId="262"/>
            <ac:spMk id="6" creationId="{A6BB0859-2A4E-4EC0-9603-099F6F58FC49}"/>
          </ac:spMkLst>
        </pc:spChg>
        <pc:spChg chg="mod topLvl">
          <ac:chgData name="Perelygina, Ludmila M. (CDC/DDID/NCIRD/DVD)" userId="7d3b25f4-6f80-4483-bceb-5fdc4e1f170d" providerId="ADAL" clId="{FB76851E-49FD-48D9-93AB-02CF62F5D00A}" dt="2021-12-28T18:53:32.971" v="40" actId="165"/>
          <ac:spMkLst>
            <pc:docMk/>
            <pc:sldMk cId="3513049566" sldId="262"/>
            <ac:spMk id="7" creationId="{218003D1-3D52-452E-BA6A-F372335FF546}"/>
          </ac:spMkLst>
        </pc:spChg>
        <pc:spChg chg="mod topLvl">
          <ac:chgData name="Perelygina, Ludmila M. (CDC/DDID/NCIRD/DVD)" userId="7d3b25f4-6f80-4483-bceb-5fdc4e1f170d" providerId="ADAL" clId="{FB76851E-49FD-48D9-93AB-02CF62F5D00A}" dt="2021-12-28T18:53:32.971" v="40" actId="165"/>
          <ac:spMkLst>
            <pc:docMk/>
            <pc:sldMk cId="3513049566" sldId="262"/>
            <ac:spMk id="8" creationId="{2F6B0451-EE37-4714-A3A0-9DE45B78D33C}"/>
          </ac:spMkLst>
        </pc:spChg>
        <pc:spChg chg="add mod">
          <ac:chgData name="Perelygina, Ludmila M. (CDC/DDID/NCIRD/DVD)" userId="7d3b25f4-6f80-4483-bceb-5fdc4e1f170d" providerId="ADAL" clId="{FB76851E-49FD-48D9-93AB-02CF62F5D00A}" dt="2021-12-28T18:59:45.751" v="47" actId="208"/>
          <ac:spMkLst>
            <pc:docMk/>
            <pc:sldMk cId="3513049566" sldId="262"/>
            <ac:spMk id="10" creationId="{99FE1D6D-1DEB-49CC-A8CB-764A6D69CF15}"/>
          </ac:spMkLst>
        </pc:spChg>
        <pc:grpChg chg="add del mod">
          <ac:chgData name="Perelygina, Ludmila M. (CDC/DDID/NCIRD/DVD)" userId="7d3b25f4-6f80-4483-bceb-5fdc4e1f170d" providerId="ADAL" clId="{FB76851E-49FD-48D9-93AB-02CF62F5D00A}" dt="2021-12-28T18:53:32.971" v="40" actId="165"/>
          <ac:grpSpMkLst>
            <pc:docMk/>
            <pc:sldMk cId="3513049566" sldId="262"/>
            <ac:grpSpMk id="9" creationId="{1A1A7648-4869-47AB-B2A8-697E43C89AD1}"/>
          </ac:grpSpMkLst>
        </pc:grpChg>
        <pc:graphicFrameChg chg="mod topLvl">
          <ac:chgData name="Perelygina, Ludmila M. (CDC/DDID/NCIRD/DVD)" userId="7d3b25f4-6f80-4483-bceb-5fdc4e1f170d" providerId="ADAL" clId="{FB76851E-49FD-48D9-93AB-02CF62F5D00A}" dt="2021-12-28T18:53:32.971" v="40" actId="165"/>
          <ac:graphicFrameMkLst>
            <pc:docMk/>
            <pc:sldMk cId="3513049566" sldId="262"/>
            <ac:graphicFrameMk id="2" creationId="{30FE33E8-7D89-4149-B4FC-247E43D7A0A5}"/>
          </ac:graphicFrameMkLst>
        </pc:graphicFrameChg>
        <pc:graphicFrameChg chg="add mod modGraphic">
          <ac:chgData name="Perelygina, Ludmila M. (CDC/DDID/NCIRD/DVD)" userId="7d3b25f4-6f80-4483-bceb-5fdc4e1f170d" providerId="ADAL" clId="{FB76851E-49FD-48D9-93AB-02CF62F5D00A}" dt="2021-12-28T19:01:04.163" v="59" actId="255"/>
          <ac:graphicFrameMkLst>
            <pc:docMk/>
            <pc:sldMk cId="3513049566" sldId="262"/>
            <ac:graphicFrameMk id="12" creationId="{FDD089F9-E8DF-4C42-AD49-F8F210EF21FF}"/>
          </ac:graphicFrameMkLst>
        </pc:graphicFrameChg>
        <pc:picChg chg="add del mod">
          <ac:chgData name="Perelygina, Ludmila M. (CDC/DDID/NCIRD/DVD)" userId="7d3b25f4-6f80-4483-bceb-5fdc4e1f170d" providerId="ADAL" clId="{FB76851E-49FD-48D9-93AB-02CF62F5D00A}" dt="2021-12-28T19:00:50.679" v="57" actId="478"/>
          <ac:picMkLst>
            <pc:docMk/>
            <pc:sldMk cId="3513049566" sldId="262"/>
            <ac:picMk id="11" creationId="{9D636F3D-8302-44D1-8DAE-73B7E2EB3A64}"/>
          </ac:picMkLst>
        </pc:picChg>
      </pc:sldChg>
    </pc:docChg>
  </pc:docChgLst>
  <pc:docChgLst>
    <pc:chgData name="Perelygina, Ludmila M. (CDC/DDID/NCIRD/DVD)" userId="7d3b25f4-6f80-4483-bceb-5fdc4e1f170d" providerId="ADAL" clId="{37FD2FA5-ABDD-464C-8397-1D6DB9F8955D}"/>
    <pc:docChg chg="undo custSel addSld delSld modSld sldOrd">
      <pc:chgData name="Perelygina, Ludmila M. (CDC/DDID/NCIRD/DVD)" userId="7d3b25f4-6f80-4483-bceb-5fdc4e1f170d" providerId="ADAL" clId="{37FD2FA5-ABDD-464C-8397-1D6DB9F8955D}" dt="2021-12-07T11:47:44.716" v="2184" actId="1036"/>
      <pc:docMkLst>
        <pc:docMk/>
      </pc:docMkLst>
      <pc:sldChg chg="addSp delSp modSp mod">
        <pc:chgData name="Perelygina, Ludmila M. (CDC/DDID/NCIRD/DVD)" userId="7d3b25f4-6f80-4483-bceb-5fdc4e1f170d" providerId="ADAL" clId="{37FD2FA5-ABDD-464C-8397-1D6DB9F8955D}" dt="2021-12-02T20:06:11.726" v="2145" actId="20577"/>
        <pc:sldMkLst>
          <pc:docMk/>
          <pc:sldMk cId="1726942282" sldId="256"/>
        </pc:sldMkLst>
        <pc:spChg chg="add mod">
          <ac:chgData name="Perelygina, Ludmila M. (CDC/DDID/NCIRD/DVD)" userId="7d3b25f4-6f80-4483-bceb-5fdc4e1f170d" providerId="ADAL" clId="{37FD2FA5-ABDD-464C-8397-1D6DB9F8955D}" dt="2021-12-01T18:14:46.181" v="1571" actId="164"/>
          <ac:spMkLst>
            <pc:docMk/>
            <pc:sldMk cId="1726942282" sldId="256"/>
            <ac:spMk id="2" creationId="{CB621483-F3E7-4FEA-A899-E8A6CDC87B17}"/>
          </ac:spMkLst>
        </pc:spChg>
        <pc:spChg chg="mod topLvl">
          <ac:chgData name="Perelygina, Ludmila M. (CDC/DDID/NCIRD/DVD)" userId="7d3b25f4-6f80-4483-bceb-5fdc4e1f170d" providerId="ADAL" clId="{37FD2FA5-ABDD-464C-8397-1D6DB9F8955D}" dt="2021-11-30T18:23:29.601" v="635" actId="165"/>
          <ac:spMkLst>
            <pc:docMk/>
            <pc:sldMk cId="1726942282" sldId="256"/>
            <ac:spMk id="6" creationId="{66A64B89-496E-480B-9DC4-3806F8CA859E}"/>
          </ac:spMkLst>
        </pc:spChg>
        <pc:spChg chg="mod topLvl">
          <ac:chgData name="Perelygina, Ludmila M. (CDC/DDID/NCIRD/DVD)" userId="7d3b25f4-6f80-4483-bceb-5fdc4e1f170d" providerId="ADAL" clId="{37FD2FA5-ABDD-464C-8397-1D6DB9F8955D}" dt="2021-11-30T18:23:29.601" v="635" actId="165"/>
          <ac:spMkLst>
            <pc:docMk/>
            <pc:sldMk cId="1726942282" sldId="256"/>
            <ac:spMk id="7" creationId="{C31E6DE2-2431-4DD4-BEFA-08C02206C6C6}"/>
          </ac:spMkLst>
        </pc:spChg>
        <pc:spChg chg="mod topLvl">
          <ac:chgData name="Perelygina, Ludmila M. (CDC/DDID/NCIRD/DVD)" userId="7d3b25f4-6f80-4483-bceb-5fdc4e1f170d" providerId="ADAL" clId="{37FD2FA5-ABDD-464C-8397-1D6DB9F8955D}" dt="2021-11-30T18:23:29.601" v="635" actId="165"/>
          <ac:spMkLst>
            <pc:docMk/>
            <pc:sldMk cId="1726942282" sldId="256"/>
            <ac:spMk id="8" creationId="{7E2ADB75-E6FE-4C14-9744-3AC4E570AC77}"/>
          </ac:spMkLst>
        </pc:spChg>
        <pc:spChg chg="mod topLvl">
          <ac:chgData name="Perelygina, Ludmila M. (CDC/DDID/NCIRD/DVD)" userId="7d3b25f4-6f80-4483-bceb-5fdc4e1f170d" providerId="ADAL" clId="{37FD2FA5-ABDD-464C-8397-1D6DB9F8955D}" dt="2021-11-30T18:23:29.601" v="635" actId="165"/>
          <ac:spMkLst>
            <pc:docMk/>
            <pc:sldMk cId="1726942282" sldId="256"/>
            <ac:spMk id="9" creationId="{F34379E9-0203-4D59-8105-7BAE0686EA21}"/>
          </ac:spMkLst>
        </pc:spChg>
        <pc:spChg chg="mod topLvl">
          <ac:chgData name="Perelygina, Ludmila M. (CDC/DDID/NCIRD/DVD)" userId="7d3b25f4-6f80-4483-bceb-5fdc4e1f170d" providerId="ADAL" clId="{37FD2FA5-ABDD-464C-8397-1D6DB9F8955D}" dt="2021-11-30T18:23:29.601" v="635" actId="165"/>
          <ac:spMkLst>
            <pc:docMk/>
            <pc:sldMk cId="1726942282" sldId="256"/>
            <ac:spMk id="10" creationId="{58204A97-13E5-4F75-9D47-81821DC993E2}"/>
          </ac:spMkLst>
        </pc:spChg>
        <pc:spChg chg="mod topLvl">
          <ac:chgData name="Perelygina, Ludmila M. (CDC/DDID/NCIRD/DVD)" userId="7d3b25f4-6f80-4483-bceb-5fdc4e1f170d" providerId="ADAL" clId="{37FD2FA5-ABDD-464C-8397-1D6DB9F8955D}" dt="2021-11-30T18:23:29.601" v="635" actId="165"/>
          <ac:spMkLst>
            <pc:docMk/>
            <pc:sldMk cId="1726942282" sldId="256"/>
            <ac:spMk id="11" creationId="{A28C9E6F-B561-4939-B5E0-57FE588A359D}"/>
          </ac:spMkLst>
        </pc:spChg>
        <pc:spChg chg="mod topLvl">
          <ac:chgData name="Perelygina, Ludmila M. (CDC/DDID/NCIRD/DVD)" userId="7d3b25f4-6f80-4483-bceb-5fdc4e1f170d" providerId="ADAL" clId="{37FD2FA5-ABDD-464C-8397-1D6DB9F8955D}" dt="2021-11-30T18:23:29.601" v="635" actId="165"/>
          <ac:spMkLst>
            <pc:docMk/>
            <pc:sldMk cId="1726942282" sldId="256"/>
            <ac:spMk id="12" creationId="{568CCFB3-D4DF-4521-8CEE-AE82B8A3C508}"/>
          </ac:spMkLst>
        </pc:spChg>
        <pc:spChg chg="mod topLvl">
          <ac:chgData name="Perelygina, Ludmila M. (CDC/DDID/NCIRD/DVD)" userId="7d3b25f4-6f80-4483-bceb-5fdc4e1f170d" providerId="ADAL" clId="{37FD2FA5-ABDD-464C-8397-1D6DB9F8955D}" dt="2021-11-30T18:23:29.601" v="635" actId="165"/>
          <ac:spMkLst>
            <pc:docMk/>
            <pc:sldMk cId="1726942282" sldId="256"/>
            <ac:spMk id="13" creationId="{28FF9C53-5642-4CCE-9DC0-D14F257E8681}"/>
          </ac:spMkLst>
        </pc:spChg>
        <pc:spChg chg="mod topLvl">
          <ac:chgData name="Perelygina, Ludmila M. (CDC/DDID/NCIRD/DVD)" userId="7d3b25f4-6f80-4483-bceb-5fdc4e1f170d" providerId="ADAL" clId="{37FD2FA5-ABDD-464C-8397-1D6DB9F8955D}" dt="2021-11-30T18:23:29.601" v="635" actId="165"/>
          <ac:spMkLst>
            <pc:docMk/>
            <pc:sldMk cId="1726942282" sldId="256"/>
            <ac:spMk id="14" creationId="{81DBE345-2A69-4B7D-8891-4E86CC7C880D}"/>
          </ac:spMkLst>
        </pc:spChg>
        <pc:spChg chg="mod topLvl">
          <ac:chgData name="Perelygina, Ludmila M. (CDC/DDID/NCIRD/DVD)" userId="7d3b25f4-6f80-4483-bceb-5fdc4e1f170d" providerId="ADAL" clId="{37FD2FA5-ABDD-464C-8397-1D6DB9F8955D}" dt="2021-11-30T18:23:29.601" v="635" actId="165"/>
          <ac:spMkLst>
            <pc:docMk/>
            <pc:sldMk cId="1726942282" sldId="256"/>
            <ac:spMk id="15" creationId="{ADFECB8E-313F-44FD-B3D4-C462787400F7}"/>
          </ac:spMkLst>
        </pc:spChg>
        <pc:spChg chg="del mod topLvl">
          <ac:chgData name="Perelygina, Ludmila M. (CDC/DDID/NCIRD/DVD)" userId="7d3b25f4-6f80-4483-bceb-5fdc4e1f170d" providerId="ADAL" clId="{37FD2FA5-ABDD-464C-8397-1D6DB9F8955D}" dt="2021-11-30T19:05:47.410" v="718" actId="21"/>
          <ac:spMkLst>
            <pc:docMk/>
            <pc:sldMk cId="1726942282" sldId="256"/>
            <ac:spMk id="17" creationId="{BBB804B5-0D67-47F5-9070-C83272B9F0E1}"/>
          </ac:spMkLst>
        </pc:spChg>
        <pc:spChg chg="del mod topLvl">
          <ac:chgData name="Perelygina, Ludmila M. (CDC/DDID/NCIRD/DVD)" userId="7d3b25f4-6f80-4483-bceb-5fdc4e1f170d" providerId="ADAL" clId="{37FD2FA5-ABDD-464C-8397-1D6DB9F8955D}" dt="2021-11-30T19:05:47.410" v="718" actId="21"/>
          <ac:spMkLst>
            <pc:docMk/>
            <pc:sldMk cId="1726942282" sldId="256"/>
            <ac:spMk id="18" creationId="{CB15674C-F571-4C88-A1BB-460EAF4997ED}"/>
          </ac:spMkLst>
        </pc:spChg>
        <pc:spChg chg="del mod topLvl">
          <ac:chgData name="Perelygina, Ludmila M. (CDC/DDID/NCIRD/DVD)" userId="7d3b25f4-6f80-4483-bceb-5fdc4e1f170d" providerId="ADAL" clId="{37FD2FA5-ABDD-464C-8397-1D6DB9F8955D}" dt="2021-11-30T19:05:47.410" v="718" actId="21"/>
          <ac:spMkLst>
            <pc:docMk/>
            <pc:sldMk cId="1726942282" sldId="256"/>
            <ac:spMk id="19" creationId="{DAC29EE2-B1DB-4A16-9ED7-079C0ADE6F49}"/>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0" creationId="{B356AA67-D55E-460B-B038-3ECCB9FED350}"/>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1" creationId="{5E52ECDC-2518-45FA-8688-2E1E8B548C2F}"/>
          </ac:spMkLst>
        </pc:spChg>
        <pc:spChg chg="mod topLvl">
          <ac:chgData name="Perelygina, Ludmila M. (CDC/DDID/NCIRD/DVD)" userId="7d3b25f4-6f80-4483-bceb-5fdc4e1f170d" providerId="ADAL" clId="{37FD2FA5-ABDD-464C-8397-1D6DB9F8955D}" dt="2021-12-01T18:20:48.620" v="1629" actId="164"/>
          <ac:spMkLst>
            <pc:docMk/>
            <pc:sldMk cId="1726942282" sldId="256"/>
            <ac:spMk id="22" creationId="{28E9742F-967C-495B-98AE-B13CDB4433BD}"/>
          </ac:spMkLst>
        </pc:spChg>
        <pc:spChg chg="mod topLvl">
          <ac:chgData name="Perelygina, Ludmila M. (CDC/DDID/NCIRD/DVD)" userId="7d3b25f4-6f80-4483-bceb-5fdc4e1f170d" providerId="ADAL" clId="{37FD2FA5-ABDD-464C-8397-1D6DB9F8955D}" dt="2021-12-01T18:20:48.620" v="1629" actId="164"/>
          <ac:spMkLst>
            <pc:docMk/>
            <pc:sldMk cId="1726942282" sldId="256"/>
            <ac:spMk id="23" creationId="{A95AC4B7-55A3-4252-9537-9CAF6E68D90D}"/>
          </ac:spMkLst>
        </pc:spChg>
        <pc:spChg chg="mod topLvl">
          <ac:chgData name="Perelygina, Ludmila M. (CDC/DDID/NCIRD/DVD)" userId="7d3b25f4-6f80-4483-bceb-5fdc4e1f170d" providerId="ADAL" clId="{37FD2FA5-ABDD-464C-8397-1D6DB9F8955D}" dt="2021-12-01T18:20:48.620" v="1629" actId="164"/>
          <ac:spMkLst>
            <pc:docMk/>
            <pc:sldMk cId="1726942282" sldId="256"/>
            <ac:spMk id="24" creationId="{2B31BB06-72FE-4ABA-BF93-4E8CF8DA1C22}"/>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5" creationId="{9F8F05FB-9250-4B69-91CA-5C61BD12C64D}"/>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6" creationId="{ABCA268D-A564-4895-A71E-2A5892018E91}"/>
          </ac:spMkLst>
        </pc:spChg>
        <pc:spChg chg="add mod">
          <ac:chgData name="Perelygina, Ludmila M. (CDC/DDID/NCIRD/DVD)" userId="7d3b25f4-6f80-4483-bceb-5fdc4e1f170d" providerId="ADAL" clId="{37FD2FA5-ABDD-464C-8397-1D6DB9F8955D}" dt="2021-12-01T18:14:46.181" v="1571" actId="164"/>
          <ac:spMkLst>
            <pc:docMk/>
            <pc:sldMk cId="1726942282" sldId="256"/>
            <ac:spMk id="27" creationId="{31081107-8B6E-4854-8798-339AAEE63DB2}"/>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7" creationId="{69B8CD65-A269-4845-9730-8B0DBB0C0BC6}"/>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8" creationId="{35606849-BB71-420E-BEAE-E927FFA74ABE}"/>
          </ac:spMkLst>
        </pc:spChg>
        <pc:spChg chg="del mod topLvl">
          <ac:chgData name="Perelygina, Ludmila M. (CDC/DDID/NCIRD/DVD)" userId="7d3b25f4-6f80-4483-bceb-5fdc4e1f170d" providerId="ADAL" clId="{37FD2FA5-ABDD-464C-8397-1D6DB9F8955D}" dt="2021-11-30T19:05:47.410" v="718" actId="21"/>
          <ac:spMkLst>
            <pc:docMk/>
            <pc:sldMk cId="1726942282" sldId="256"/>
            <ac:spMk id="29" creationId="{4D06B400-5ECE-4150-9D19-EE46E8267AEB}"/>
          </ac:spMkLst>
        </pc:spChg>
        <pc:spChg chg="add mod">
          <ac:chgData name="Perelygina, Ludmila M. (CDC/DDID/NCIRD/DVD)" userId="7d3b25f4-6f80-4483-bceb-5fdc4e1f170d" providerId="ADAL" clId="{37FD2FA5-ABDD-464C-8397-1D6DB9F8955D}" dt="2021-12-02T20:06:11.726" v="2145" actId="20577"/>
          <ac:spMkLst>
            <pc:docMk/>
            <pc:sldMk cId="1726942282" sldId="256"/>
            <ac:spMk id="31" creationId="{0FDB5CC8-C87A-401D-BB20-75EED81FE036}"/>
          </ac:spMkLst>
        </pc:spChg>
        <pc:spChg chg="add del mod topLvl">
          <ac:chgData name="Perelygina, Ludmila M. (CDC/DDID/NCIRD/DVD)" userId="7d3b25f4-6f80-4483-bceb-5fdc4e1f170d" providerId="ADAL" clId="{37FD2FA5-ABDD-464C-8397-1D6DB9F8955D}" dt="2021-12-01T18:20:20.421" v="1620" actId="478"/>
          <ac:spMkLst>
            <pc:docMk/>
            <pc:sldMk cId="1726942282" sldId="256"/>
            <ac:spMk id="31" creationId="{3F18A1B1-3E15-49B9-90BD-6D47270D6BE3}"/>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32" creationId="{0EE872E1-6946-43B9-B775-7BDD4BBBA48E}"/>
          </ac:spMkLst>
        </pc:spChg>
        <pc:spChg chg="add mod topLvl">
          <ac:chgData name="Perelygina, Ludmila M. (CDC/DDID/NCIRD/DVD)" userId="7d3b25f4-6f80-4483-bceb-5fdc4e1f170d" providerId="ADAL" clId="{37FD2FA5-ABDD-464C-8397-1D6DB9F8955D}" dt="2021-12-01T18:19:29.917" v="1614" actId="164"/>
          <ac:spMkLst>
            <pc:docMk/>
            <pc:sldMk cId="1726942282" sldId="256"/>
            <ac:spMk id="33" creationId="{89308FB0-74C8-499A-BA92-A3B2936A6A60}"/>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34" creationId="{54953B60-0DDF-490C-944F-15629ECB354E}"/>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35" creationId="{24B4AFBB-41BA-44FB-A177-5A8F37DAEF4F}"/>
          </ac:spMkLst>
        </pc:spChg>
        <pc:spChg chg="add mod">
          <ac:chgData name="Perelygina, Ludmila M. (CDC/DDID/NCIRD/DVD)" userId="7d3b25f4-6f80-4483-bceb-5fdc4e1f170d" providerId="ADAL" clId="{37FD2FA5-ABDD-464C-8397-1D6DB9F8955D}" dt="2021-12-01T18:19:29.917" v="1614" actId="164"/>
          <ac:spMkLst>
            <pc:docMk/>
            <pc:sldMk cId="1726942282" sldId="256"/>
            <ac:spMk id="36" creationId="{0E03541F-E13D-4A27-AF7E-7AA2AF294BE5}"/>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40" creationId="{029DD118-3494-44A1-AAEA-FFD9800DC169}"/>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41" creationId="{73889C25-00C8-4042-A28B-ED27F749BFBE}"/>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42" creationId="{680668E6-0D97-486A-98A4-44A5DEAA6EF4}"/>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43" creationId="{3575D2A5-95B6-4C1B-BA18-611C66586B18}"/>
          </ac:spMkLst>
        </pc:spChg>
        <pc:spChg chg="add mod topLvl">
          <ac:chgData name="Perelygina, Ludmila M. (CDC/DDID/NCIRD/DVD)" userId="7d3b25f4-6f80-4483-bceb-5fdc4e1f170d" providerId="ADAL" clId="{37FD2FA5-ABDD-464C-8397-1D6DB9F8955D}" dt="2021-12-01T18:20:48.620" v="1629" actId="164"/>
          <ac:spMkLst>
            <pc:docMk/>
            <pc:sldMk cId="1726942282" sldId="256"/>
            <ac:spMk id="44" creationId="{F62FA2F5-BF11-4CAC-B944-5A7B640D5DCB}"/>
          </ac:spMkLst>
        </pc:spChg>
        <pc:spChg chg="mod topLvl">
          <ac:chgData name="Perelygina, Ludmila M. (CDC/DDID/NCIRD/DVD)" userId="7d3b25f4-6f80-4483-bceb-5fdc4e1f170d" providerId="ADAL" clId="{37FD2FA5-ABDD-464C-8397-1D6DB9F8955D}" dt="2021-12-01T18:20:48.620" v="1629" actId="164"/>
          <ac:spMkLst>
            <pc:docMk/>
            <pc:sldMk cId="1726942282" sldId="256"/>
            <ac:spMk id="46" creationId="{1245D63C-8106-4ABD-A366-A82FC1AF8277}"/>
          </ac:spMkLst>
        </pc:spChg>
        <pc:spChg chg="mod topLvl">
          <ac:chgData name="Perelygina, Ludmila M. (CDC/DDID/NCIRD/DVD)" userId="7d3b25f4-6f80-4483-bceb-5fdc4e1f170d" providerId="ADAL" clId="{37FD2FA5-ABDD-464C-8397-1D6DB9F8955D}" dt="2021-12-01T18:20:48.620" v="1629" actId="164"/>
          <ac:spMkLst>
            <pc:docMk/>
            <pc:sldMk cId="1726942282" sldId="256"/>
            <ac:spMk id="47" creationId="{A8B50054-1ECA-4343-80AC-F306C02A2399}"/>
          </ac:spMkLst>
        </pc:spChg>
        <pc:spChg chg="mod topLvl">
          <ac:chgData name="Perelygina, Ludmila M. (CDC/DDID/NCIRD/DVD)" userId="7d3b25f4-6f80-4483-bceb-5fdc4e1f170d" providerId="ADAL" clId="{37FD2FA5-ABDD-464C-8397-1D6DB9F8955D}" dt="2021-12-01T18:20:48.620" v="1629" actId="164"/>
          <ac:spMkLst>
            <pc:docMk/>
            <pc:sldMk cId="1726942282" sldId="256"/>
            <ac:spMk id="48" creationId="{8C8661DC-EB69-4F80-9A17-1184D31A0D95}"/>
          </ac:spMkLst>
        </pc:spChg>
        <pc:spChg chg="mod topLvl">
          <ac:chgData name="Perelygina, Ludmila M. (CDC/DDID/NCIRD/DVD)" userId="7d3b25f4-6f80-4483-bceb-5fdc4e1f170d" providerId="ADAL" clId="{37FD2FA5-ABDD-464C-8397-1D6DB9F8955D}" dt="2021-12-01T18:20:48.620" v="1629" actId="164"/>
          <ac:spMkLst>
            <pc:docMk/>
            <pc:sldMk cId="1726942282" sldId="256"/>
            <ac:spMk id="49" creationId="{409DA022-D94F-4E72-8A3E-2D598B4C724C}"/>
          </ac:spMkLst>
        </pc:spChg>
        <pc:spChg chg="mod topLvl">
          <ac:chgData name="Perelygina, Ludmila M. (CDC/DDID/NCIRD/DVD)" userId="7d3b25f4-6f80-4483-bceb-5fdc4e1f170d" providerId="ADAL" clId="{37FD2FA5-ABDD-464C-8397-1D6DB9F8955D}" dt="2021-12-01T18:20:48.620" v="1629" actId="164"/>
          <ac:spMkLst>
            <pc:docMk/>
            <pc:sldMk cId="1726942282" sldId="256"/>
            <ac:spMk id="50" creationId="{E31648D6-11F7-40DC-BD47-DA537BBD3EC6}"/>
          </ac:spMkLst>
        </pc:spChg>
        <pc:spChg chg="mod topLvl">
          <ac:chgData name="Perelygina, Ludmila M. (CDC/DDID/NCIRD/DVD)" userId="7d3b25f4-6f80-4483-bceb-5fdc4e1f170d" providerId="ADAL" clId="{37FD2FA5-ABDD-464C-8397-1D6DB9F8955D}" dt="2021-12-01T18:20:48.620" v="1629" actId="164"/>
          <ac:spMkLst>
            <pc:docMk/>
            <pc:sldMk cId="1726942282" sldId="256"/>
            <ac:spMk id="51" creationId="{0A994A50-FE31-4BFF-B233-18D7CD50907A}"/>
          </ac:spMkLst>
        </pc:spChg>
        <pc:spChg chg="mod topLvl">
          <ac:chgData name="Perelygina, Ludmila M. (CDC/DDID/NCIRD/DVD)" userId="7d3b25f4-6f80-4483-bceb-5fdc4e1f170d" providerId="ADAL" clId="{37FD2FA5-ABDD-464C-8397-1D6DB9F8955D}" dt="2021-12-01T18:20:48.620" v="1629" actId="164"/>
          <ac:spMkLst>
            <pc:docMk/>
            <pc:sldMk cId="1726942282" sldId="256"/>
            <ac:spMk id="52" creationId="{D91BAFFD-F289-4D70-BB7F-2AA218AF62E1}"/>
          </ac:spMkLst>
        </pc:spChg>
        <pc:spChg chg="mod topLvl">
          <ac:chgData name="Perelygina, Ludmila M. (CDC/DDID/NCIRD/DVD)" userId="7d3b25f4-6f80-4483-bceb-5fdc4e1f170d" providerId="ADAL" clId="{37FD2FA5-ABDD-464C-8397-1D6DB9F8955D}" dt="2021-12-01T18:20:48.620" v="1629" actId="164"/>
          <ac:spMkLst>
            <pc:docMk/>
            <pc:sldMk cId="1726942282" sldId="256"/>
            <ac:spMk id="53" creationId="{EDBBFAD3-68D9-47BC-8253-D09410878228}"/>
          </ac:spMkLst>
        </pc:spChg>
        <pc:spChg chg="mod topLvl">
          <ac:chgData name="Perelygina, Ludmila M. (CDC/DDID/NCIRD/DVD)" userId="7d3b25f4-6f80-4483-bceb-5fdc4e1f170d" providerId="ADAL" clId="{37FD2FA5-ABDD-464C-8397-1D6DB9F8955D}" dt="2021-12-01T18:20:48.620" v="1629" actId="164"/>
          <ac:spMkLst>
            <pc:docMk/>
            <pc:sldMk cId="1726942282" sldId="256"/>
            <ac:spMk id="54" creationId="{65BECD5D-EDED-4953-A50E-62266878E553}"/>
          </ac:spMkLst>
        </pc:spChg>
        <pc:spChg chg="mod topLvl">
          <ac:chgData name="Perelygina, Ludmila M. (CDC/DDID/NCIRD/DVD)" userId="7d3b25f4-6f80-4483-bceb-5fdc4e1f170d" providerId="ADAL" clId="{37FD2FA5-ABDD-464C-8397-1D6DB9F8955D}" dt="2021-12-01T18:20:48.620" v="1629" actId="164"/>
          <ac:spMkLst>
            <pc:docMk/>
            <pc:sldMk cId="1726942282" sldId="256"/>
            <ac:spMk id="55" creationId="{2D4A214B-F315-4126-905C-4AF982500662}"/>
          </ac:spMkLst>
        </pc:spChg>
        <pc:grpChg chg="add del mod">
          <ac:chgData name="Perelygina, Ludmila M. (CDC/DDID/NCIRD/DVD)" userId="7d3b25f4-6f80-4483-bceb-5fdc4e1f170d" providerId="ADAL" clId="{37FD2FA5-ABDD-464C-8397-1D6DB9F8955D}" dt="2021-11-30T19:11:05.986" v="760" actId="165"/>
          <ac:grpSpMkLst>
            <pc:docMk/>
            <pc:sldMk cId="1726942282" sldId="256"/>
            <ac:grpSpMk id="2" creationId="{4D0A5124-88B5-4CC0-BAC8-30C90AF5EF07}"/>
          </ac:grpSpMkLst>
        </pc:grpChg>
        <pc:grpChg chg="add mod">
          <ac:chgData name="Perelygina, Ludmila M. (CDC/DDID/NCIRD/DVD)" userId="7d3b25f4-6f80-4483-bceb-5fdc4e1f170d" providerId="ADAL" clId="{37FD2FA5-ABDD-464C-8397-1D6DB9F8955D}" dt="2021-11-30T18:23:28.827" v="634" actId="164"/>
          <ac:grpSpMkLst>
            <pc:docMk/>
            <pc:sldMk cId="1726942282" sldId="256"/>
            <ac:grpSpMk id="2" creationId="{80363FFD-3B45-4C7A-B72B-C5E0FC228A49}"/>
          </ac:grpSpMkLst>
        </pc:grpChg>
        <pc:grpChg chg="add del mod">
          <ac:chgData name="Perelygina, Ludmila M. (CDC/DDID/NCIRD/DVD)" userId="7d3b25f4-6f80-4483-bceb-5fdc4e1f170d" providerId="ADAL" clId="{37FD2FA5-ABDD-464C-8397-1D6DB9F8955D}" dt="2021-12-01T18:14:52.838" v="1572" actId="165"/>
          <ac:grpSpMkLst>
            <pc:docMk/>
            <pc:sldMk cId="1726942282" sldId="256"/>
            <ac:grpSpMk id="3" creationId="{1E9FD51C-93FC-4D4A-8F14-30DEDF7478BE}"/>
          </ac:grpSpMkLst>
        </pc:grpChg>
        <pc:grpChg chg="add mod">
          <ac:chgData name="Perelygina, Ludmila M. (CDC/DDID/NCIRD/DVD)" userId="7d3b25f4-6f80-4483-bceb-5fdc4e1f170d" providerId="ADAL" clId="{37FD2FA5-ABDD-464C-8397-1D6DB9F8955D}" dt="2021-12-01T18:20:48.620" v="1629" actId="164"/>
          <ac:grpSpMkLst>
            <pc:docMk/>
            <pc:sldMk cId="1726942282" sldId="256"/>
            <ac:grpSpMk id="4" creationId="{4E64BF19-809E-447A-AF43-83BDC314167F}"/>
          </ac:grpSpMkLst>
        </pc:grpChg>
        <pc:grpChg chg="add mod">
          <ac:chgData name="Perelygina, Ludmila M. (CDC/DDID/NCIRD/DVD)" userId="7d3b25f4-6f80-4483-bceb-5fdc4e1f170d" providerId="ADAL" clId="{37FD2FA5-ABDD-464C-8397-1D6DB9F8955D}" dt="2021-12-01T18:20:48.620" v="1629" actId="164"/>
          <ac:grpSpMkLst>
            <pc:docMk/>
            <pc:sldMk cId="1726942282" sldId="256"/>
            <ac:grpSpMk id="6" creationId="{EF039703-8FD3-4880-9731-4BAA80D2DB6E}"/>
          </ac:grpSpMkLst>
        </pc:grpChg>
        <pc:grpChg chg="add mod">
          <ac:chgData name="Perelygina, Ludmila M. (CDC/DDID/NCIRD/DVD)" userId="7d3b25f4-6f80-4483-bceb-5fdc4e1f170d" providerId="ADAL" clId="{37FD2FA5-ABDD-464C-8397-1D6DB9F8955D}" dt="2021-12-01T18:20:48.620" v="1629" actId="164"/>
          <ac:grpSpMkLst>
            <pc:docMk/>
            <pc:sldMk cId="1726942282" sldId="256"/>
            <ac:grpSpMk id="9" creationId="{1277C819-E894-41B9-AADA-172A3435EE1F}"/>
          </ac:grpSpMkLst>
        </pc:grpChg>
        <pc:grpChg chg="add del mod">
          <ac:chgData name="Perelygina, Ludmila M. (CDC/DDID/NCIRD/DVD)" userId="7d3b25f4-6f80-4483-bceb-5fdc4e1f170d" providerId="ADAL" clId="{37FD2FA5-ABDD-464C-8397-1D6DB9F8955D}" dt="2021-11-30T18:58:03.834" v="651" actId="165"/>
          <ac:grpSpMkLst>
            <pc:docMk/>
            <pc:sldMk cId="1726942282" sldId="256"/>
            <ac:grpSpMk id="38" creationId="{FF7D90DF-C9FA-40A2-AA4F-6B80458C596D}"/>
          </ac:grpSpMkLst>
        </pc:grpChg>
        <pc:grpChg chg="add del mod">
          <ac:chgData name="Perelygina, Ludmila M. (CDC/DDID/NCIRD/DVD)" userId="7d3b25f4-6f80-4483-bceb-5fdc4e1f170d" providerId="ADAL" clId="{37FD2FA5-ABDD-464C-8397-1D6DB9F8955D}" dt="2021-11-30T19:05:47.410" v="718" actId="21"/>
          <ac:grpSpMkLst>
            <pc:docMk/>
            <pc:sldMk cId="1726942282" sldId="256"/>
            <ac:grpSpMk id="39" creationId="{A9747B91-F985-4B1F-A10C-D1C2672829A4}"/>
          </ac:grpSpMkLst>
        </pc:grpChg>
        <pc:grpChg chg="add del mod">
          <ac:chgData name="Perelygina, Ludmila M. (CDC/DDID/NCIRD/DVD)" userId="7d3b25f4-6f80-4483-bceb-5fdc4e1f170d" providerId="ADAL" clId="{37FD2FA5-ABDD-464C-8397-1D6DB9F8955D}" dt="2021-11-30T19:07:36.517" v="732" actId="165"/>
          <ac:grpSpMkLst>
            <pc:docMk/>
            <pc:sldMk cId="1726942282" sldId="256"/>
            <ac:grpSpMk id="45" creationId="{B24BD0BD-F5AD-4325-9198-8F83B4EC3E44}"/>
          </ac:grpSpMkLst>
        </pc:grpChg>
        <pc:graphicFrameChg chg="add mod topLvl">
          <ac:chgData name="Perelygina, Ludmila M. (CDC/DDID/NCIRD/DVD)" userId="7d3b25f4-6f80-4483-bceb-5fdc4e1f170d" providerId="ADAL" clId="{37FD2FA5-ABDD-464C-8397-1D6DB9F8955D}" dt="2021-12-01T18:20:48.620" v="1629" actId="164"/>
          <ac:graphicFrameMkLst>
            <pc:docMk/>
            <pc:sldMk cId="1726942282" sldId="256"/>
            <ac:graphicFrameMk id="30" creationId="{A8FD380A-76C5-4314-BE01-581E5F08BAA9}"/>
          </ac:graphicFrameMkLst>
        </pc:graphicFrameChg>
        <pc:picChg chg="mod topLvl">
          <ac:chgData name="Perelygina, Ludmila M. (CDC/DDID/NCIRD/DVD)" userId="7d3b25f4-6f80-4483-bceb-5fdc4e1f170d" providerId="ADAL" clId="{37FD2FA5-ABDD-464C-8397-1D6DB9F8955D}" dt="2021-11-30T18:23:29.601" v="635" actId="165"/>
          <ac:picMkLst>
            <pc:docMk/>
            <pc:sldMk cId="1726942282" sldId="256"/>
            <ac:picMk id="36" creationId="{162FD76D-BEB4-4E7A-B4FB-9726E920661A}"/>
          </ac:picMkLst>
        </pc:picChg>
        <pc:picChg chg="add del mod topLvl">
          <ac:chgData name="Perelygina, Ludmila M. (CDC/DDID/NCIRD/DVD)" userId="7d3b25f4-6f80-4483-bceb-5fdc4e1f170d" providerId="ADAL" clId="{37FD2FA5-ABDD-464C-8397-1D6DB9F8955D}" dt="2021-11-30T19:06:05.486" v="722" actId="21"/>
          <ac:picMkLst>
            <pc:docMk/>
            <pc:sldMk cId="1726942282" sldId="256"/>
            <ac:picMk id="37" creationId="{DB88E9D7-64A6-4B61-A3A7-498BA850D984}"/>
          </ac:picMkLst>
        </pc:picChg>
        <pc:picChg chg="del mod topLvl">
          <ac:chgData name="Perelygina, Ludmila M. (CDC/DDID/NCIRD/DVD)" userId="7d3b25f4-6f80-4483-bceb-5fdc4e1f170d" providerId="ADAL" clId="{37FD2FA5-ABDD-464C-8397-1D6DB9F8955D}" dt="2021-11-30T19:07:58.613" v="735" actId="478"/>
          <ac:picMkLst>
            <pc:docMk/>
            <pc:sldMk cId="1726942282" sldId="256"/>
            <ac:picMk id="56" creationId="{D66246D2-1E45-43D0-A7F9-D4D1F3608B60}"/>
          </ac:picMkLst>
        </pc:picChg>
        <pc:cxnChg chg="add del mod">
          <ac:chgData name="Perelygina, Ludmila M. (CDC/DDID/NCIRD/DVD)" userId="7d3b25f4-6f80-4483-bceb-5fdc4e1f170d" providerId="ADAL" clId="{37FD2FA5-ABDD-464C-8397-1D6DB9F8955D}" dt="2021-12-01T18:20:20.421" v="1620" actId="478"/>
          <ac:cxnSpMkLst>
            <pc:docMk/>
            <pc:sldMk cId="1726942282" sldId="256"/>
            <ac:cxnSpMk id="8" creationId="{56100F5B-C11B-4375-94F2-8EEA8CB62FD8}"/>
          </ac:cxnSpMkLst>
        </pc:cxnChg>
      </pc:sldChg>
      <pc:sldChg chg="addSp delSp modSp mod">
        <pc:chgData name="Perelygina, Ludmila M. (CDC/DDID/NCIRD/DVD)" userId="7d3b25f4-6f80-4483-bceb-5fdc4e1f170d" providerId="ADAL" clId="{37FD2FA5-ABDD-464C-8397-1D6DB9F8955D}" dt="2021-12-02T16:42:41.131" v="1939" actId="20577"/>
        <pc:sldMkLst>
          <pc:docMk/>
          <pc:sldMk cId="2864907532" sldId="257"/>
        </pc:sldMkLst>
        <pc:spChg chg="del mod">
          <ac:chgData name="Perelygina, Ludmila M. (CDC/DDID/NCIRD/DVD)" userId="7d3b25f4-6f80-4483-bceb-5fdc4e1f170d" providerId="ADAL" clId="{37FD2FA5-ABDD-464C-8397-1D6DB9F8955D}" dt="2021-12-01T13:41:38.873" v="886" actId="478"/>
          <ac:spMkLst>
            <pc:docMk/>
            <pc:sldMk cId="2864907532" sldId="257"/>
            <ac:spMk id="2" creationId="{18222F38-2CB7-475A-B786-287CBB3D4981}"/>
          </ac:spMkLst>
        </pc:spChg>
        <pc:spChg chg="add mod">
          <ac:chgData name="Perelygina, Ludmila M. (CDC/DDID/NCIRD/DVD)" userId="7d3b25f4-6f80-4483-bceb-5fdc4e1f170d" providerId="ADAL" clId="{37FD2FA5-ABDD-464C-8397-1D6DB9F8955D}" dt="2021-12-02T16:41:04.586" v="1907" actId="1038"/>
          <ac:spMkLst>
            <pc:docMk/>
            <pc:sldMk cId="2864907532" sldId="257"/>
            <ac:spMk id="6" creationId="{4EEBF3E1-EAF0-4182-8D43-6E90DBAB9C72}"/>
          </ac:spMkLst>
        </pc:spChg>
        <pc:spChg chg="add mod">
          <ac:chgData name="Perelygina, Ludmila M. (CDC/DDID/NCIRD/DVD)" userId="7d3b25f4-6f80-4483-bceb-5fdc4e1f170d" providerId="ADAL" clId="{37FD2FA5-ABDD-464C-8397-1D6DB9F8955D}" dt="2021-12-02T16:42:41.131" v="1939" actId="20577"/>
          <ac:spMkLst>
            <pc:docMk/>
            <pc:sldMk cId="2864907532" sldId="257"/>
            <ac:spMk id="7" creationId="{25F8C4D2-91FA-45EE-A853-F7E40B93AE51}"/>
          </ac:spMkLst>
        </pc:spChg>
        <pc:spChg chg="add mod">
          <ac:chgData name="Perelygina, Ludmila M. (CDC/DDID/NCIRD/DVD)" userId="7d3b25f4-6f80-4483-bceb-5fdc4e1f170d" providerId="ADAL" clId="{37FD2FA5-ABDD-464C-8397-1D6DB9F8955D}" dt="2021-12-02T16:40:58.120" v="1903" actId="1076"/>
          <ac:spMkLst>
            <pc:docMk/>
            <pc:sldMk cId="2864907532" sldId="257"/>
            <ac:spMk id="8" creationId="{E5DA449E-F502-42F6-9A3D-E68B41B66CF4}"/>
          </ac:spMkLst>
        </pc:spChg>
        <pc:spChg chg="add mod">
          <ac:chgData name="Perelygina, Ludmila M. (CDC/DDID/NCIRD/DVD)" userId="7d3b25f4-6f80-4483-bceb-5fdc4e1f170d" providerId="ADAL" clId="{37FD2FA5-ABDD-464C-8397-1D6DB9F8955D}" dt="2021-12-02T16:42:15.341" v="1936" actId="20577"/>
          <ac:spMkLst>
            <pc:docMk/>
            <pc:sldMk cId="2864907532" sldId="257"/>
            <ac:spMk id="9" creationId="{DA5AA404-9DD0-4DBC-AE09-C74D01F3050A}"/>
          </ac:spMkLst>
        </pc:spChg>
        <pc:spChg chg="del">
          <ac:chgData name="Perelygina, Ludmila M. (CDC/DDID/NCIRD/DVD)" userId="7d3b25f4-6f80-4483-bceb-5fdc4e1f170d" providerId="ADAL" clId="{37FD2FA5-ABDD-464C-8397-1D6DB9F8955D}" dt="2021-11-24T16:06:32.864" v="323" actId="478"/>
          <ac:spMkLst>
            <pc:docMk/>
            <pc:sldMk cId="2864907532" sldId="257"/>
            <ac:spMk id="12" creationId="{3F7CCACA-39A9-47F2-96B9-A60DDD1B5B81}"/>
          </ac:spMkLst>
        </pc:spChg>
        <pc:spChg chg="del">
          <ac:chgData name="Perelygina, Ludmila M. (CDC/DDID/NCIRD/DVD)" userId="7d3b25f4-6f80-4483-bceb-5fdc4e1f170d" providerId="ADAL" clId="{37FD2FA5-ABDD-464C-8397-1D6DB9F8955D}" dt="2021-11-24T16:06:32.864" v="323" actId="478"/>
          <ac:spMkLst>
            <pc:docMk/>
            <pc:sldMk cId="2864907532" sldId="257"/>
            <ac:spMk id="13" creationId="{129370F6-C5AC-477F-BC65-8D52A9C7B08F}"/>
          </ac:spMkLst>
        </pc:spChg>
        <pc:spChg chg="del">
          <ac:chgData name="Perelygina, Ludmila M. (CDC/DDID/NCIRD/DVD)" userId="7d3b25f4-6f80-4483-bceb-5fdc4e1f170d" providerId="ADAL" clId="{37FD2FA5-ABDD-464C-8397-1D6DB9F8955D}" dt="2021-11-24T16:06:32.864" v="323" actId="478"/>
          <ac:spMkLst>
            <pc:docMk/>
            <pc:sldMk cId="2864907532" sldId="257"/>
            <ac:spMk id="14" creationId="{FF9DB941-E3AB-4CD9-BA2F-8271A98CFF7B}"/>
          </ac:spMkLst>
        </pc:spChg>
        <pc:graphicFrameChg chg="add mod modGraphic">
          <ac:chgData name="Perelygina, Ludmila M. (CDC/DDID/NCIRD/DVD)" userId="7d3b25f4-6f80-4483-bceb-5fdc4e1f170d" providerId="ADAL" clId="{37FD2FA5-ABDD-464C-8397-1D6DB9F8955D}" dt="2021-12-01T18:40:43.821" v="1812" actId="1076"/>
          <ac:graphicFrameMkLst>
            <pc:docMk/>
            <pc:sldMk cId="2864907532" sldId="257"/>
            <ac:graphicFrameMk id="3" creationId="{618FF06B-4D82-408A-B002-DEED8867C78D}"/>
          </ac:graphicFrameMkLst>
        </pc:graphicFrameChg>
        <pc:graphicFrameChg chg="add del mod modGraphic">
          <ac:chgData name="Perelygina, Ludmila M. (CDC/DDID/NCIRD/DVD)" userId="7d3b25f4-6f80-4483-bceb-5fdc4e1f170d" providerId="ADAL" clId="{37FD2FA5-ABDD-464C-8397-1D6DB9F8955D}" dt="2021-11-30T13:39:00.372" v="348" actId="478"/>
          <ac:graphicFrameMkLst>
            <pc:docMk/>
            <pc:sldMk cId="2864907532" sldId="257"/>
            <ac:graphicFrameMk id="3" creationId="{B55D62F5-43EB-4502-9CFB-9F850FE1C8E3}"/>
          </ac:graphicFrameMkLst>
        </pc:graphicFrameChg>
        <pc:graphicFrameChg chg="add del mod modGraphic">
          <ac:chgData name="Perelygina, Ludmila M. (CDC/DDID/NCIRD/DVD)" userId="7d3b25f4-6f80-4483-bceb-5fdc4e1f170d" providerId="ADAL" clId="{37FD2FA5-ABDD-464C-8397-1D6DB9F8955D}" dt="2021-11-30T14:12:17.194" v="376" actId="478"/>
          <ac:graphicFrameMkLst>
            <pc:docMk/>
            <pc:sldMk cId="2864907532" sldId="257"/>
            <ac:graphicFrameMk id="4" creationId="{32F9E5F8-2F71-4B02-A04E-E09D6B5662BF}"/>
          </ac:graphicFrameMkLst>
        </pc:graphicFrameChg>
        <pc:graphicFrameChg chg="add del mod modGraphic">
          <ac:chgData name="Perelygina, Ludmila M. (CDC/DDID/NCIRD/DVD)" userId="7d3b25f4-6f80-4483-bceb-5fdc4e1f170d" providerId="ADAL" clId="{37FD2FA5-ABDD-464C-8397-1D6DB9F8955D}" dt="2021-12-01T13:45:20.948" v="887" actId="478"/>
          <ac:graphicFrameMkLst>
            <pc:docMk/>
            <pc:sldMk cId="2864907532" sldId="257"/>
            <ac:graphicFrameMk id="5" creationId="{B2D834B4-7136-4410-92DD-296CEC874013}"/>
          </ac:graphicFrameMkLst>
        </pc:graphicFrameChg>
        <pc:picChg chg="add del mod">
          <ac:chgData name="Perelygina, Ludmila M. (CDC/DDID/NCIRD/DVD)" userId="7d3b25f4-6f80-4483-bceb-5fdc4e1f170d" providerId="ADAL" clId="{37FD2FA5-ABDD-464C-8397-1D6DB9F8955D}" dt="2021-11-24T16:09:30.035" v="327" actId="478"/>
          <ac:picMkLst>
            <pc:docMk/>
            <pc:sldMk cId="2864907532" sldId="257"/>
            <ac:picMk id="4" creationId="{C537ACDA-3F74-4044-B93A-ACAE7B7A53F3}"/>
          </ac:picMkLst>
        </pc:picChg>
        <pc:picChg chg="add del mod">
          <ac:chgData name="Perelygina, Ludmila M. (CDC/DDID/NCIRD/DVD)" userId="7d3b25f4-6f80-4483-bceb-5fdc4e1f170d" providerId="ADAL" clId="{37FD2FA5-ABDD-464C-8397-1D6DB9F8955D}" dt="2021-11-24T16:43:07.191" v="337" actId="478"/>
          <ac:picMkLst>
            <pc:docMk/>
            <pc:sldMk cId="2864907532" sldId="257"/>
            <ac:picMk id="5" creationId="{493D74CA-BAEC-471E-9743-AA7E520C1E87}"/>
          </ac:picMkLst>
        </pc:picChg>
        <pc:picChg chg="add del mod">
          <ac:chgData name="Perelygina, Ludmila M. (CDC/DDID/NCIRD/DVD)" userId="7d3b25f4-6f80-4483-bceb-5fdc4e1f170d" providerId="ADAL" clId="{37FD2FA5-ABDD-464C-8397-1D6DB9F8955D}" dt="2021-11-30T15:39:22.426" v="525" actId="478"/>
          <ac:picMkLst>
            <pc:docMk/>
            <pc:sldMk cId="2864907532" sldId="257"/>
            <ac:picMk id="6" creationId="{27AAF4D4-B94C-4533-A6AC-3F534D55F3A4}"/>
          </ac:picMkLst>
        </pc:picChg>
        <pc:picChg chg="add del mod">
          <ac:chgData name="Perelygina, Ludmila M. (CDC/DDID/NCIRD/DVD)" userId="7d3b25f4-6f80-4483-bceb-5fdc4e1f170d" providerId="ADAL" clId="{37FD2FA5-ABDD-464C-8397-1D6DB9F8955D}" dt="2021-11-30T15:39:23.354" v="526" actId="478"/>
          <ac:picMkLst>
            <pc:docMk/>
            <pc:sldMk cId="2864907532" sldId="257"/>
            <ac:picMk id="8" creationId="{6D8F98D3-A635-4419-9A06-F9B77C92BCA2}"/>
          </ac:picMkLst>
        </pc:picChg>
        <pc:picChg chg="del">
          <ac:chgData name="Perelygina, Ludmila M. (CDC/DDID/NCIRD/DVD)" userId="7d3b25f4-6f80-4483-bceb-5fdc4e1f170d" providerId="ADAL" clId="{37FD2FA5-ABDD-464C-8397-1D6DB9F8955D}" dt="2021-11-24T16:06:30.737" v="322" actId="478"/>
          <ac:picMkLst>
            <pc:docMk/>
            <pc:sldMk cId="2864907532" sldId="257"/>
            <ac:picMk id="9" creationId="{4A80953C-6FB1-4020-BEA7-B19D07E9BB7C}"/>
          </ac:picMkLst>
        </pc:picChg>
        <pc:picChg chg="add del mod">
          <ac:chgData name="Perelygina, Ludmila M. (CDC/DDID/NCIRD/DVD)" userId="7d3b25f4-6f80-4483-bceb-5fdc4e1f170d" providerId="ADAL" clId="{37FD2FA5-ABDD-464C-8397-1D6DB9F8955D}" dt="2021-11-30T16:29:15.670" v="539" actId="478"/>
          <ac:picMkLst>
            <pc:docMk/>
            <pc:sldMk cId="2864907532" sldId="257"/>
            <ac:picMk id="10" creationId="{3C8CF366-C489-4BE1-8867-EE6BC07C2D6C}"/>
          </ac:picMkLst>
        </pc:picChg>
        <pc:picChg chg="del">
          <ac:chgData name="Perelygina, Ludmila M. (CDC/DDID/NCIRD/DVD)" userId="7d3b25f4-6f80-4483-bceb-5fdc4e1f170d" providerId="ADAL" clId="{37FD2FA5-ABDD-464C-8397-1D6DB9F8955D}" dt="2021-11-24T16:06:29.793" v="321" actId="478"/>
          <ac:picMkLst>
            <pc:docMk/>
            <pc:sldMk cId="2864907532" sldId="257"/>
            <ac:picMk id="11" creationId="{856ED258-174D-4B2A-94ED-0440F45F2760}"/>
          </ac:picMkLst>
        </pc:picChg>
        <pc:picChg chg="add del mod">
          <ac:chgData name="Perelygina, Ludmila M. (CDC/DDID/NCIRD/DVD)" userId="7d3b25f4-6f80-4483-bceb-5fdc4e1f170d" providerId="ADAL" clId="{37FD2FA5-ABDD-464C-8397-1D6DB9F8955D}" dt="2021-11-30T16:29:13.174" v="538" actId="478"/>
          <ac:picMkLst>
            <pc:docMk/>
            <pc:sldMk cId="2864907532" sldId="257"/>
            <ac:picMk id="12" creationId="{C549AD26-4E5F-46E9-9801-C86C7A7BD473}"/>
          </ac:picMkLst>
        </pc:picChg>
        <pc:picChg chg="add mod">
          <ac:chgData name="Perelygina, Ludmila M. (CDC/DDID/NCIRD/DVD)" userId="7d3b25f4-6f80-4483-bceb-5fdc4e1f170d" providerId="ADAL" clId="{37FD2FA5-ABDD-464C-8397-1D6DB9F8955D}" dt="2021-12-02T16:40:55.656" v="1902" actId="1076"/>
          <ac:picMkLst>
            <pc:docMk/>
            <pc:sldMk cId="2864907532" sldId="257"/>
            <ac:picMk id="14" creationId="{160A2E07-4B21-4669-8B25-8B49BC1DD09D}"/>
          </ac:picMkLst>
        </pc:picChg>
        <pc:picChg chg="add del mod">
          <ac:chgData name="Perelygina, Ludmila M. (CDC/DDID/NCIRD/DVD)" userId="7d3b25f4-6f80-4483-bceb-5fdc4e1f170d" providerId="ADAL" clId="{37FD2FA5-ABDD-464C-8397-1D6DB9F8955D}" dt="2021-11-30T16:32:08.775" v="555" actId="478"/>
          <ac:picMkLst>
            <pc:docMk/>
            <pc:sldMk cId="2864907532" sldId="257"/>
            <ac:picMk id="16" creationId="{FBB5A3F6-3E20-4A37-ADE6-6C85AC24733C}"/>
          </ac:picMkLst>
        </pc:picChg>
        <pc:picChg chg="add mod">
          <ac:chgData name="Perelygina, Ludmila M. (CDC/DDID/NCIRD/DVD)" userId="7d3b25f4-6f80-4483-bceb-5fdc4e1f170d" providerId="ADAL" clId="{37FD2FA5-ABDD-464C-8397-1D6DB9F8955D}" dt="2021-12-01T18:40:30.205" v="1811" actId="14100"/>
          <ac:picMkLst>
            <pc:docMk/>
            <pc:sldMk cId="2864907532" sldId="257"/>
            <ac:picMk id="18" creationId="{8BD43898-10D6-4518-BDD0-505A854D1829}"/>
          </ac:picMkLst>
        </pc:picChg>
      </pc:sldChg>
      <pc:sldChg chg="addSp delSp modSp new mod ord">
        <pc:chgData name="Perelygina, Ludmila M. (CDC/DDID/NCIRD/DVD)" userId="7d3b25f4-6f80-4483-bceb-5fdc4e1f170d" providerId="ADAL" clId="{37FD2FA5-ABDD-464C-8397-1D6DB9F8955D}" dt="2021-12-07T11:47:44.716" v="2184" actId="1036"/>
        <pc:sldMkLst>
          <pc:docMk/>
          <pc:sldMk cId="1664974692" sldId="258"/>
        </pc:sldMkLst>
        <pc:spChg chg="add mod">
          <ac:chgData name="Perelygina, Ludmila M. (CDC/DDID/NCIRD/DVD)" userId="7d3b25f4-6f80-4483-bceb-5fdc4e1f170d" providerId="ADAL" clId="{37FD2FA5-ABDD-464C-8397-1D6DB9F8955D}" dt="2021-12-07T11:47:44.716" v="2184" actId="1036"/>
          <ac:spMkLst>
            <pc:docMk/>
            <pc:sldMk cId="1664974692" sldId="258"/>
            <ac:spMk id="4" creationId="{0D97A794-93DF-4132-A57A-9F177761E2E0}"/>
          </ac:spMkLst>
        </pc:spChg>
        <pc:spChg chg="add mod topLvl">
          <ac:chgData name="Perelygina, Ludmila M. (CDC/DDID/NCIRD/DVD)" userId="7d3b25f4-6f80-4483-bceb-5fdc4e1f170d" providerId="ADAL" clId="{37FD2FA5-ABDD-464C-8397-1D6DB9F8955D}" dt="2021-11-24T15:55:56.398" v="188" actId="164"/>
          <ac:spMkLst>
            <pc:docMk/>
            <pc:sldMk cId="1664974692" sldId="258"/>
            <ac:spMk id="6" creationId="{532EE440-FE70-4B88-9CA0-A67BBED3C564}"/>
          </ac:spMkLst>
        </pc:spChg>
        <pc:spChg chg="add mod topLvl">
          <ac:chgData name="Perelygina, Ludmila M. (CDC/DDID/NCIRD/DVD)" userId="7d3b25f4-6f80-4483-bceb-5fdc4e1f170d" providerId="ADAL" clId="{37FD2FA5-ABDD-464C-8397-1D6DB9F8955D}" dt="2021-11-24T15:55:56.398" v="188" actId="164"/>
          <ac:spMkLst>
            <pc:docMk/>
            <pc:sldMk cId="1664974692" sldId="258"/>
            <ac:spMk id="7" creationId="{6A349AB3-2188-4D13-9605-20EFC83228DB}"/>
          </ac:spMkLst>
        </pc:spChg>
        <pc:spChg chg="add mod topLvl">
          <ac:chgData name="Perelygina, Ludmila M. (CDC/DDID/NCIRD/DVD)" userId="7d3b25f4-6f80-4483-bceb-5fdc4e1f170d" providerId="ADAL" clId="{37FD2FA5-ABDD-464C-8397-1D6DB9F8955D}" dt="2021-11-24T15:56:12.919" v="190" actId="164"/>
          <ac:spMkLst>
            <pc:docMk/>
            <pc:sldMk cId="1664974692" sldId="258"/>
            <ac:spMk id="8" creationId="{912408BA-6AAF-487B-8103-E03DCF2C0A49}"/>
          </ac:spMkLst>
        </pc:spChg>
        <pc:spChg chg="add mod topLvl">
          <ac:chgData name="Perelygina, Ludmila M. (CDC/DDID/NCIRD/DVD)" userId="7d3b25f4-6f80-4483-bceb-5fdc4e1f170d" providerId="ADAL" clId="{37FD2FA5-ABDD-464C-8397-1D6DB9F8955D}" dt="2021-11-24T15:56:12.919" v="190" actId="164"/>
          <ac:spMkLst>
            <pc:docMk/>
            <pc:sldMk cId="1664974692" sldId="258"/>
            <ac:spMk id="9" creationId="{8E32C665-0181-452F-9993-F4D16F633A28}"/>
          </ac:spMkLst>
        </pc:spChg>
        <pc:spChg chg="add mod">
          <ac:chgData name="Perelygina, Ludmila M. (CDC/DDID/NCIRD/DVD)" userId="7d3b25f4-6f80-4483-bceb-5fdc4e1f170d" providerId="ADAL" clId="{37FD2FA5-ABDD-464C-8397-1D6DB9F8955D}" dt="2021-12-07T11:47:44.716" v="2184" actId="1036"/>
          <ac:spMkLst>
            <pc:docMk/>
            <pc:sldMk cId="1664974692" sldId="258"/>
            <ac:spMk id="10" creationId="{53FCA661-7CF5-4EA8-8086-7B4F74AE6B0E}"/>
          </ac:spMkLst>
        </pc:spChg>
        <pc:spChg chg="add del mod">
          <ac:chgData name="Perelygina, Ludmila M. (CDC/DDID/NCIRD/DVD)" userId="7d3b25f4-6f80-4483-bceb-5fdc4e1f170d" providerId="ADAL" clId="{37FD2FA5-ABDD-464C-8397-1D6DB9F8955D}" dt="2021-11-23T20:29:51.129" v="135" actId="478"/>
          <ac:spMkLst>
            <pc:docMk/>
            <pc:sldMk cId="1664974692" sldId="258"/>
            <ac:spMk id="10" creationId="{EDA95D11-2E95-4D59-9E1A-C4BDDDB99B26}"/>
          </ac:spMkLst>
        </pc:spChg>
        <pc:spChg chg="add mod">
          <ac:chgData name="Perelygina, Ludmila M. (CDC/DDID/NCIRD/DVD)" userId="7d3b25f4-6f80-4483-bceb-5fdc4e1f170d" providerId="ADAL" clId="{37FD2FA5-ABDD-464C-8397-1D6DB9F8955D}" dt="2021-11-24T15:56:12.919" v="190" actId="164"/>
          <ac:spMkLst>
            <pc:docMk/>
            <pc:sldMk cId="1664974692" sldId="258"/>
            <ac:spMk id="11" creationId="{1D94F09C-229E-4439-87BC-A363A0E5C60C}"/>
          </ac:spMkLst>
        </pc:spChg>
        <pc:spChg chg="add mod">
          <ac:chgData name="Perelygina, Ludmila M. (CDC/DDID/NCIRD/DVD)" userId="7d3b25f4-6f80-4483-bceb-5fdc4e1f170d" providerId="ADAL" clId="{37FD2FA5-ABDD-464C-8397-1D6DB9F8955D}" dt="2021-11-24T15:55:56.398" v="188" actId="164"/>
          <ac:spMkLst>
            <pc:docMk/>
            <pc:sldMk cId="1664974692" sldId="258"/>
            <ac:spMk id="12" creationId="{AA0381B7-5BC9-4922-973E-59471817D675}"/>
          </ac:spMkLst>
        </pc:spChg>
        <pc:spChg chg="add mod">
          <ac:chgData name="Perelygina, Ludmila M. (CDC/DDID/NCIRD/DVD)" userId="7d3b25f4-6f80-4483-bceb-5fdc4e1f170d" providerId="ADAL" clId="{37FD2FA5-ABDD-464C-8397-1D6DB9F8955D}" dt="2021-12-07T11:47:44.716" v="2184" actId="1036"/>
          <ac:spMkLst>
            <pc:docMk/>
            <pc:sldMk cId="1664974692" sldId="258"/>
            <ac:spMk id="15" creationId="{1179887A-73E5-4A7D-A6B1-332F43AA631E}"/>
          </ac:spMkLst>
        </pc:spChg>
        <pc:spChg chg="add mod">
          <ac:chgData name="Perelygina, Ludmila M. (CDC/DDID/NCIRD/DVD)" userId="7d3b25f4-6f80-4483-bceb-5fdc4e1f170d" providerId="ADAL" clId="{37FD2FA5-ABDD-464C-8397-1D6DB9F8955D}" dt="2021-12-07T11:47:44.716" v="2184" actId="1036"/>
          <ac:spMkLst>
            <pc:docMk/>
            <pc:sldMk cId="1664974692" sldId="258"/>
            <ac:spMk id="16" creationId="{D7AC37FD-2D02-4B02-BF1A-879A215C3E1B}"/>
          </ac:spMkLst>
        </pc:spChg>
        <pc:spChg chg="add del mod">
          <ac:chgData name="Perelygina, Ludmila M. (CDC/DDID/NCIRD/DVD)" userId="7d3b25f4-6f80-4483-bceb-5fdc4e1f170d" providerId="ADAL" clId="{37FD2FA5-ABDD-464C-8397-1D6DB9F8955D}" dt="2021-11-24T16:00:16.188" v="206"/>
          <ac:spMkLst>
            <pc:docMk/>
            <pc:sldMk cId="1664974692" sldId="258"/>
            <ac:spMk id="16" creationId="{ED6E4D61-4718-41E4-A212-C12578FA84BE}"/>
          </ac:spMkLst>
        </pc:spChg>
        <pc:spChg chg="add del mod">
          <ac:chgData name="Perelygina, Ludmila M. (CDC/DDID/NCIRD/DVD)" userId="7d3b25f4-6f80-4483-bceb-5fdc4e1f170d" providerId="ADAL" clId="{37FD2FA5-ABDD-464C-8397-1D6DB9F8955D}" dt="2021-11-24T16:02:31.695" v="253" actId="478"/>
          <ac:spMkLst>
            <pc:docMk/>
            <pc:sldMk cId="1664974692" sldId="258"/>
            <ac:spMk id="17" creationId="{6B86C702-D5DE-4BE8-9F6F-176E121C33CA}"/>
          </ac:spMkLst>
        </pc:spChg>
        <pc:spChg chg="mod">
          <ac:chgData name="Perelygina, Ludmila M. (CDC/DDID/NCIRD/DVD)" userId="7d3b25f4-6f80-4483-bceb-5fdc4e1f170d" providerId="ADAL" clId="{37FD2FA5-ABDD-464C-8397-1D6DB9F8955D}" dt="2021-12-07T11:47:44.716" v="2184" actId="1036"/>
          <ac:spMkLst>
            <pc:docMk/>
            <pc:sldMk cId="1664974692" sldId="258"/>
            <ac:spMk id="29" creationId="{3D2D728A-FC60-450A-AEF9-9E500AF5D238}"/>
          </ac:spMkLst>
        </pc:spChg>
        <pc:spChg chg="mod">
          <ac:chgData name="Perelygina, Ludmila M. (CDC/DDID/NCIRD/DVD)" userId="7d3b25f4-6f80-4483-bceb-5fdc4e1f170d" providerId="ADAL" clId="{37FD2FA5-ABDD-464C-8397-1D6DB9F8955D}" dt="2021-12-07T11:47:44.716" v="2184" actId="1036"/>
          <ac:spMkLst>
            <pc:docMk/>
            <pc:sldMk cId="1664974692" sldId="258"/>
            <ac:spMk id="30" creationId="{F7210DD3-2D86-47FE-A22F-70ACEAE51D2A}"/>
          </ac:spMkLst>
        </pc:spChg>
        <pc:spChg chg="mod">
          <ac:chgData name="Perelygina, Ludmila M. (CDC/DDID/NCIRD/DVD)" userId="7d3b25f4-6f80-4483-bceb-5fdc4e1f170d" providerId="ADAL" clId="{37FD2FA5-ABDD-464C-8397-1D6DB9F8955D}" dt="2021-12-07T11:47:44.716" v="2184" actId="1036"/>
          <ac:spMkLst>
            <pc:docMk/>
            <pc:sldMk cId="1664974692" sldId="258"/>
            <ac:spMk id="32" creationId="{8E94FC1B-4F01-4D77-B3C8-38682C1B1F37}"/>
          </ac:spMkLst>
        </pc:spChg>
        <pc:spChg chg="mod">
          <ac:chgData name="Perelygina, Ludmila M. (CDC/DDID/NCIRD/DVD)" userId="7d3b25f4-6f80-4483-bceb-5fdc4e1f170d" providerId="ADAL" clId="{37FD2FA5-ABDD-464C-8397-1D6DB9F8955D}" dt="2021-12-07T11:47:44.716" v="2184" actId="1036"/>
          <ac:spMkLst>
            <pc:docMk/>
            <pc:sldMk cId="1664974692" sldId="258"/>
            <ac:spMk id="33" creationId="{7EE23045-7D33-490D-9227-BD224C2CB564}"/>
          </ac:spMkLst>
        </pc:spChg>
        <pc:spChg chg="mod">
          <ac:chgData name="Perelygina, Ludmila M. (CDC/DDID/NCIRD/DVD)" userId="7d3b25f4-6f80-4483-bceb-5fdc4e1f170d" providerId="ADAL" clId="{37FD2FA5-ABDD-464C-8397-1D6DB9F8955D}" dt="2021-12-07T11:47:44.716" v="2184" actId="1036"/>
          <ac:spMkLst>
            <pc:docMk/>
            <pc:sldMk cId="1664974692" sldId="258"/>
            <ac:spMk id="34" creationId="{8D3EA077-3C5D-48B8-BCB8-7CEE539FBF8F}"/>
          </ac:spMkLst>
        </pc:spChg>
        <pc:spChg chg="mod">
          <ac:chgData name="Perelygina, Ludmila M. (CDC/DDID/NCIRD/DVD)" userId="7d3b25f4-6f80-4483-bceb-5fdc4e1f170d" providerId="ADAL" clId="{37FD2FA5-ABDD-464C-8397-1D6DB9F8955D}" dt="2021-12-07T11:47:44.716" v="2184" actId="1036"/>
          <ac:spMkLst>
            <pc:docMk/>
            <pc:sldMk cId="1664974692" sldId="258"/>
            <ac:spMk id="35" creationId="{95300F00-EEF5-45DD-A5A3-B6E56578259C}"/>
          </ac:spMkLst>
        </pc:spChg>
        <pc:spChg chg="mod">
          <ac:chgData name="Perelygina, Ludmila M. (CDC/DDID/NCIRD/DVD)" userId="7d3b25f4-6f80-4483-bceb-5fdc4e1f170d" providerId="ADAL" clId="{37FD2FA5-ABDD-464C-8397-1D6DB9F8955D}" dt="2021-12-07T11:47:44.716" v="2184" actId="1036"/>
          <ac:spMkLst>
            <pc:docMk/>
            <pc:sldMk cId="1664974692" sldId="258"/>
            <ac:spMk id="36" creationId="{32A03A23-0E38-4FC8-9A2B-51F66E9F3AB8}"/>
          </ac:spMkLst>
        </pc:spChg>
        <pc:grpChg chg="add del mod">
          <ac:chgData name="Perelygina, Ludmila M. (CDC/DDID/NCIRD/DVD)" userId="7d3b25f4-6f80-4483-bceb-5fdc4e1f170d" providerId="ADAL" clId="{37FD2FA5-ABDD-464C-8397-1D6DB9F8955D}" dt="2021-11-24T15:55:47.893" v="187" actId="165"/>
          <ac:grpSpMkLst>
            <pc:docMk/>
            <pc:sldMk cId="1664974692" sldId="258"/>
            <ac:grpSpMk id="2" creationId="{B7F68F95-836A-4919-BA69-159B68F2D44A}"/>
          </ac:grpSpMkLst>
        </pc:grpChg>
        <pc:grpChg chg="add mod">
          <ac:chgData name="Perelygina, Ludmila M. (CDC/DDID/NCIRD/DVD)" userId="7d3b25f4-6f80-4483-bceb-5fdc4e1f170d" providerId="ADAL" clId="{37FD2FA5-ABDD-464C-8397-1D6DB9F8955D}" dt="2021-12-07T11:47:44.716" v="2184" actId="1036"/>
          <ac:grpSpMkLst>
            <pc:docMk/>
            <pc:sldMk cId="1664974692" sldId="258"/>
            <ac:grpSpMk id="13" creationId="{E22169B2-A3F4-40EB-83D4-6FCC1039A0A1}"/>
          </ac:grpSpMkLst>
        </pc:grpChg>
        <pc:grpChg chg="add mod">
          <ac:chgData name="Perelygina, Ludmila M. (CDC/DDID/NCIRD/DVD)" userId="7d3b25f4-6f80-4483-bceb-5fdc4e1f170d" providerId="ADAL" clId="{37FD2FA5-ABDD-464C-8397-1D6DB9F8955D}" dt="2021-12-07T11:47:44.716" v="2184" actId="1036"/>
          <ac:grpSpMkLst>
            <pc:docMk/>
            <pc:sldMk cId="1664974692" sldId="258"/>
            <ac:grpSpMk id="14" creationId="{CD0A6AC8-32FA-4510-B3C8-2AAA273D4754}"/>
          </ac:grpSpMkLst>
        </pc:grpChg>
        <pc:grpChg chg="mod">
          <ac:chgData name="Perelygina, Ludmila M. (CDC/DDID/NCIRD/DVD)" userId="7d3b25f4-6f80-4483-bceb-5fdc4e1f170d" providerId="ADAL" clId="{37FD2FA5-ABDD-464C-8397-1D6DB9F8955D}" dt="2021-12-07T11:47:44.716" v="2184" actId="1036"/>
          <ac:grpSpMkLst>
            <pc:docMk/>
            <pc:sldMk cId="1664974692" sldId="258"/>
            <ac:grpSpMk id="23" creationId="{68B25D1D-9189-4507-AF5C-7F2B42FDD9B7}"/>
          </ac:grpSpMkLst>
        </pc:grpChg>
        <pc:graphicFrameChg chg="mod">
          <ac:chgData name="Perelygina, Ludmila M. (CDC/DDID/NCIRD/DVD)" userId="7d3b25f4-6f80-4483-bceb-5fdc4e1f170d" providerId="ADAL" clId="{37FD2FA5-ABDD-464C-8397-1D6DB9F8955D}" dt="2021-12-07T11:47:44.716" v="2184" actId="1036"/>
          <ac:graphicFrameMkLst>
            <pc:docMk/>
            <pc:sldMk cId="1664974692" sldId="258"/>
            <ac:graphicFrameMk id="28" creationId="{E9533548-8D9D-400A-A97A-06E3097E32CD}"/>
          </ac:graphicFrameMkLst>
        </pc:graphicFrameChg>
        <pc:picChg chg="add mod topLvl">
          <ac:chgData name="Perelygina, Ludmila M. (CDC/DDID/NCIRD/DVD)" userId="7d3b25f4-6f80-4483-bceb-5fdc4e1f170d" providerId="ADAL" clId="{37FD2FA5-ABDD-464C-8397-1D6DB9F8955D}" dt="2021-11-24T15:56:12.919" v="190" actId="164"/>
          <ac:picMkLst>
            <pc:docMk/>
            <pc:sldMk cId="1664974692" sldId="258"/>
            <ac:picMk id="3" creationId="{017D7002-3432-4BCD-8379-A118EA2DC8F5}"/>
          </ac:picMkLst>
        </pc:picChg>
        <pc:picChg chg="add mod topLvl">
          <ac:chgData name="Perelygina, Ludmila M. (CDC/DDID/NCIRD/DVD)" userId="7d3b25f4-6f80-4483-bceb-5fdc4e1f170d" providerId="ADAL" clId="{37FD2FA5-ABDD-464C-8397-1D6DB9F8955D}" dt="2021-11-24T15:55:56.398" v="188" actId="164"/>
          <ac:picMkLst>
            <pc:docMk/>
            <pc:sldMk cId="1664974692" sldId="258"/>
            <ac:picMk id="5" creationId="{624CBDB6-D0B3-4E82-9D73-E1F035A107EC}"/>
          </ac:picMkLst>
        </pc:picChg>
      </pc:sldChg>
      <pc:sldChg chg="addSp modSp add del">
        <pc:chgData name="Perelygina, Ludmila M. (CDC/DDID/NCIRD/DVD)" userId="7d3b25f4-6f80-4483-bceb-5fdc4e1f170d" providerId="ADAL" clId="{37FD2FA5-ABDD-464C-8397-1D6DB9F8955D}" dt="2021-11-30T14:01:28.647" v="355" actId="47"/>
        <pc:sldMkLst>
          <pc:docMk/>
          <pc:sldMk cId="1786850455" sldId="259"/>
        </pc:sldMkLst>
        <pc:graphicFrameChg chg="add mod">
          <ac:chgData name="Perelygina, Ludmila M. (CDC/DDID/NCIRD/DVD)" userId="7d3b25f4-6f80-4483-bceb-5fdc4e1f170d" providerId="ADAL" clId="{37FD2FA5-ABDD-464C-8397-1D6DB9F8955D}" dt="2021-11-30T13:57:17.556" v="352"/>
          <ac:graphicFrameMkLst>
            <pc:docMk/>
            <pc:sldMk cId="1786850455" sldId="259"/>
            <ac:graphicFrameMk id="2" creationId="{D39F64CF-7CED-41E6-8BFA-EF7086A8415B}"/>
          </ac:graphicFrameMkLst>
        </pc:graphicFrameChg>
      </pc:sldChg>
      <pc:sldChg chg="addSp modSp add del mod">
        <pc:chgData name="Perelygina, Ludmila M. (CDC/DDID/NCIRD/DVD)" userId="7d3b25f4-6f80-4483-bceb-5fdc4e1f170d" providerId="ADAL" clId="{37FD2FA5-ABDD-464C-8397-1D6DB9F8955D}" dt="2021-12-01T13:28:52.659" v="882" actId="47"/>
        <pc:sldMkLst>
          <pc:docMk/>
          <pc:sldMk cId="1184749516" sldId="260"/>
        </pc:sldMkLst>
        <pc:graphicFrameChg chg="add mod">
          <ac:chgData name="Perelygina, Ludmila M. (CDC/DDID/NCIRD/DVD)" userId="7d3b25f4-6f80-4483-bceb-5fdc4e1f170d" providerId="ADAL" clId="{37FD2FA5-ABDD-464C-8397-1D6DB9F8955D}" dt="2021-11-30T15:15:45.772" v="524" actId="1076"/>
          <ac:graphicFrameMkLst>
            <pc:docMk/>
            <pc:sldMk cId="1184749516" sldId="260"/>
            <ac:graphicFrameMk id="2" creationId="{522E14EA-FC9D-4C0C-BDC7-8D8CB1E83754}"/>
          </ac:graphicFrameMkLst>
        </pc:graphicFrameChg>
      </pc:sldChg>
      <pc:sldChg chg="addSp modSp add mod ord">
        <pc:chgData name="Perelygina, Ludmila M. (CDC/DDID/NCIRD/DVD)" userId="7d3b25f4-6f80-4483-bceb-5fdc4e1f170d" providerId="ADAL" clId="{37FD2FA5-ABDD-464C-8397-1D6DB9F8955D}" dt="2021-11-30T19:15:26.993" v="788"/>
        <pc:sldMkLst>
          <pc:docMk/>
          <pc:sldMk cId="3550709966" sldId="261"/>
        </pc:sldMkLst>
        <pc:spChg chg="mod">
          <ac:chgData name="Perelygina, Ludmila M. (CDC/DDID/NCIRD/DVD)" userId="7d3b25f4-6f80-4483-bceb-5fdc4e1f170d" providerId="ADAL" clId="{37FD2FA5-ABDD-464C-8397-1D6DB9F8955D}" dt="2021-11-30T19:05:50.551" v="719"/>
          <ac:spMkLst>
            <pc:docMk/>
            <pc:sldMk cId="3550709966" sldId="261"/>
            <ac:spMk id="4" creationId="{D1450344-3DAA-4F62-A73D-A3E9FF56E0A5}"/>
          </ac:spMkLst>
        </pc:spChg>
        <pc:spChg chg="mod">
          <ac:chgData name="Perelygina, Ludmila M. (CDC/DDID/NCIRD/DVD)" userId="7d3b25f4-6f80-4483-bceb-5fdc4e1f170d" providerId="ADAL" clId="{37FD2FA5-ABDD-464C-8397-1D6DB9F8955D}" dt="2021-11-30T19:05:50.551" v="719"/>
          <ac:spMkLst>
            <pc:docMk/>
            <pc:sldMk cId="3550709966" sldId="261"/>
            <ac:spMk id="5" creationId="{77F3269F-218A-4126-8B40-CB1AA19BC183}"/>
          </ac:spMkLst>
        </pc:spChg>
        <pc:spChg chg="mod">
          <ac:chgData name="Perelygina, Ludmila M. (CDC/DDID/NCIRD/DVD)" userId="7d3b25f4-6f80-4483-bceb-5fdc4e1f170d" providerId="ADAL" clId="{37FD2FA5-ABDD-464C-8397-1D6DB9F8955D}" dt="2021-11-30T19:05:50.551" v="719"/>
          <ac:spMkLst>
            <pc:docMk/>
            <pc:sldMk cId="3550709966" sldId="261"/>
            <ac:spMk id="6" creationId="{2D9F04A5-8C84-4910-A096-5A5603FA41BA}"/>
          </ac:spMkLst>
        </pc:spChg>
        <pc:spChg chg="mod">
          <ac:chgData name="Perelygina, Ludmila M. (CDC/DDID/NCIRD/DVD)" userId="7d3b25f4-6f80-4483-bceb-5fdc4e1f170d" providerId="ADAL" clId="{37FD2FA5-ABDD-464C-8397-1D6DB9F8955D}" dt="2021-11-30T19:05:50.551" v="719"/>
          <ac:spMkLst>
            <pc:docMk/>
            <pc:sldMk cId="3550709966" sldId="261"/>
            <ac:spMk id="7" creationId="{183B9E7E-79CE-43E6-B415-EA86A7186762}"/>
          </ac:spMkLst>
        </pc:spChg>
        <pc:spChg chg="mod">
          <ac:chgData name="Perelygina, Ludmila M. (CDC/DDID/NCIRD/DVD)" userId="7d3b25f4-6f80-4483-bceb-5fdc4e1f170d" providerId="ADAL" clId="{37FD2FA5-ABDD-464C-8397-1D6DB9F8955D}" dt="2021-11-30T19:05:50.551" v="719"/>
          <ac:spMkLst>
            <pc:docMk/>
            <pc:sldMk cId="3550709966" sldId="261"/>
            <ac:spMk id="8" creationId="{4DFFE500-AD92-46BD-9D64-7C303BF4212F}"/>
          </ac:spMkLst>
        </pc:spChg>
        <pc:spChg chg="mod">
          <ac:chgData name="Perelygina, Ludmila M. (CDC/DDID/NCIRD/DVD)" userId="7d3b25f4-6f80-4483-bceb-5fdc4e1f170d" providerId="ADAL" clId="{37FD2FA5-ABDD-464C-8397-1D6DB9F8955D}" dt="2021-11-30T19:05:50.551" v="719"/>
          <ac:spMkLst>
            <pc:docMk/>
            <pc:sldMk cId="3550709966" sldId="261"/>
            <ac:spMk id="9" creationId="{D04554A2-5A7A-4D28-8FD2-016A750145EC}"/>
          </ac:spMkLst>
        </pc:spChg>
        <pc:spChg chg="mod">
          <ac:chgData name="Perelygina, Ludmila M. (CDC/DDID/NCIRD/DVD)" userId="7d3b25f4-6f80-4483-bceb-5fdc4e1f170d" providerId="ADAL" clId="{37FD2FA5-ABDD-464C-8397-1D6DB9F8955D}" dt="2021-11-30T19:05:50.551" v="719"/>
          <ac:spMkLst>
            <pc:docMk/>
            <pc:sldMk cId="3550709966" sldId="261"/>
            <ac:spMk id="10" creationId="{E19A3E21-3D5E-4317-A0ED-3B9DD28C50F2}"/>
          </ac:spMkLst>
        </pc:spChg>
        <pc:spChg chg="mod">
          <ac:chgData name="Perelygina, Ludmila M. (CDC/DDID/NCIRD/DVD)" userId="7d3b25f4-6f80-4483-bceb-5fdc4e1f170d" providerId="ADAL" clId="{37FD2FA5-ABDD-464C-8397-1D6DB9F8955D}" dt="2021-11-30T19:05:50.551" v="719"/>
          <ac:spMkLst>
            <pc:docMk/>
            <pc:sldMk cId="3550709966" sldId="261"/>
            <ac:spMk id="11" creationId="{60AD6372-F66C-4C6E-AD0A-FEF43290FD76}"/>
          </ac:spMkLst>
        </pc:spChg>
        <pc:spChg chg="mod">
          <ac:chgData name="Perelygina, Ludmila M. (CDC/DDID/NCIRD/DVD)" userId="7d3b25f4-6f80-4483-bceb-5fdc4e1f170d" providerId="ADAL" clId="{37FD2FA5-ABDD-464C-8397-1D6DB9F8955D}" dt="2021-11-30T19:05:50.551" v="719"/>
          <ac:spMkLst>
            <pc:docMk/>
            <pc:sldMk cId="3550709966" sldId="261"/>
            <ac:spMk id="12" creationId="{3F8379C5-C4E0-4636-AFFD-FEA241D3A35B}"/>
          </ac:spMkLst>
        </pc:spChg>
        <pc:spChg chg="mod">
          <ac:chgData name="Perelygina, Ludmila M. (CDC/DDID/NCIRD/DVD)" userId="7d3b25f4-6f80-4483-bceb-5fdc4e1f170d" providerId="ADAL" clId="{37FD2FA5-ABDD-464C-8397-1D6DB9F8955D}" dt="2021-11-30T19:05:50.551" v="719"/>
          <ac:spMkLst>
            <pc:docMk/>
            <pc:sldMk cId="3550709966" sldId="261"/>
            <ac:spMk id="13" creationId="{A6D0448B-A054-4033-BD41-1351D489661C}"/>
          </ac:spMkLst>
        </pc:spChg>
        <pc:spChg chg="add mod">
          <ac:chgData name="Perelygina, Ludmila M. (CDC/DDID/NCIRD/DVD)" userId="7d3b25f4-6f80-4483-bceb-5fdc4e1f170d" providerId="ADAL" clId="{37FD2FA5-ABDD-464C-8397-1D6DB9F8955D}" dt="2021-11-30T19:05:54.141" v="720" actId="1076"/>
          <ac:spMkLst>
            <pc:docMk/>
            <pc:sldMk cId="3550709966" sldId="261"/>
            <ac:spMk id="15" creationId="{5FFCB9D6-3170-4D51-A0BD-1119BBEF4C2D}"/>
          </ac:spMkLst>
        </pc:spChg>
        <pc:spChg chg="add mod">
          <ac:chgData name="Perelygina, Ludmila M. (CDC/DDID/NCIRD/DVD)" userId="7d3b25f4-6f80-4483-bceb-5fdc4e1f170d" providerId="ADAL" clId="{37FD2FA5-ABDD-464C-8397-1D6DB9F8955D}" dt="2021-11-30T19:05:54.141" v="720" actId="1076"/>
          <ac:spMkLst>
            <pc:docMk/>
            <pc:sldMk cId="3550709966" sldId="261"/>
            <ac:spMk id="16" creationId="{D7E15EA4-B31E-43D7-9781-2F7FB6D6759C}"/>
          </ac:spMkLst>
        </pc:spChg>
        <pc:spChg chg="add mod">
          <ac:chgData name="Perelygina, Ludmila M. (CDC/DDID/NCIRD/DVD)" userId="7d3b25f4-6f80-4483-bceb-5fdc4e1f170d" providerId="ADAL" clId="{37FD2FA5-ABDD-464C-8397-1D6DB9F8955D}" dt="2021-11-30T19:05:54.141" v="720" actId="1076"/>
          <ac:spMkLst>
            <pc:docMk/>
            <pc:sldMk cId="3550709966" sldId="261"/>
            <ac:spMk id="17" creationId="{7997FBD0-86DB-4897-BD15-F1A10665EB98}"/>
          </ac:spMkLst>
        </pc:spChg>
        <pc:spChg chg="add mod">
          <ac:chgData name="Perelygina, Ludmila M. (CDC/DDID/NCIRD/DVD)" userId="7d3b25f4-6f80-4483-bceb-5fdc4e1f170d" providerId="ADAL" clId="{37FD2FA5-ABDD-464C-8397-1D6DB9F8955D}" dt="2021-11-30T19:05:54.141" v="720" actId="1076"/>
          <ac:spMkLst>
            <pc:docMk/>
            <pc:sldMk cId="3550709966" sldId="261"/>
            <ac:spMk id="18" creationId="{2182277E-3ECE-4B6C-A3C0-8EC6B0A4724E}"/>
          </ac:spMkLst>
        </pc:spChg>
        <pc:spChg chg="add mod">
          <ac:chgData name="Perelygina, Ludmila M. (CDC/DDID/NCIRD/DVD)" userId="7d3b25f4-6f80-4483-bceb-5fdc4e1f170d" providerId="ADAL" clId="{37FD2FA5-ABDD-464C-8397-1D6DB9F8955D}" dt="2021-11-30T19:05:54.141" v="720" actId="1076"/>
          <ac:spMkLst>
            <pc:docMk/>
            <pc:sldMk cId="3550709966" sldId="261"/>
            <ac:spMk id="19" creationId="{905D009B-C511-4E70-A12B-820F50714E19}"/>
          </ac:spMkLst>
        </pc:spChg>
        <pc:spChg chg="add mod">
          <ac:chgData name="Perelygina, Ludmila M. (CDC/DDID/NCIRD/DVD)" userId="7d3b25f4-6f80-4483-bceb-5fdc4e1f170d" providerId="ADAL" clId="{37FD2FA5-ABDD-464C-8397-1D6DB9F8955D}" dt="2021-11-30T19:05:54.141" v="720" actId="1076"/>
          <ac:spMkLst>
            <pc:docMk/>
            <pc:sldMk cId="3550709966" sldId="261"/>
            <ac:spMk id="20" creationId="{4CD35980-056F-43DE-A032-472979984FE6}"/>
          </ac:spMkLst>
        </pc:spChg>
        <pc:spChg chg="add mod">
          <ac:chgData name="Perelygina, Ludmila M. (CDC/DDID/NCIRD/DVD)" userId="7d3b25f4-6f80-4483-bceb-5fdc4e1f170d" providerId="ADAL" clId="{37FD2FA5-ABDD-464C-8397-1D6DB9F8955D}" dt="2021-11-30T19:05:54.141" v="720" actId="1076"/>
          <ac:spMkLst>
            <pc:docMk/>
            <pc:sldMk cId="3550709966" sldId="261"/>
            <ac:spMk id="21" creationId="{D32B9201-B166-43B8-AEAA-06C66139395E}"/>
          </ac:spMkLst>
        </pc:spChg>
        <pc:spChg chg="add mod">
          <ac:chgData name="Perelygina, Ludmila M. (CDC/DDID/NCIRD/DVD)" userId="7d3b25f4-6f80-4483-bceb-5fdc4e1f170d" providerId="ADAL" clId="{37FD2FA5-ABDD-464C-8397-1D6DB9F8955D}" dt="2021-11-30T19:05:54.141" v="720" actId="1076"/>
          <ac:spMkLst>
            <pc:docMk/>
            <pc:sldMk cId="3550709966" sldId="261"/>
            <ac:spMk id="22" creationId="{AD9CB6FD-CFCA-4FFC-BF3A-71BC04FAC078}"/>
          </ac:spMkLst>
        </pc:spChg>
        <pc:spChg chg="add mod">
          <ac:chgData name="Perelygina, Ludmila M. (CDC/DDID/NCIRD/DVD)" userId="7d3b25f4-6f80-4483-bceb-5fdc4e1f170d" providerId="ADAL" clId="{37FD2FA5-ABDD-464C-8397-1D6DB9F8955D}" dt="2021-11-30T19:05:54.141" v="720" actId="1076"/>
          <ac:spMkLst>
            <pc:docMk/>
            <pc:sldMk cId="3550709966" sldId="261"/>
            <ac:spMk id="23" creationId="{59008EAF-4B95-45A4-8EC5-2B8A35C7D41B}"/>
          </ac:spMkLst>
        </pc:spChg>
        <pc:spChg chg="add mod">
          <ac:chgData name="Perelygina, Ludmila M. (CDC/DDID/NCIRD/DVD)" userId="7d3b25f4-6f80-4483-bceb-5fdc4e1f170d" providerId="ADAL" clId="{37FD2FA5-ABDD-464C-8397-1D6DB9F8955D}" dt="2021-11-30T19:05:54.141" v="720" actId="1076"/>
          <ac:spMkLst>
            <pc:docMk/>
            <pc:sldMk cId="3550709966" sldId="261"/>
            <ac:spMk id="24" creationId="{B9981248-2076-496E-BBF3-EC57D3769281}"/>
          </ac:spMkLst>
        </pc:spChg>
        <pc:grpChg chg="add mod">
          <ac:chgData name="Perelygina, Ludmila M. (CDC/DDID/NCIRD/DVD)" userId="7d3b25f4-6f80-4483-bceb-5fdc4e1f170d" providerId="ADAL" clId="{37FD2FA5-ABDD-464C-8397-1D6DB9F8955D}" dt="2021-11-30T19:05:54.141" v="720" actId="1076"/>
          <ac:grpSpMkLst>
            <pc:docMk/>
            <pc:sldMk cId="3550709966" sldId="261"/>
            <ac:grpSpMk id="3" creationId="{AEC49364-262A-4AB8-95C1-F7FC21688643}"/>
          </ac:grpSpMkLst>
        </pc:grpChg>
        <pc:graphicFrameChg chg="add mod">
          <ac:chgData name="Perelygina, Ludmila M. (CDC/DDID/NCIRD/DVD)" userId="7d3b25f4-6f80-4483-bceb-5fdc4e1f170d" providerId="ADAL" clId="{37FD2FA5-ABDD-464C-8397-1D6DB9F8955D}" dt="2021-11-30T19:05:55.947" v="721" actId="1076"/>
          <ac:graphicFrameMkLst>
            <pc:docMk/>
            <pc:sldMk cId="3550709966" sldId="261"/>
            <ac:graphicFrameMk id="2" creationId="{8B35F599-C0C3-4654-B966-08070FD367D4}"/>
          </ac:graphicFrameMkLst>
        </pc:graphicFrameChg>
        <pc:picChg chg="mod">
          <ac:chgData name="Perelygina, Ludmila M. (CDC/DDID/NCIRD/DVD)" userId="7d3b25f4-6f80-4483-bceb-5fdc4e1f170d" providerId="ADAL" clId="{37FD2FA5-ABDD-464C-8397-1D6DB9F8955D}" dt="2021-11-30T19:05:50.551" v="719"/>
          <ac:picMkLst>
            <pc:docMk/>
            <pc:sldMk cId="3550709966" sldId="261"/>
            <ac:picMk id="14" creationId="{1665938E-F857-4400-ADAC-4978BE755C36}"/>
          </ac:picMkLst>
        </pc:picChg>
        <pc:picChg chg="add mod">
          <ac:chgData name="Perelygina, Ludmila M. (CDC/DDID/NCIRD/DVD)" userId="7d3b25f4-6f80-4483-bceb-5fdc4e1f170d" providerId="ADAL" clId="{37FD2FA5-ABDD-464C-8397-1D6DB9F8955D}" dt="2021-11-30T19:06:14.452" v="724" actId="1076"/>
          <ac:picMkLst>
            <pc:docMk/>
            <pc:sldMk cId="3550709966" sldId="261"/>
            <ac:picMk id="25" creationId="{B453CDAB-CBAB-49E4-8CE8-DAC12388D386}"/>
          </ac:picMkLst>
        </pc:picChg>
      </pc:sldChg>
      <pc:sldChg chg="addSp modSp add del">
        <pc:chgData name="Perelygina, Ludmila M. (CDC/DDID/NCIRD/DVD)" userId="7d3b25f4-6f80-4483-bceb-5fdc4e1f170d" providerId="ADAL" clId="{37FD2FA5-ABDD-464C-8397-1D6DB9F8955D}" dt="2021-12-01T13:28:30.449" v="877" actId="47"/>
        <pc:sldMkLst>
          <pc:docMk/>
          <pc:sldMk cId="2589318346" sldId="262"/>
        </pc:sldMkLst>
        <pc:graphicFrameChg chg="add mod">
          <ac:chgData name="Perelygina, Ludmila M. (CDC/DDID/NCIRD/DVD)" userId="7d3b25f4-6f80-4483-bceb-5fdc4e1f170d" providerId="ADAL" clId="{37FD2FA5-ABDD-464C-8397-1D6DB9F8955D}" dt="2021-12-01T13:27:15.095" v="876"/>
          <ac:graphicFrameMkLst>
            <pc:docMk/>
            <pc:sldMk cId="2589318346" sldId="262"/>
            <ac:graphicFrameMk id="2" creationId="{C501C8D3-2D35-4870-BF07-D960D23E2B03}"/>
          </ac:graphicFrameMkLst>
        </pc:graphicFrameChg>
      </pc:sldChg>
      <pc:sldChg chg="addSp delSp modSp add mod ord">
        <pc:chgData name="Perelygina, Ludmila M. (CDC/DDID/NCIRD/DVD)" userId="7d3b25f4-6f80-4483-bceb-5fdc4e1f170d" providerId="ADAL" clId="{37FD2FA5-ABDD-464C-8397-1D6DB9F8955D}" dt="2021-12-02T20:00:06.513" v="1940" actId="1076"/>
        <pc:sldMkLst>
          <pc:docMk/>
          <pc:sldMk cId="3513049566" sldId="262"/>
        </pc:sldMkLst>
        <pc:spChg chg="add mod">
          <ac:chgData name="Perelygina, Ludmila M. (CDC/DDID/NCIRD/DVD)" userId="7d3b25f4-6f80-4483-bceb-5fdc4e1f170d" providerId="ADAL" clId="{37FD2FA5-ABDD-464C-8397-1D6DB9F8955D}" dt="2021-12-02T20:00:06.513" v="1940" actId="1076"/>
          <ac:spMkLst>
            <pc:docMk/>
            <pc:sldMk cId="3513049566" sldId="262"/>
            <ac:spMk id="3" creationId="{337F8738-E22F-48ED-9EFA-B8F222219FC0}"/>
          </ac:spMkLst>
        </pc:spChg>
        <pc:spChg chg="add mod">
          <ac:chgData name="Perelygina, Ludmila M. (CDC/DDID/NCIRD/DVD)" userId="7d3b25f4-6f80-4483-bceb-5fdc4e1f170d" providerId="ADAL" clId="{37FD2FA5-ABDD-464C-8397-1D6DB9F8955D}" dt="2021-12-02T16:38:01.575" v="1855" actId="1076"/>
          <ac:spMkLst>
            <pc:docMk/>
            <pc:sldMk cId="3513049566" sldId="262"/>
            <ac:spMk id="4" creationId="{43C31911-B422-4C9F-BBA0-0BF79E048D5A}"/>
          </ac:spMkLst>
        </pc:spChg>
        <pc:spChg chg="add mod">
          <ac:chgData name="Perelygina, Ludmila M. (CDC/DDID/NCIRD/DVD)" userId="7d3b25f4-6f80-4483-bceb-5fdc4e1f170d" providerId="ADAL" clId="{37FD2FA5-ABDD-464C-8397-1D6DB9F8955D}" dt="2021-12-02T16:38:01.575" v="1855" actId="1076"/>
          <ac:spMkLst>
            <pc:docMk/>
            <pc:sldMk cId="3513049566" sldId="262"/>
            <ac:spMk id="5" creationId="{A3744FED-CD44-487E-82D7-7DBE76FAB682}"/>
          </ac:spMkLst>
        </pc:spChg>
        <pc:spChg chg="add mod">
          <ac:chgData name="Perelygina, Ludmila M. (CDC/DDID/NCIRD/DVD)" userId="7d3b25f4-6f80-4483-bceb-5fdc4e1f170d" providerId="ADAL" clId="{37FD2FA5-ABDD-464C-8397-1D6DB9F8955D}" dt="2021-12-02T16:38:01.575" v="1855" actId="1076"/>
          <ac:spMkLst>
            <pc:docMk/>
            <pc:sldMk cId="3513049566" sldId="262"/>
            <ac:spMk id="6" creationId="{A6BB0859-2A4E-4EC0-9603-099F6F58FC49}"/>
          </ac:spMkLst>
        </pc:spChg>
        <pc:spChg chg="add mod">
          <ac:chgData name="Perelygina, Ludmila M. (CDC/DDID/NCIRD/DVD)" userId="7d3b25f4-6f80-4483-bceb-5fdc4e1f170d" providerId="ADAL" clId="{37FD2FA5-ABDD-464C-8397-1D6DB9F8955D}" dt="2021-12-02T16:38:01.575" v="1855" actId="1076"/>
          <ac:spMkLst>
            <pc:docMk/>
            <pc:sldMk cId="3513049566" sldId="262"/>
            <ac:spMk id="7" creationId="{218003D1-3D52-452E-BA6A-F372335FF546}"/>
          </ac:spMkLst>
        </pc:spChg>
        <pc:spChg chg="add mod">
          <ac:chgData name="Perelygina, Ludmila M. (CDC/DDID/NCIRD/DVD)" userId="7d3b25f4-6f80-4483-bceb-5fdc4e1f170d" providerId="ADAL" clId="{37FD2FA5-ABDD-464C-8397-1D6DB9F8955D}" dt="2021-12-02T16:38:01.575" v="1855" actId="1076"/>
          <ac:spMkLst>
            <pc:docMk/>
            <pc:sldMk cId="3513049566" sldId="262"/>
            <ac:spMk id="8" creationId="{2F6B0451-EE37-4714-A3A0-9DE45B78D33C}"/>
          </ac:spMkLst>
        </pc:spChg>
        <pc:spChg chg="add del mod">
          <ac:chgData name="Perelygina, Ludmila M. (CDC/DDID/NCIRD/DVD)" userId="7d3b25f4-6f80-4483-bceb-5fdc4e1f170d" providerId="ADAL" clId="{37FD2FA5-ABDD-464C-8397-1D6DB9F8955D}" dt="2021-12-02T16:37:53.079" v="1854" actId="478"/>
          <ac:spMkLst>
            <pc:docMk/>
            <pc:sldMk cId="3513049566" sldId="262"/>
            <ac:spMk id="9" creationId="{D38D229E-8AB5-484E-9211-462180FC0AA6}"/>
          </ac:spMkLst>
        </pc:spChg>
        <pc:graphicFrameChg chg="add mod">
          <ac:chgData name="Perelygina, Ludmila M. (CDC/DDID/NCIRD/DVD)" userId="7d3b25f4-6f80-4483-bceb-5fdc4e1f170d" providerId="ADAL" clId="{37FD2FA5-ABDD-464C-8397-1D6DB9F8955D}" dt="2021-12-02T16:38:01.575" v="1855" actId="1076"/>
          <ac:graphicFrameMkLst>
            <pc:docMk/>
            <pc:sldMk cId="3513049566" sldId="262"/>
            <ac:graphicFrameMk id="2" creationId="{30FE33E8-7D89-4149-B4FC-247E43D7A0A5}"/>
          </ac:graphicFrameMkLst>
        </pc:graphicFrameChg>
      </pc:sldChg>
    </pc:docChg>
  </pc:docChgLst>
  <pc:docChgLst>
    <pc:chgData name="Perelygina, Ludmila M. (CDC/DDID/NCIRD/DVD)" userId="7d3b25f4-6f80-4483-bceb-5fdc4e1f170d" providerId="ADAL" clId="{7BA49553-49B3-4A55-AE48-3280220CC911}"/>
    <pc:docChg chg="custSel addSld modSld">
      <pc:chgData name="Perelygina, Ludmila M. (CDC/DDID/NCIRD/DVD)" userId="7d3b25f4-6f80-4483-bceb-5fdc4e1f170d" providerId="ADAL" clId="{7BA49553-49B3-4A55-AE48-3280220CC911}" dt="2021-11-15T23:14:12.732" v="256" actId="20577"/>
      <pc:docMkLst>
        <pc:docMk/>
      </pc:docMkLst>
      <pc:sldChg chg="addSp delSp modSp new mod">
        <pc:chgData name="Perelygina, Ludmila M. (CDC/DDID/NCIRD/DVD)" userId="7d3b25f4-6f80-4483-bceb-5fdc4e1f170d" providerId="ADAL" clId="{7BA49553-49B3-4A55-AE48-3280220CC911}" dt="2021-11-15T23:14:12.732" v="256" actId="20577"/>
        <pc:sldMkLst>
          <pc:docMk/>
          <pc:sldMk cId="2864907532" sldId="257"/>
        </pc:sldMkLst>
        <pc:spChg chg="add mod">
          <ac:chgData name="Perelygina, Ludmila M. (CDC/DDID/NCIRD/DVD)" userId="7d3b25f4-6f80-4483-bceb-5fdc4e1f170d" providerId="ADAL" clId="{7BA49553-49B3-4A55-AE48-3280220CC911}" dt="2021-11-15T23:14:12.732" v="256" actId="20577"/>
          <ac:spMkLst>
            <pc:docMk/>
            <pc:sldMk cId="2864907532" sldId="257"/>
            <ac:spMk id="2" creationId="{18222F38-2CB7-475A-B786-287CBB3D4981}"/>
          </ac:spMkLst>
        </pc:spChg>
        <pc:spChg chg="add mod">
          <ac:chgData name="Perelygina, Ludmila M. (CDC/DDID/NCIRD/DVD)" userId="7d3b25f4-6f80-4483-bceb-5fdc4e1f170d" providerId="ADAL" clId="{7BA49553-49B3-4A55-AE48-3280220CC911}" dt="2021-11-15T23:01:23.820" v="62" actId="1076"/>
          <ac:spMkLst>
            <pc:docMk/>
            <pc:sldMk cId="2864907532" sldId="257"/>
            <ac:spMk id="12" creationId="{3F7CCACA-39A9-47F2-96B9-A60DDD1B5B81}"/>
          </ac:spMkLst>
        </pc:spChg>
        <pc:spChg chg="add mod">
          <ac:chgData name="Perelygina, Ludmila M. (CDC/DDID/NCIRD/DVD)" userId="7d3b25f4-6f80-4483-bceb-5fdc4e1f170d" providerId="ADAL" clId="{7BA49553-49B3-4A55-AE48-3280220CC911}" dt="2021-11-15T23:02:50.745" v="69" actId="1076"/>
          <ac:spMkLst>
            <pc:docMk/>
            <pc:sldMk cId="2864907532" sldId="257"/>
            <ac:spMk id="13" creationId="{129370F6-C5AC-477F-BC65-8D52A9C7B08F}"/>
          </ac:spMkLst>
        </pc:spChg>
        <pc:spChg chg="add mod">
          <ac:chgData name="Perelygina, Ludmila M. (CDC/DDID/NCIRD/DVD)" userId="7d3b25f4-6f80-4483-bceb-5fdc4e1f170d" providerId="ADAL" clId="{7BA49553-49B3-4A55-AE48-3280220CC911}" dt="2021-11-15T23:03:37.348" v="74" actId="1076"/>
          <ac:spMkLst>
            <pc:docMk/>
            <pc:sldMk cId="2864907532" sldId="257"/>
            <ac:spMk id="14" creationId="{FF9DB941-E3AB-4CD9-BA2F-8271A98CFF7B}"/>
          </ac:spMkLst>
        </pc:spChg>
        <pc:picChg chg="add del mod">
          <ac:chgData name="Perelygina, Ludmila M. (CDC/DDID/NCIRD/DVD)" userId="7d3b25f4-6f80-4483-bceb-5fdc4e1f170d" providerId="ADAL" clId="{7BA49553-49B3-4A55-AE48-3280220CC911}" dt="2021-11-15T20:38:48.095" v="5" actId="478"/>
          <ac:picMkLst>
            <pc:docMk/>
            <pc:sldMk cId="2864907532" sldId="257"/>
            <ac:picMk id="3" creationId="{8240F7F0-F68C-4211-9865-177F526A5435}"/>
          </ac:picMkLst>
        </pc:picChg>
        <pc:picChg chg="add del mod">
          <ac:chgData name="Perelygina, Ludmila M. (CDC/DDID/NCIRD/DVD)" userId="7d3b25f4-6f80-4483-bceb-5fdc4e1f170d" providerId="ADAL" clId="{7BA49553-49B3-4A55-AE48-3280220CC911}" dt="2021-11-15T22:59:38.904" v="39" actId="478"/>
          <ac:picMkLst>
            <pc:docMk/>
            <pc:sldMk cId="2864907532" sldId="257"/>
            <ac:picMk id="5" creationId="{B5D067C4-D03B-4FA4-B5C3-60A7AB1C43B2}"/>
          </ac:picMkLst>
        </pc:picChg>
        <pc:picChg chg="add del mod">
          <ac:chgData name="Perelygina, Ludmila M. (CDC/DDID/NCIRD/DVD)" userId="7d3b25f4-6f80-4483-bceb-5fdc4e1f170d" providerId="ADAL" clId="{7BA49553-49B3-4A55-AE48-3280220CC911}" dt="2021-11-15T22:46:47.161" v="27" actId="478"/>
          <ac:picMkLst>
            <pc:docMk/>
            <pc:sldMk cId="2864907532" sldId="257"/>
            <ac:picMk id="7" creationId="{E740D178-23D5-46F2-8895-D0A571DE79D7}"/>
          </ac:picMkLst>
        </pc:picChg>
        <pc:picChg chg="add mod">
          <ac:chgData name="Perelygina, Ludmila M. (CDC/DDID/NCIRD/DVD)" userId="7d3b25f4-6f80-4483-bceb-5fdc4e1f170d" providerId="ADAL" clId="{7BA49553-49B3-4A55-AE48-3280220CC911}" dt="2021-11-15T22:47:31.207" v="33" actId="14100"/>
          <ac:picMkLst>
            <pc:docMk/>
            <pc:sldMk cId="2864907532" sldId="257"/>
            <ac:picMk id="9" creationId="{4A80953C-6FB1-4020-BEA7-B19D07E9BB7C}"/>
          </ac:picMkLst>
        </pc:picChg>
        <pc:picChg chg="add mod">
          <ac:chgData name="Perelygina, Ludmila M. (CDC/DDID/NCIRD/DVD)" userId="7d3b25f4-6f80-4483-bceb-5fdc4e1f170d" providerId="ADAL" clId="{7BA49553-49B3-4A55-AE48-3280220CC911}" dt="2021-11-15T22:59:43.769" v="40" actId="1076"/>
          <ac:picMkLst>
            <pc:docMk/>
            <pc:sldMk cId="2864907532" sldId="257"/>
            <ac:picMk id="11" creationId="{856ED258-174D-4B2A-94ED-0440F45F2760}"/>
          </ac:picMkLst>
        </pc:picChg>
      </pc:sldChg>
    </pc:docChg>
  </pc:docChgLst>
  <pc:docChgLst>
    <pc:chgData name="Ludmila" userId="7d3b25f4-6f80-4483-bceb-5fdc4e1f170d" providerId="ADAL" clId="{7BA49553-49B3-4A55-AE48-3280220CC911}"/>
    <pc:docChg chg="undo custSel delSld modSld sldOrd">
      <pc:chgData name="Ludmila" userId="7d3b25f4-6f80-4483-bceb-5fdc4e1f170d" providerId="ADAL" clId="{7BA49553-49B3-4A55-AE48-3280220CC911}" dt="2021-12-05T23:20:20.003" v="499" actId="27918"/>
      <pc:docMkLst>
        <pc:docMk/>
      </pc:docMkLst>
      <pc:sldChg chg="modSp mod">
        <pc:chgData name="Ludmila" userId="7d3b25f4-6f80-4483-bceb-5fdc4e1f170d" providerId="ADAL" clId="{7BA49553-49B3-4A55-AE48-3280220CC911}" dt="2021-12-05T20:44:34.271" v="211" actId="1076"/>
        <pc:sldMkLst>
          <pc:docMk/>
          <pc:sldMk cId="1726942282" sldId="256"/>
        </pc:sldMkLst>
        <pc:spChg chg="mod">
          <ac:chgData name="Ludmila" userId="7d3b25f4-6f80-4483-bceb-5fdc4e1f170d" providerId="ADAL" clId="{7BA49553-49B3-4A55-AE48-3280220CC911}" dt="2021-12-05T20:44:34.271" v="211" actId="1076"/>
          <ac:spMkLst>
            <pc:docMk/>
            <pc:sldMk cId="1726942282" sldId="256"/>
            <ac:spMk id="31" creationId="{0FDB5CC8-C87A-401D-BB20-75EED81FE036}"/>
          </ac:spMkLst>
        </pc:spChg>
      </pc:sldChg>
      <pc:sldChg chg="modSp mod ord">
        <pc:chgData name="Ludmila" userId="7d3b25f4-6f80-4483-bceb-5fdc4e1f170d" providerId="ADAL" clId="{7BA49553-49B3-4A55-AE48-3280220CC911}" dt="2021-12-05T21:07:53.862" v="497" actId="20577"/>
        <pc:sldMkLst>
          <pc:docMk/>
          <pc:sldMk cId="2864907532" sldId="257"/>
        </pc:sldMkLst>
        <pc:spChg chg="mod">
          <ac:chgData name="Ludmila" userId="7d3b25f4-6f80-4483-bceb-5fdc4e1f170d" providerId="ADAL" clId="{7BA49553-49B3-4A55-AE48-3280220CC911}" dt="2021-12-05T20:57:41.615" v="386" actId="255"/>
          <ac:spMkLst>
            <pc:docMk/>
            <pc:sldMk cId="2864907532" sldId="257"/>
            <ac:spMk id="6" creationId="{4EEBF3E1-EAF0-4182-8D43-6E90DBAB9C72}"/>
          </ac:spMkLst>
        </pc:spChg>
        <pc:spChg chg="mod">
          <ac:chgData name="Ludmila" userId="7d3b25f4-6f80-4483-bceb-5fdc4e1f170d" providerId="ADAL" clId="{7BA49553-49B3-4A55-AE48-3280220CC911}" dt="2021-12-05T21:07:53.862" v="497" actId="20577"/>
          <ac:spMkLst>
            <pc:docMk/>
            <pc:sldMk cId="2864907532" sldId="257"/>
            <ac:spMk id="7" creationId="{25F8C4D2-91FA-45EE-A853-F7E40B93AE51}"/>
          </ac:spMkLst>
        </pc:spChg>
        <pc:spChg chg="mod">
          <ac:chgData name="Ludmila" userId="7d3b25f4-6f80-4483-bceb-5fdc4e1f170d" providerId="ADAL" clId="{7BA49553-49B3-4A55-AE48-3280220CC911}" dt="2021-12-05T20:57:47.794" v="387" actId="255"/>
          <ac:spMkLst>
            <pc:docMk/>
            <pc:sldMk cId="2864907532" sldId="257"/>
            <ac:spMk id="8" creationId="{E5DA449E-F502-42F6-9A3D-E68B41B66CF4}"/>
          </ac:spMkLst>
        </pc:spChg>
        <pc:spChg chg="mod">
          <ac:chgData name="Ludmila" userId="7d3b25f4-6f80-4483-bceb-5fdc4e1f170d" providerId="ADAL" clId="{7BA49553-49B3-4A55-AE48-3280220CC911}" dt="2021-12-05T20:57:54.344" v="388" actId="255"/>
          <ac:spMkLst>
            <pc:docMk/>
            <pc:sldMk cId="2864907532" sldId="257"/>
            <ac:spMk id="9" creationId="{DA5AA404-9DD0-4DBC-AE09-C74D01F3050A}"/>
          </ac:spMkLst>
        </pc:spChg>
        <pc:graphicFrameChg chg="mod modGraphic">
          <ac:chgData name="Ludmila" userId="7d3b25f4-6f80-4483-bceb-5fdc4e1f170d" providerId="ADAL" clId="{7BA49553-49B3-4A55-AE48-3280220CC911}" dt="2021-12-05T21:02:11.072" v="470" actId="20577"/>
          <ac:graphicFrameMkLst>
            <pc:docMk/>
            <pc:sldMk cId="2864907532" sldId="257"/>
            <ac:graphicFrameMk id="3" creationId="{618FF06B-4D82-408A-B002-DEED8867C78D}"/>
          </ac:graphicFrameMkLst>
        </pc:graphicFrameChg>
      </pc:sldChg>
      <pc:sldChg chg="addSp delSp modSp mod">
        <pc:chgData name="Ludmila" userId="7d3b25f4-6f80-4483-bceb-5fdc4e1f170d" providerId="ADAL" clId="{7BA49553-49B3-4A55-AE48-3280220CC911}" dt="2021-12-05T23:20:20.003" v="499" actId="27918"/>
        <pc:sldMkLst>
          <pc:docMk/>
          <pc:sldMk cId="1664974692" sldId="258"/>
        </pc:sldMkLst>
        <pc:spChg chg="add mod">
          <ac:chgData name="Ludmila" userId="7d3b25f4-6f80-4483-bceb-5fdc4e1f170d" providerId="ADAL" clId="{7BA49553-49B3-4A55-AE48-3280220CC911}" dt="2021-12-05T20:29:59.492" v="97" actId="164"/>
          <ac:spMkLst>
            <pc:docMk/>
            <pc:sldMk cId="1664974692" sldId="258"/>
            <ac:spMk id="2" creationId="{EE9A5737-B3E6-47B9-8889-B1C6A58C5930}"/>
          </ac:spMkLst>
        </pc:spChg>
        <pc:spChg chg="mod ord">
          <ac:chgData name="Ludmila" userId="7d3b25f4-6f80-4483-bceb-5fdc4e1f170d" providerId="ADAL" clId="{7BA49553-49B3-4A55-AE48-3280220CC911}" dt="2021-12-05T20:38:35.650" v="136" actId="1076"/>
          <ac:spMkLst>
            <pc:docMk/>
            <pc:sldMk cId="1664974692" sldId="258"/>
            <ac:spMk id="4" creationId="{0D97A794-93DF-4132-A57A-9F177761E2E0}"/>
          </ac:spMkLst>
        </pc:spChg>
        <pc:spChg chg="mod">
          <ac:chgData name="Ludmila" userId="7d3b25f4-6f80-4483-bceb-5fdc4e1f170d" providerId="ADAL" clId="{7BA49553-49B3-4A55-AE48-3280220CC911}" dt="2021-12-05T20:38:40.880" v="137" actId="1076"/>
          <ac:spMkLst>
            <pc:docMk/>
            <pc:sldMk cId="1664974692" sldId="258"/>
            <ac:spMk id="10" creationId="{53FCA661-7CF5-4EA8-8086-7B4F74AE6B0E}"/>
          </ac:spMkLst>
        </pc:spChg>
        <pc:spChg chg="mod">
          <ac:chgData name="Ludmila" userId="7d3b25f4-6f80-4483-bceb-5fdc4e1f170d" providerId="ADAL" clId="{7BA49553-49B3-4A55-AE48-3280220CC911}" dt="2021-12-03T23:30:47.884" v="14" actId="14100"/>
          <ac:spMkLst>
            <pc:docMk/>
            <pc:sldMk cId="1664974692" sldId="258"/>
            <ac:spMk id="15" creationId="{1179887A-73E5-4A7D-A6B1-332F43AA631E}"/>
          </ac:spMkLst>
        </pc:spChg>
        <pc:spChg chg="mod">
          <ac:chgData name="Ludmila" userId="7d3b25f4-6f80-4483-bceb-5fdc4e1f170d" providerId="ADAL" clId="{7BA49553-49B3-4A55-AE48-3280220CC911}" dt="2021-12-05T20:56:57.447" v="382" actId="20577"/>
          <ac:spMkLst>
            <pc:docMk/>
            <pc:sldMk cId="1664974692" sldId="258"/>
            <ac:spMk id="16" creationId="{D7AC37FD-2D02-4B02-BF1A-879A215C3E1B}"/>
          </ac:spMkLst>
        </pc:spChg>
        <pc:spChg chg="add mod">
          <ac:chgData name="Ludmila" userId="7d3b25f4-6f80-4483-bceb-5fdc4e1f170d" providerId="ADAL" clId="{7BA49553-49B3-4A55-AE48-3280220CC911}" dt="2021-12-05T20:29:59.492" v="97" actId="164"/>
          <ac:spMkLst>
            <pc:docMk/>
            <pc:sldMk cId="1664974692" sldId="258"/>
            <ac:spMk id="18" creationId="{A49E3989-E18D-4A08-A893-615EE9685BD0}"/>
          </ac:spMkLst>
        </pc:spChg>
        <pc:spChg chg="add del">
          <ac:chgData name="Ludmila" userId="7d3b25f4-6f80-4483-bceb-5fdc4e1f170d" providerId="ADAL" clId="{7BA49553-49B3-4A55-AE48-3280220CC911}" dt="2021-12-05T20:27:45.296" v="61" actId="478"/>
          <ac:spMkLst>
            <pc:docMk/>
            <pc:sldMk cId="1664974692" sldId="258"/>
            <ac:spMk id="19" creationId="{4EC4009D-F602-4332-9D72-4B0EF837A509}"/>
          </ac:spMkLst>
        </pc:spChg>
        <pc:spChg chg="add del">
          <ac:chgData name="Ludmila" userId="7d3b25f4-6f80-4483-bceb-5fdc4e1f170d" providerId="ADAL" clId="{7BA49553-49B3-4A55-AE48-3280220CC911}" dt="2021-12-05T20:36:19.081" v="118" actId="22"/>
          <ac:spMkLst>
            <pc:docMk/>
            <pc:sldMk cId="1664974692" sldId="258"/>
            <ac:spMk id="26" creationId="{F4F982CA-6DDE-4AE0-A981-F431C1BF957F}"/>
          </ac:spMkLst>
        </pc:spChg>
        <pc:spChg chg="add mod">
          <ac:chgData name="Ludmila" userId="7d3b25f4-6f80-4483-bceb-5fdc4e1f170d" providerId="ADAL" clId="{7BA49553-49B3-4A55-AE48-3280220CC911}" dt="2021-12-05T20:39:23.665" v="144" actId="1076"/>
          <ac:spMkLst>
            <pc:docMk/>
            <pc:sldMk cId="1664974692" sldId="258"/>
            <ac:spMk id="29" creationId="{3D2D728A-FC60-450A-AEF9-9E500AF5D238}"/>
          </ac:spMkLst>
        </pc:spChg>
        <pc:spChg chg="add mod">
          <ac:chgData name="Ludmila" userId="7d3b25f4-6f80-4483-bceb-5fdc4e1f170d" providerId="ADAL" clId="{7BA49553-49B3-4A55-AE48-3280220CC911}" dt="2021-12-05T20:41:03.846" v="166" actId="1076"/>
          <ac:spMkLst>
            <pc:docMk/>
            <pc:sldMk cId="1664974692" sldId="258"/>
            <ac:spMk id="30" creationId="{F7210DD3-2D86-47FE-A22F-70ACEAE51D2A}"/>
          </ac:spMkLst>
        </pc:spChg>
        <pc:spChg chg="add del mod">
          <ac:chgData name="Ludmila" userId="7d3b25f4-6f80-4483-bceb-5fdc4e1f170d" providerId="ADAL" clId="{7BA49553-49B3-4A55-AE48-3280220CC911}" dt="2021-12-05T20:40:08.228" v="155" actId="478"/>
          <ac:spMkLst>
            <pc:docMk/>
            <pc:sldMk cId="1664974692" sldId="258"/>
            <ac:spMk id="31" creationId="{FE454433-1A5D-4F4F-B83F-C8E0CD907694}"/>
          </ac:spMkLst>
        </pc:spChg>
        <pc:spChg chg="add mod">
          <ac:chgData name="Ludmila" userId="7d3b25f4-6f80-4483-bceb-5fdc4e1f170d" providerId="ADAL" clId="{7BA49553-49B3-4A55-AE48-3280220CC911}" dt="2021-12-05T20:40:59.227" v="165" actId="1076"/>
          <ac:spMkLst>
            <pc:docMk/>
            <pc:sldMk cId="1664974692" sldId="258"/>
            <ac:spMk id="32" creationId="{8E94FC1B-4F01-4D77-B3C8-38682C1B1F37}"/>
          </ac:spMkLst>
        </pc:spChg>
        <pc:spChg chg="add mod">
          <ac:chgData name="Ludmila" userId="7d3b25f4-6f80-4483-bceb-5fdc4e1f170d" providerId="ADAL" clId="{7BA49553-49B3-4A55-AE48-3280220CC911}" dt="2021-12-05T20:42:41.620" v="185" actId="1076"/>
          <ac:spMkLst>
            <pc:docMk/>
            <pc:sldMk cId="1664974692" sldId="258"/>
            <ac:spMk id="33" creationId="{7EE23045-7D33-490D-9227-BD224C2CB564}"/>
          </ac:spMkLst>
        </pc:spChg>
        <pc:spChg chg="add mod">
          <ac:chgData name="Ludmila" userId="7d3b25f4-6f80-4483-bceb-5fdc4e1f170d" providerId="ADAL" clId="{7BA49553-49B3-4A55-AE48-3280220CC911}" dt="2021-12-05T20:42:50.081" v="187" actId="1076"/>
          <ac:spMkLst>
            <pc:docMk/>
            <pc:sldMk cId="1664974692" sldId="258"/>
            <ac:spMk id="34" creationId="{8D3EA077-3C5D-48B8-BCB8-7CEE539FBF8F}"/>
          </ac:spMkLst>
        </pc:spChg>
        <pc:spChg chg="add mod">
          <ac:chgData name="Ludmila" userId="7d3b25f4-6f80-4483-bceb-5fdc4e1f170d" providerId="ADAL" clId="{7BA49553-49B3-4A55-AE48-3280220CC911}" dt="2021-12-05T20:42:57.253" v="189" actId="1076"/>
          <ac:spMkLst>
            <pc:docMk/>
            <pc:sldMk cId="1664974692" sldId="258"/>
            <ac:spMk id="35" creationId="{95300F00-EEF5-45DD-A5A3-B6E56578259C}"/>
          </ac:spMkLst>
        </pc:spChg>
        <pc:spChg chg="add mod">
          <ac:chgData name="Ludmila" userId="7d3b25f4-6f80-4483-bceb-5fdc4e1f170d" providerId="ADAL" clId="{7BA49553-49B3-4A55-AE48-3280220CC911}" dt="2021-12-05T20:43:05.604" v="192" actId="1076"/>
          <ac:spMkLst>
            <pc:docMk/>
            <pc:sldMk cId="1664974692" sldId="258"/>
            <ac:spMk id="36" creationId="{32A03A23-0E38-4FC8-9A2B-51F66E9F3AB8}"/>
          </ac:spMkLst>
        </pc:spChg>
        <pc:grpChg chg="mod">
          <ac:chgData name="Ludmila" userId="7d3b25f4-6f80-4483-bceb-5fdc4e1f170d" providerId="ADAL" clId="{7BA49553-49B3-4A55-AE48-3280220CC911}" dt="2021-12-05T20:38:10.217" v="132" actId="1076"/>
          <ac:grpSpMkLst>
            <pc:docMk/>
            <pc:sldMk cId="1664974692" sldId="258"/>
            <ac:grpSpMk id="13" creationId="{E22169B2-A3F4-40EB-83D4-6FCC1039A0A1}"/>
          </ac:grpSpMkLst>
        </pc:grpChg>
        <pc:grpChg chg="mod">
          <ac:chgData name="Ludmila" userId="7d3b25f4-6f80-4483-bceb-5fdc4e1f170d" providerId="ADAL" clId="{7BA49553-49B3-4A55-AE48-3280220CC911}" dt="2021-12-03T23:29:37.997" v="3" actId="14100"/>
          <ac:grpSpMkLst>
            <pc:docMk/>
            <pc:sldMk cId="1664974692" sldId="258"/>
            <ac:grpSpMk id="14" creationId="{CD0A6AC8-32FA-4510-B3C8-2AAA273D4754}"/>
          </ac:grpSpMkLst>
        </pc:grpChg>
        <pc:grpChg chg="add mod">
          <ac:chgData name="Ludmila" userId="7d3b25f4-6f80-4483-bceb-5fdc4e1f170d" providerId="ADAL" clId="{7BA49553-49B3-4A55-AE48-3280220CC911}" dt="2021-12-05T20:41:22.186" v="172" actId="1037"/>
          <ac:grpSpMkLst>
            <pc:docMk/>
            <pc:sldMk cId="1664974692" sldId="258"/>
            <ac:grpSpMk id="23" creationId="{68B25D1D-9189-4507-AF5C-7F2B42FDD9B7}"/>
          </ac:grpSpMkLst>
        </pc:grpChg>
        <pc:graphicFrameChg chg="add mod">
          <ac:chgData name="Ludmila" userId="7d3b25f4-6f80-4483-bceb-5fdc4e1f170d" providerId="ADAL" clId="{7BA49553-49B3-4A55-AE48-3280220CC911}" dt="2021-12-05T20:29:59.492" v="97" actId="164"/>
          <ac:graphicFrameMkLst>
            <pc:docMk/>
            <pc:sldMk cId="1664974692" sldId="258"/>
            <ac:graphicFrameMk id="17" creationId="{B6BFFCD5-B4DA-402E-BFA2-0927937055F1}"/>
          </ac:graphicFrameMkLst>
        </pc:graphicFrameChg>
        <pc:graphicFrameChg chg="add del mod">
          <ac:chgData name="Ludmila" userId="7d3b25f4-6f80-4483-bceb-5fdc4e1f170d" providerId="ADAL" clId="{7BA49553-49B3-4A55-AE48-3280220CC911}" dt="2021-12-05T20:36:17.171" v="115"/>
          <ac:graphicFrameMkLst>
            <pc:docMk/>
            <pc:sldMk cId="1664974692" sldId="258"/>
            <ac:graphicFrameMk id="24" creationId="{84936169-2F50-4C0D-B63A-771C94A689FF}"/>
          </ac:graphicFrameMkLst>
        </pc:graphicFrameChg>
        <pc:graphicFrameChg chg="add del mod">
          <ac:chgData name="Ludmila" userId="7d3b25f4-6f80-4483-bceb-5fdc4e1f170d" providerId="ADAL" clId="{7BA49553-49B3-4A55-AE48-3280220CC911}" dt="2021-12-05T20:36:25.390" v="122"/>
          <ac:graphicFrameMkLst>
            <pc:docMk/>
            <pc:sldMk cId="1664974692" sldId="258"/>
            <ac:graphicFrameMk id="27" creationId="{D69E7533-4172-4770-8BDA-06C38544BD03}"/>
          </ac:graphicFrameMkLst>
        </pc:graphicFrameChg>
        <pc:graphicFrameChg chg="add mod">
          <ac:chgData name="Ludmila" userId="7d3b25f4-6f80-4483-bceb-5fdc4e1f170d" providerId="ADAL" clId="{7BA49553-49B3-4A55-AE48-3280220CC911}" dt="2021-12-05T20:58:15.715" v="390"/>
          <ac:graphicFrameMkLst>
            <pc:docMk/>
            <pc:sldMk cId="1664974692" sldId="258"/>
            <ac:graphicFrameMk id="28" creationId="{E9533548-8D9D-400A-A97A-06E3097E32CD}"/>
          </ac:graphicFrameMkLst>
        </pc:graphicFrameChg>
        <pc:cxnChg chg="add mod">
          <ac:chgData name="Ludmila" userId="7d3b25f4-6f80-4483-bceb-5fdc4e1f170d" providerId="ADAL" clId="{7BA49553-49B3-4A55-AE48-3280220CC911}" dt="2021-12-05T20:29:59.492" v="97" actId="164"/>
          <ac:cxnSpMkLst>
            <pc:docMk/>
            <pc:sldMk cId="1664974692" sldId="258"/>
            <ac:cxnSpMk id="21" creationId="{951EFD1B-9388-46FE-A5AF-E4306378FCA6}"/>
          </ac:cxnSpMkLst>
        </pc:cxnChg>
        <pc:cxnChg chg="add mod">
          <ac:chgData name="Ludmila" userId="7d3b25f4-6f80-4483-bceb-5fdc4e1f170d" providerId="ADAL" clId="{7BA49553-49B3-4A55-AE48-3280220CC911}" dt="2021-12-05T20:29:59.492" v="97" actId="164"/>
          <ac:cxnSpMkLst>
            <pc:docMk/>
            <pc:sldMk cId="1664974692" sldId="258"/>
            <ac:cxnSpMk id="22" creationId="{4D713FD3-24B6-4BB1-A284-C4DDC5FDE57D}"/>
          </ac:cxnSpMkLst>
        </pc:cxnChg>
      </pc:sldChg>
      <pc:sldChg chg="del">
        <pc:chgData name="Ludmila" userId="7d3b25f4-6f80-4483-bceb-5fdc4e1f170d" providerId="ADAL" clId="{7BA49553-49B3-4A55-AE48-3280220CC911}" dt="2021-12-05T20:57:06.430" v="383" actId="47"/>
        <pc:sldMkLst>
          <pc:docMk/>
          <pc:sldMk cId="3550709966" sldId="261"/>
        </pc:sldMkLst>
      </pc:sldChg>
      <pc:sldChg chg="modSp mod">
        <pc:chgData name="Ludmila" userId="7d3b25f4-6f80-4483-bceb-5fdc4e1f170d" providerId="ADAL" clId="{7BA49553-49B3-4A55-AE48-3280220CC911}" dt="2021-12-05T20:57:22.532" v="384" actId="1076"/>
        <pc:sldMkLst>
          <pc:docMk/>
          <pc:sldMk cId="3513049566" sldId="262"/>
        </pc:sldMkLst>
        <pc:spChg chg="mod">
          <ac:chgData name="Ludmila" userId="7d3b25f4-6f80-4483-bceb-5fdc4e1f170d" providerId="ADAL" clId="{7BA49553-49B3-4A55-AE48-3280220CC911}" dt="2021-12-05T20:45:42.428" v="215" actId="20577"/>
          <ac:spMkLst>
            <pc:docMk/>
            <pc:sldMk cId="3513049566" sldId="262"/>
            <ac:spMk id="3" creationId="{337F8738-E22F-48ED-9EFA-B8F222219FC0}"/>
          </ac:spMkLst>
        </pc:spChg>
        <pc:spChg chg="mod">
          <ac:chgData name="Ludmila" userId="7d3b25f4-6f80-4483-bceb-5fdc4e1f170d" providerId="ADAL" clId="{7BA49553-49B3-4A55-AE48-3280220CC911}" dt="2021-12-05T20:39:01.922" v="141" actId="113"/>
          <ac:spMkLst>
            <pc:docMk/>
            <pc:sldMk cId="3513049566" sldId="262"/>
            <ac:spMk id="5" creationId="{A3744FED-CD44-487E-82D7-7DBE76FAB682}"/>
          </ac:spMkLst>
        </pc:spChg>
        <pc:spChg chg="mod">
          <ac:chgData name="Ludmila" userId="7d3b25f4-6f80-4483-bceb-5fdc4e1f170d" providerId="ADAL" clId="{7BA49553-49B3-4A55-AE48-3280220CC911}" dt="2021-12-05T20:39:01.922" v="141" actId="113"/>
          <ac:spMkLst>
            <pc:docMk/>
            <pc:sldMk cId="3513049566" sldId="262"/>
            <ac:spMk id="6" creationId="{A6BB0859-2A4E-4EC0-9603-099F6F58FC49}"/>
          </ac:spMkLst>
        </pc:spChg>
        <pc:spChg chg="mod">
          <ac:chgData name="Ludmila" userId="7d3b25f4-6f80-4483-bceb-5fdc4e1f170d" providerId="ADAL" clId="{7BA49553-49B3-4A55-AE48-3280220CC911}" dt="2021-12-05T20:57:22.532" v="384" actId="1076"/>
          <ac:spMkLst>
            <pc:docMk/>
            <pc:sldMk cId="3513049566" sldId="262"/>
            <ac:spMk id="7" creationId="{218003D1-3D52-452E-BA6A-F372335FF546}"/>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cdc-my.sharepoint.com/personal/ifw0_cdc_gov/Documents/+My_Documents/My%20Publications/Manuscripts/Manuscripts%20in%20working/2021%20msNTZ%20iVDRV%20CA%20RI/Diversiy%20calculation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8158053583863318"/>
          <c:y val="9.6963879951650386E-2"/>
          <c:w val="0.65614063869454309"/>
          <c:h val="0.75397090825561353"/>
        </c:manualLayout>
      </c:layout>
      <c:barChart>
        <c:barDir val="col"/>
        <c:grouping val="clustered"/>
        <c:varyColors val="0"/>
        <c:ser>
          <c:idx val="0"/>
          <c:order val="0"/>
          <c:tx>
            <c:strRef>
              <c:f>'Figfor ms'!$C$3</c:f>
              <c:strCache>
                <c:ptCount val="1"/>
              </c:strCache>
            </c:strRef>
          </c:tx>
          <c:spPr>
            <a:solidFill>
              <a:schemeClr val="accent1"/>
            </a:solidFill>
            <a:ln>
              <a:noFill/>
            </a:ln>
            <a:effectLst/>
          </c:spPr>
          <c:invertIfNegative val="0"/>
          <c:cat>
            <c:strRef>
              <c:f>'Figfor ms'!$B$4:$B$8</c:f>
              <c:strCache>
                <c:ptCount val="5"/>
                <c:pt idx="0">
                  <c:v>T0</c:v>
                </c:pt>
                <c:pt idx="1">
                  <c:v>T1</c:v>
                </c:pt>
                <c:pt idx="2">
                  <c:v>T0</c:v>
                </c:pt>
                <c:pt idx="3">
                  <c:v>T1</c:v>
                </c:pt>
                <c:pt idx="4">
                  <c:v>T2</c:v>
                </c:pt>
              </c:strCache>
            </c:strRef>
          </c:cat>
          <c:val>
            <c:numRef>
              <c:f>'Figfor ms'!$C$4:$C$8</c:f>
              <c:numCache>
                <c:formatCode>General</c:formatCode>
                <c:ptCount val="5"/>
                <c:pt idx="0">
                  <c:v>55</c:v>
                </c:pt>
                <c:pt idx="1">
                  <c:v>60</c:v>
                </c:pt>
                <c:pt idx="2">
                  <c:v>90</c:v>
                </c:pt>
                <c:pt idx="3">
                  <c:v>55</c:v>
                </c:pt>
                <c:pt idx="4">
                  <c:v>10</c:v>
                </c:pt>
              </c:numCache>
            </c:numRef>
          </c:val>
          <c:extLst>
            <c:ext xmlns:c16="http://schemas.microsoft.com/office/drawing/2014/chart" uri="{C3380CC4-5D6E-409C-BE32-E72D297353CC}">
              <c16:uniqueId val="{00000000-FD91-474A-BBA6-571A60451BEA}"/>
            </c:ext>
          </c:extLst>
        </c:ser>
        <c:dLbls>
          <c:showLegendKey val="0"/>
          <c:showVal val="0"/>
          <c:showCatName val="0"/>
          <c:showSerName val="0"/>
          <c:showPercent val="0"/>
          <c:showBubbleSize val="0"/>
        </c:dLbls>
        <c:gapWidth val="219"/>
        <c:overlap val="-27"/>
        <c:axId val="710611616"/>
        <c:axId val="710614112"/>
      </c:barChart>
      <c:catAx>
        <c:axId val="71061161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710614112"/>
        <c:crosses val="autoZero"/>
        <c:auto val="1"/>
        <c:lblAlgn val="ctr"/>
        <c:lblOffset val="100"/>
        <c:noMultiLvlLbl val="0"/>
      </c:catAx>
      <c:valAx>
        <c:axId val="710614112"/>
        <c:scaling>
          <c:orientation val="minMax"/>
          <c:max val="100"/>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r>
                  <a:rPr lang="en-US" sz="900" b="1" dirty="0">
                    <a:latin typeface="Arial" panose="020B0604020202020204" pitchFamily="34" charset="0"/>
                    <a:cs typeface="Arial" panose="020B0604020202020204" pitchFamily="34" charset="0"/>
                  </a:rPr>
                  <a:t>% identical clones</a:t>
                </a:r>
              </a:p>
            </c:rich>
          </c:tx>
          <c:layout>
            <c:manualLayout>
              <c:xMode val="edge"/>
              <c:yMode val="edge"/>
              <c:x val="4.3368735221560449E-2"/>
              <c:y val="0.10600923334103006"/>
            </c:manualLayout>
          </c:layout>
          <c:overlay val="0"/>
          <c:spPr>
            <a:noFill/>
            <a:ln>
              <a:noFill/>
            </a:ln>
            <a:effectLst/>
          </c:spPr>
          <c:txPr>
            <a:bodyPr rot="-54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710611616"/>
        <c:crosses val="autoZero"/>
        <c:crossBetween val="between"/>
        <c:majorUnit val="20"/>
        <c:minorUnit val="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3BA9E49-63F2-4C31-B0A8-340EB038DC86}"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5010779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BA9E49-63F2-4C31-B0A8-340EB038DC86}"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9391269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BA9E49-63F2-4C31-B0A8-340EB038DC86}"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34051517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BA9E49-63F2-4C31-B0A8-340EB038DC86}"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23889883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3BA9E49-63F2-4C31-B0A8-340EB038DC86}" type="datetimeFigureOut">
              <a:rPr lang="en-US" smtClean="0"/>
              <a:t>3/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7281198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BA9E49-63F2-4C31-B0A8-340EB038DC86}"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38019347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BA9E49-63F2-4C31-B0A8-340EB038DC86}" type="datetimeFigureOut">
              <a:rPr lang="en-US" smtClean="0"/>
              <a:t>3/1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0343481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BA9E49-63F2-4C31-B0A8-340EB038DC86}" type="datetimeFigureOut">
              <a:rPr lang="en-US" smtClean="0"/>
              <a:t>3/1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6757037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BA9E49-63F2-4C31-B0A8-340EB038DC86}" type="datetimeFigureOut">
              <a:rPr lang="en-US" smtClean="0"/>
              <a:t>3/1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5161331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3BA9E49-63F2-4C31-B0A8-340EB038DC86}"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2661518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3BA9E49-63F2-4C31-B0A8-340EB038DC86}" type="datetimeFigureOut">
              <a:rPr lang="en-US" smtClean="0"/>
              <a:t>3/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AC5E39-C056-499C-B9B3-017ADB8110FB}" type="slidenum">
              <a:rPr lang="en-US" smtClean="0"/>
              <a:t>‹#›</a:t>
            </a:fld>
            <a:endParaRPr lang="en-US"/>
          </a:p>
        </p:txBody>
      </p:sp>
    </p:spTree>
    <p:extLst>
      <p:ext uri="{BB962C8B-B14F-4D97-AF65-F5344CB8AC3E}">
        <p14:creationId xmlns:p14="http://schemas.microsoft.com/office/powerpoint/2010/main" val="1120480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3BA9E49-63F2-4C31-B0A8-340EB038DC86}" type="datetimeFigureOut">
              <a:rPr lang="en-US" smtClean="0"/>
              <a:t>3/11/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6AC5E39-C056-499C-B9B3-017ADB8110FB}" type="slidenum">
              <a:rPr lang="en-US" smtClean="0"/>
              <a:t>‹#›</a:t>
            </a:fld>
            <a:endParaRPr lang="en-US"/>
          </a:p>
        </p:txBody>
      </p:sp>
    </p:spTree>
    <p:extLst>
      <p:ext uri="{BB962C8B-B14F-4D97-AF65-F5344CB8AC3E}">
        <p14:creationId xmlns:p14="http://schemas.microsoft.com/office/powerpoint/2010/main" val="256074090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tif"/><Relationship Id="rId7" Type="http://schemas.openxmlformats.org/officeDocument/2006/relationships/image" Target="../media/image5.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package" Target="../embeddings/Microsoft_Excel_Worksheet.xlsx"/><Relationship Id="rId5" Type="http://schemas.openxmlformats.org/officeDocument/2006/relationships/chart" Target="../charts/chart1.xml"/><Relationship Id="rId4" Type="http://schemas.openxmlformats.org/officeDocument/2006/relationships/image" Target="../media/image7.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1277C819-E894-41B9-AADA-172A3435EE1F}"/>
              </a:ext>
            </a:extLst>
          </p:cNvPr>
          <p:cNvGrpSpPr/>
          <p:nvPr/>
        </p:nvGrpSpPr>
        <p:grpSpPr>
          <a:xfrm>
            <a:off x="602779" y="2127743"/>
            <a:ext cx="5992078" cy="1926162"/>
            <a:chOff x="432961" y="1775046"/>
            <a:chExt cx="5992078" cy="1926162"/>
          </a:xfrm>
        </p:grpSpPr>
        <p:graphicFrame>
          <p:nvGraphicFramePr>
            <p:cNvPr id="30" name="Object 29">
              <a:extLst>
                <a:ext uri="{FF2B5EF4-FFF2-40B4-BE49-F238E27FC236}">
                  <a16:creationId xmlns:a16="http://schemas.microsoft.com/office/drawing/2014/main" id="{A8FD380A-76C5-4314-BE01-581E5F08BAA9}"/>
                </a:ext>
              </a:extLst>
            </p:cNvPr>
            <p:cNvGraphicFramePr>
              <a:graphicFrameLocks noChangeAspect="1"/>
            </p:cNvGraphicFramePr>
            <p:nvPr>
              <p:extLst>
                <p:ext uri="{D42A27DB-BD31-4B8C-83A1-F6EECF244321}">
                  <p14:modId xmlns:p14="http://schemas.microsoft.com/office/powerpoint/2010/main" val="3685885719"/>
                </p:ext>
              </p:extLst>
            </p:nvPr>
          </p:nvGraphicFramePr>
          <p:xfrm>
            <a:off x="432961" y="1822532"/>
            <a:ext cx="5822950" cy="1811337"/>
          </p:xfrm>
          <a:graphic>
            <a:graphicData uri="http://schemas.openxmlformats.org/presentationml/2006/ole">
              <mc:AlternateContent xmlns:mc="http://schemas.openxmlformats.org/markup-compatibility/2006">
                <mc:Choice xmlns:v="urn:schemas-microsoft-com:vml" Requires="v">
                  <p:oleObj spid="_x0000_s1027" name="Prism 8" r:id="rId3" imgW="5822314" imgH="1811215" progId="Prism8.Document">
                    <p:embed/>
                  </p:oleObj>
                </mc:Choice>
                <mc:Fallback>
                  <p:oleObj name="Prism 8" r:id="rId3" imgW="5822314" imgH="1811215" progId="Prism8.Document">
                    <p:embed/>
                    <p:pic>
                      <p:nvPicPr>
                        <p:cNvPr id="30" name="Object 29">
                          <a:extLst>
                            <a:ext uri="{FF2B5EF4-FFF2-40B4-BE49-F238E27FC236}">
                              <a16:creationId xmlns:a16="http://schemas.microsoft.com/office/drawing/2014/main" id="{A8FD380A-76C5-4314-BE01-581E5F08BAA9}"/>
                            </a:ext>
                          </a:extLst>
                        </p:cNvPr>
                        <p:cNvPicPr/>
                        <p:nvPr/>
                      </p:nvPicPr>
                      <p:blipFill>
                        <a:blip r:embed="rId4"/>
                        <a:stretch>
                          <a:fillRect/>
                        </a:stretch>
                      </p:blipFill>
                      <p:spPr>
                        <a:xfrm>
                          <a:off x="432961" y="1822532"/>
                          <a:ext cx="5822950" cy="1811337"/>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28E9742F-967C-495B-98AE-B13CDB4433BD}"/>
                </a:ext>
              </a:extLst>
            </p:cNvPr>
            <p:cNvSpPr txBox="1"/>
            <p:nvPr/>
          </p:nvSpPr>
          <p:spPr>
            <a:xfrm>
              <a:off x="3473914" y="3385295"/>
              <a:ext cx="486780" cy="315913"/>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Feb 2017</a:t>
              </a:r>
            </a:p>
          </p:txBody>
        </p:sp>
        <p:sp>
          <p:nvSpPr>
            <p:cNvPr id="23" name="TextBox 22">
              <a:extLst>
                <a:ext uri="{FF2B5EF4-FFF2-40B4-BE49-F238E27FC236}">
                  <a16:creationId xmlns:a16="http://schemas.microsoft.com/office/drawing/2014/main" id="{A95AC4B7-55A3-4252-9537-9CAF6E68D90D}"/>
                </a:ext>
              </a:extLst>
            </p:cNvPr>
            <p:cNvSpPr txBox="1"/>
            <p:nvPr/>
          </p:nvSpPr>
          <p:spPr>
            <a:xfrm>
              <a:off x="5856453" y="3385295"/>
              <a:ext cx="486781" cy="315913"/>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Feb 2018</a:t>
              </a:r>
            </a:p>
          </p:txBody>
        </p:sp>
        <p:sp>
          <p:nvSpPr>
            <p:cNvPr id="24" name="TextBox 23">
              <a:extLst>
                <a:ext uri="{FF2B5EF4-FFF2-40B4-BE49-F238E27FC236}">
                  <a16:creationId xmlns:a16="http://schemas.microsoft.com/office/drawing/2014/main" id="{2B31BB06-72FE-4ABA-BF93-4E8CF8DA1C22}"/>
                </a:ext>
              </a:extLst>
            </p:cNvPr>
            <p:cNvSpPr txBox="1"/>
            <p:nvPr/>
          </p:nvSpPr>
          <p:spPr>
            <a:xfrm>
              <a:off x="4699139" y="3385295"/>
              <a:ext cx="486780" cy="315913"/>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Aug</a:t>
              </a:r>
            </a:p>
            <a:p>
              <a:pPr algn="ctr"/>
              <a:r>
                <a:rPr lang="en-US" sz="800" dirty="0">
                  <a:latin typeface="Arial" panose="020B0604020202020204" pitchFamily="34" charset="0"/>
                  <a:cs typeface="Arial" panose="020B0604020202020204" pitchFamily="34" charset="0"/>
                </a:rPr>
                <a:t>2017</a:t>
              </a:r>
            </a:p>
          </p:txBody>
        </p:sp>
        <p:sp>
          <p:nvSpPr>
            <p:cNvPr id="32" name="Rectangle 31">
              <a:extLst>
                <a:ext uri="{FF2B5EF4-FFF2-40B4-BE49-F238E27FC236}">
                  <a16:creationId xmlns:a16="http://schemas.microsoft.com/office/drawing/2014/main" id="{0EE872E1-6946-43B9-B775-7BDD4BBBA48E}"/>
                </a:ext>
              </a:extLst>
            </p:cNvPr>
            <p:cNvSpPr/>
            <p:nvPr/>
          </p:nvSpPr>
          <p:spPr>
            <a:xfrm>
              <a:off x="3728445" y="3225338"/>
              <a:ext cx="2325334" cy="101319"/>
            </a:xfrm>
            <a:prstGeom prst="rect">
              <a:avLst/>
            </a:prstGeom>
            <a:solidFill>
              <a:schemeClr val="accent6">
                <a:lumMod val="75000"/>
              </a:schemeClr>
            </a:solidFill>
            <a:ln w="19050">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solidFill>
                    <a:schemeClr val="bg1"/>
                  </a:solidFill>
                  <a:latin typeface="Arial" panose="020B0604020202020204" pitchFamily="34" charset="0"/>
                  <a:cs typeface="Arial" panose="020B0604020202020204" pitchFamily="34" charset="0"/>
                </a:rPr>
                <a:t>intramuscular IG</a:t>
              </a:r>
            </a:p>
          </p:txBody>
        </p:sp>
        <p:sp>
          <p:nvSpPr>
            <p:cNvPr id="34" name="TextBox 33">
              <a:extLst>
                <a:ext uri="{FF2B5EF4-FFF2-40B4-BE49-F238E27FC236}">
                  <a16:creationId xmlns:a16="http://schemas.microsoft.com/office/drawing/2014/main" id="{54953B60-0DDF-490C-944F-15629ECB354E}"/>
                </a:ext>
              </a:extLst>
            </p:cNvPr>
            <p:cNvSpPr txBox="1"/>
            <p:nvPr/>
          </p:nvSpPr>
          <p:spPr>
            <a:xfrm>
              <a:off x="3658990" y="1854141"/>
              <a:ext cx="641566" cy="315913"/>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VDRV RI6318</a:t>
              </a:r>
            </a:p>
          </p:txBody>
        </p:sp>
        <p:sp>
          <p:nvSpPr>
            <p:cNvPr id="35" name="TextBox 34">
              <a:extLst>
                <a:ext uri="{FF2B5EF4-FFF2-40B4-BE49-F238E27FC236}">
                  <a16:creationId xmlns:a16="http://schemas.microsoft.com/office/drawing/2014/main" id="{24B4AFBB-41BA-44FB-A177-5A8F37DAEF4F}"/>
                </a:ext>
              </a:extLst>
            </p:cNvPr>
            <p:cNvSpPr txBox="1"/>
            <p:nvPr/>
          </p:nvSpPr>
          <p:spPr>
            <a:xfrm>
              <a:off x="4573431" y="2089650"/>
              <a:ext cx="641566" cy="315913"/>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VDRV RI5787</a:t>
              </a:r>
            </a:p>
          </p:txBody>
        </p:sp>
        <p:sp>
          <p:nvSpPr>
            <p:cNvPr id="40" name="TextBox 39">
              <a:extLst>
                <a:ext uri="{FF2B5EF4-FFF2-40B4-BE49-F238E27FC236}">
                  <a16:creationId xmlns:a16="http://schemas.microsoft.com/office/drawing/2014/main" id="{029DD118-3494-44A1-AAEA-FFD9800DC169}"/>
                </a:ext>
              </a:extLst>
            </p:cNvPr>
            <p:cNvSpPr txBox="1"/>
            <p:nvPr/>
          </p:nvSpPr>
          <p:spPr>
            <a:xfrm>
              <a:off x="5673599" y="2263421"/>
              <a:ext cx="751440" cy="33855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VDRV RI3211</a:t>
              </a:r>
            </a:p>
          </p:txBody>
        </p:sp>
        <p:sp>
          <p:nvSpPr>
            <p:cNvPr id="41" name="TextBox 40">
              <a:extLst>
                <a:ext uri="{FF2B5EF4-FFF2-40B4-BE49-F238E27FC236}">
                  <a16:creationId xmlns:a16="http://schemas.microsoft.com/office/drawing/2014/main" id="{73889C25-00C8-4042-A28B-ED27F749BFBE}"/>
                </a:ext>
              </a:extLst>
            </p:cNvPr>
            <p:cNvSpPr txBox="1"/>
            <p:nvPr/>
          </p:nvSpPr>
          <p:spPr>
            <a:xfrm>
              <a:off x="4347691" y="1775046"/>
              <a:ext cx="1260722" cy="230832"/>
            </a:xfrm>
            <a:prstGeom prst="rect">
              <a:avLst/>
            </a:prstGeom>
            <a:noFill/>
            <a:ln>
              <a:noFill/>
            </a:ln>
          </p:spPr>
          <p:txBody>
            <a:bodyPr wrap="square" rtlCol="0">
              <a:spAutoFit/>
            </a:bodyPr>
            <a:lstStyle/>
            <a:p>
              <a:pPr algn="ctr"/>
              <a:r>
                <a:rPr lang="en-US" sz="900" b="1" dirty="0">
                  <a:latin typeface="Arial" panose="020B0604020202020204" pitchFamily="34" charset="0"/>
                  <a:cs typeface="Arial" panose="020B0604020202020204" pitchFamily="34" charset="0"/>
                </a:rPr>
                <a:t>RI case</a:t>
              </a:r>
            </a:p>
          </p:txBody>
        </p:sp>
        <p:sp>
          <p:nvSpPr>
            <p:cNvPr id="42" name="Arrow: Right 41">
              <a:extLst>
                <a:ext uri="{FF2B5EF4-FFF2-40B4-BE49-F238E27FC236}">
                  <a16:creationId xmlns:a16="http://schemas.microsoft.com/office/drawing/2014/main" id="{680668E6-0D97-486A-98A4-44A5DEAA6EF4}"/>
                </a:ext>
              </a:extLst>
            </p:cNvPr>
            <p:cNvSpPr/>
            <p:nvPr/>
          </p:nvSpPr>
          <p:spPr>
            <a:xfrm rot="5400000">
              <a:off x="4798030" y="2453430"/>
              <a:ext cx="186164" cy="79298"/>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3" name="Arrow: Right 42">
              <a:extLst>
                <a:ext uri="{FF2B5EF4-FFF2-40B4-BE49-F238E27FC236}">
                  <a16:creationId xmlns:a16="http://schemas.microsoft.com/office/drawing/2014/main" id="{3575D2A5-95B6-4C1B-BA18-611C66586B18}"/>
                </a:ext>
              </a:extLst>
            </p:cNvPr>
            <p:cNvSpPr/>
            <p:nvPr/>
          </p:nvSpPr>
          <p:spPr>
            <a:xfrm rot="8381259">
              <a:off x="3750072" y="2218238"/>
              <a:ext cx="199398" cy="82539"/>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4" name="Arrow: Right 43">
              <a:extLst>
                <a:ext uri="{FF2B5EF4-FFF2-40B4-BE49-F238E27FC236}">
                  <a16:creationId xmlns:a16="http://schemas.microsoft.com/office/drawing/2014/main" id="{F62FA2F5-BF11-4CAC-B944-5A7B640D5DCB}"/>
                </a:ext>
              </a:extLst>
            </p:cNvPr>
            <p:cNvSpPr/>
            <p:nvPr/>
          </p:nvSpPr>
          <p:spPr>
            <a:xfrm rot="5400000">
              <a:off x="5956237" y="2639594"/>
              <a:ext cx="186164" cy="79298"/>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6" name="Arrow: Right 45">
              <a:extLst>
                <a:ext uri="{FF2B5EF4-FFF2-40B4-BE49-F238E27FC236}">
                  <a16:creationId xmlns:a16="http://schemas.microsoft.com/office/drawing/2014/main" id="{1245D63C-8106-4ABD-A366-A82FC1AF8277}"/>
                </a:ext>
              </a:extLst>
            </p:cNvPr>
            <p:cNvSpPr/>
            <p:nvPr/>
          </p:nvSpPr>
          <p:spPr>
            <a:xfrm rot="4537675">
              <a:off x="3102517" y="2589750"/>
              <a:ext cx="180928" cy="81920"/>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7" name="TextBox 46">
              <a:extLst>
                <a:ext uri="{FF2B5EF4-FFF2-40B4-BE49-F238E27FC236}">
                  <a16:creationId xmlns:a16="http://schemas.microsoft.com/office/drawing/2014/main" id="{A8B50054-1ECA-4343-80AC-F306C02A2399}"/>
                </a:ext>
              </a:extLst>
            </p:cNvPr>
            <p:cNvSpPr txBox="1"/>
            <p:nvPr/>
          </p:nvSpPr>
          <p:spPr>
            <a:xfrm>
              <a:off x="657171" y="3385295"/>
              <a:ext cx="502873" cy="296060"/>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Oct 2016</a:t>
              </a:r>
            </a:p>
          </p:txBody>
        </p:sp>
        <p:sp>
          <p:nvSpPr>
            <p:cNvPr id="48" name="TextBox 47">
              <a:extLst>
                <a:ext uri="{FF2B5EF4-FFF2-40B4-BE49-F238E27FC236}">
                  <a16:creationId xmlns:a16="http://schemas.microsoft.com/office/drawing/2014/main" id="{8C8661DC-EB69-4F80-9A17-1184D31A0D95}"/>
                </a:ext>
              </a:extLst>
            </p:cNvPr>
            <p:cNvSpPr txBox="1"/>
            <p:nvPr/>
          </p:nvSpPr>
          <p:spPr>
            <a:xfrm>
              <a:off x="2971041" y="3385295"/>
              <a:ext cx="502873" cy="296060"/>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March 2018</a:t>
              </a:r>
            </a:p>
          </p:txBody>
        </p:sp>
        <p:sp>
          <p:nvSpPr>
            <p:cNvPr id="49" name="TextBox 48">
              <a:extLst>
                <a:ext uri="{FF2B5EF4-FFF2-40B4-BE49-F238E27FC236}">
                  <a16:creationId xmlns:a16="http://schemas.microsoft.com/office/drawing/2014/main" id="{409DA022-D94F-4E72-8A3E-2D598B4C724C}"/>
                </a:ext>
              </a:extLst>
            </p:cNvPr>
            <p:cNvSpPr txBox="1"/>
            <p:nvPr/>
          </p:nvSpPr>
          <p:spPr>
            <a:xfrm>
              <a:off x="1344575" y="3385295"/>
              <a:ext cx="502873" cy="296060"/>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March 2017</a:t>
              </a:r>
            </a:p>
          </p:txBody>
        </p:sp>
        <p:sp>
          <p:nvSpPr>
            <p:cNvPr id="50" name="Rectangle 49">
              <a:extLst>
                <a:ext uri="{FF2B5EF4-FFF2-40B4-BE49-F238E27FC236}">
                  <a16:creationId xmlns:a16="http://schemas.microsoft.com/office/drawing/2014/main" id="{E31648D6-11F7-40DC-BD47-DA537BBD3EC6}"/>
                </a:ext>
              </a:extLst>
            </p:cNvPr>
            <p:cNvSpPr/>
            <p:nvPr/>
          </p:nvSpPr>
          <p:spPr>
            <a:xfrm>
              <a:off x="1577270" y="2982895"/>
              <a:ext cx="1656671" cy="186163"/>
            </a:xfrm>
            <a:prstGeom prst="rect">
              <a:avLst/>
            </a:prstGeom>
            <a:solidFill>
              <a:srgbClr val="0070C0"/>
            </a:solid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solidFill>
                    <a:schemeClr val="bg1"/>
                  </a:solidFill>
                  <a:latin typeface="Arial" panose="020B0604020202020204" pitchFamily="34" charset="0"/>
                  <a:cs typeface="Arial" panose="020B0604020202020204" pitchFamily="34" charset="0"/>
                </a:rPr>
                <a:t>NTZ 7 mg/kg/day for 1 </a:t>
              </a:r>
              <a:r>
                <a:rPr lang="en-US" sz="700" dirty="0" err="1">
                  <a:solidFill>
                    <a:schemeClr val="bg1"/>
                  </a:solidFill>
                  <a:latin typeface="Arial" panose="020B0604020202020204" pitchFamily="34" charset="0"/>
                  <a:cs typeface="Arial" panose="020B0604020202020204" pitchFamily="34" charset="0"/>
                </a:rPr>
                <a:t>yr</a:t>
              </a:r>
              <a:r>
                <a:rPr lang="en-US" sz="700" dirty="0">
                  <a:solidFill>
                    <a:schemeClr val="bg1"/>
                  </a:solidFill>
                  <a:latin typeface="Arial" panose="020B0604020202020204" pitchFamily="34" charset="0"/>
                  <a:cs typeface="Arial" panose="020B0604020202020204" pitchFamily="34" charset="0"/>
                </a:rPr>
                <a:t> </a:t>
              </a:r>
            </a:p>
          </p:txBody>
        </p:sp>
        <p:sp>
          <p:nvSpPr>
            <p:cNvPr id="51" name="Rectangle 50">
              <a:extLst>
                <a:ext uri="{FF2B5EF4-FFF2-40B4-BE49-F238E27FC236}">
                  <a16:creationId xmlns:a16="http://schemas.microsoft.com/office/drawing/2014/main" id="{0A994A50-FE31-4BFF-B233-18D7CD50907A}"/>
                </a:ext>
              </a:extLst>
            </p:cNvPr>
            <p:cNvSpPr/>
            <p:nvPr/>
          </p:nvSpPr>
          <p:spPr>
            <a:xfrm>
              <a:off x="908608" y="3212842"/>
              <a:ext cx="2325333" cy="110492"/>
            </a:xfrm>
            <a:prstGeom prst="rect">
              <a:avLst/>
            </a:prstGeom>
            <a:solidFill>
              <a:schemeClr val="accent2">
                <a:lumMod val="75000"/>
              </a:schemeClr>
            </a:solidFill>
            <a:ln w="190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00" dirty="0">
                  <a:solidFill>
                    <a:schemeClr val="bg1"/>
                  </a:solidFill>
                  <a:latin typeface="Arial" panose="020B0604020202020204" pitchFamily="34" charset="0"/>
                  <a:cs typeface="Arial" panose="020B0604020202020204" pitchFamily="34" charset="0"/>
                </a:rPr>
                <a:t>prednisone oral</a:t>
              </a:r>
            </a:p>
          </p:txBody>
        </p:sp>
        <p:sp>
          <p:nvSpPr>
            <p:cNvPr id="52" name="TextBox 51">
              <a:extLst>
                <a:ext uri="{FF2B5EF4-FFF2-40B4-BE49-F238E27FC236}">
                  <a16:creationId xmlns:a16="http://schemas.microsoft.com/office/drawing/2014/main" id="{D91BAFFD-F289-4D70-BB7F-2AA218AF62E1}"/>
                </a:ext>
              </a:extLst>
            </p:cNvPr>
            <p:cNvSpPr txBox="1"/>
            <p:nvPr/>
          </p:nvSpPr>
          <p:spPr>
            <a:xfrm>
              <a:off x="916717" y="1939765"/>
              <a:ext cx="767633" cy="296060"/>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VDRV CA6944</a:t>
              </a:r>
            </a:p>
          </p:txBody>
        </p:sp>
        <p:sp>
          <p:nvSpPr>
            <p:cNvPr id="53" name="TextBox 52">
              <a:extLst>
                <a:ext uri="{FF2B5EF4-FFF2-40B4-BE49-F238E27FC236}">
                  <a16:creationId xmlns:a16="http://schemas.microsoft.com/office/drawing/2014/main" id="{EDBBFAD3-68D9-47BC-8253-D09410878228}"/>
                </a:ext>
              </a:extLst>
            </p:cNvPr>
            <p:cNvSpPr txBox="1"/>
            <p:nvPr/>
          </p:nvSpPr>
          <p:spPr>
            <a:xfrm>
              <a:off x="2695056" y="2232949"/>
              <a:ext cx="696130" cy="296060"/>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iVDRV CA6598</a:t>
              </a:r>
            </a:p>
          </p:txBody>
        </p:sp>
        <p:sp>
          <p:nvSpPr>
            <p:cNvPr id="54" name="TextBox 53">
              <a:extLst>
                <a:ext uri="{FF2B5EF4-FFF2-40B4-BE49-F238E27FC236}">
                  <a16:creationId xmlns:a16="http://schemas.microsoft.com/office/drawing/2014/main" id="{65BECD5D-EDED-4953-A50E-62266878E553}"/>
                </a:ext>
              </a:extLst>
            </p:cNvPr>
            <p:cNvSpPr txBox="1"/>
            <p:nvPr/>
          </p:nvSpPr>
          <p:spPr>
            <a:xfrm>
              <a:off x="1441216" y="1775046"/>
              <a:ext cx="1302400" cy="230832"/>
            </a:xfrm>
            <a:prstGeom prst="rect">
              <a:avLst/>
            </a:prstGeom>
            <a:noFill/>
            <a:ln>
              <a:noFill/>
            </a:ln>
          </p:spPr>
          <p:txBody>
            <a:bodyPr wrap="square" rtlCol="0">
              <a:spAutoFit/>
            </a:bodyPr>
            <a:lstStyle/>
            <a:p>
              <a:pPr algn="ctr"/>
              <a:r>
                <a:rPr lang="en-US" sz="900" b="1" dirty="0">
                  <a:latin typeface="Arial" panose="020B0604020202020204" pitchFamily="34" charset="0"/>
                  <a:cs typeface="Arial" panose="020B0604020202020204" pitchFamily="34" charset="0"/>
                </a:rPr>
                <a:t>CA case</a:t>
              </a:r>
            </a:p>
          </p:txBody>
        </p:sp>
        <p:sp>
          <p:nvSpPr>
            <p:cNvPr id="55" name="Arrow: Right 54">
              <a:extLst>
                <a:ext uri="{FF2B5EF4-FFF2-40B4-BE49-F238E27FC236}">
                  <a16:creationId xmlns:a16="http://schemas.microsoft.com/office/drawing/2014/main" id="{2D4A214B-F315-4126-905C-4AF982500662}"/>
                </a:ext>
              </a:extLst>
            </p:cNvPr>
            <p:cNvSpPr/>
            <p:nvPr/>
          </p:nvSpPr>
          <p:spPr>
            <a:xfrm rot="8381259">
              <a:off x="918208" y="2243653"/>
              <a:ext cx="205990" cy="80217"/>
            </a:xfrm>
            <a:prstGeom prs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4" name="Group 3">
              <a:extLst>
                <a:ext uri="{FF2B5EF4-FFF2-40B4-BE49-F238E27FC236}">
                  <a16:creationId xmlns:a16="http://schemas.microsoft.com/office/drawing/2014/main" id="{4E64BF19-809E-447A-AF43-83BDC314167F}"/>
                </a:ext>
              </a:extLst>
            </p:cNvPr>
            <p:cNvGrpSpPr/>
            <p:nvPr/>
          </p:nvGrpSpPr>
          <p:grpSpPr>
            <a:xfrm>
              <a:off x="4447702" y="2938407"/>
              <a:ext cx="502874" cy="288632"/>
              <a:chOff x="3244030" y="4673775"/>
              <a:chExt cx="502874" cy="307777"/>
            </a:xfrm>
          </p:grpSpPr>
          <p:sp>
            <p:nvSpPr>
              <p:cNvPr id="27" name="Rectangle 26">
                <a:extLst>
                  <a:ext uri="{FF2B5EF4-FFF2-40B4-BE49-F238E27FC236}">
                    <a16:creationId xmlns:a16="http://schemas.microsoft.com/office/drawing/2014/main" id="{31081107-8B6E-4854-8798-339AAEE63DB2}"/>
                  </a:ext>
                </a:extLst>
              </p:cNvPr>
              <p:cNvSpPr/>
              <p:nvPr/>
            </p:nvSpPr>
            <p:spPr>
              <a:xfrm>
                <a:off x="3332295" y="4709434"/>
                <a:ext cx="326696" cy="236460"/>
              </a:xfrm>
              <a:prstGeom prst="rect">
                <a:avLst/>
              </a:prstGeom>
              <a:solidFill>
                <a:srgbClr val="0070C0"/>
              </a:solid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dirty="0">
                  <a:solidFill>
                    <a:schemeClr val="bg1"/>
                  </a:solidFill>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CB621483-F3E7-4FEA-A899-E8A6CDC87B17}"/>
                  </a:ext>
                </a:extLst>
              </p:cNvPr>
              <p:cNvSpPr txBox="1"/>
              <p:nvPr/>
            </p:nvSpPr>
            <p:spPr>
              <a:xfrm>
                <a:off x="3244030" y="4673775"/>
                <a:ext cx="502874" cy="307777"/>
              </a:xfrm>
              <a:prstGeom prst="rect">
                <a:avLst/>
              </a:prstGeom>
              <a:noFill/>
            </p:spPr>
            <p:txBody>
              <a:bodyPr wrap="square" rtlCol="0">
                <a:spAutoFit/>
              </a:bodyPr>
              <a:lstStyle/>
              <a:p>
                <a:pPr algn="ctr"/>
                <a:r>
                  <a:rPr lang="en-US" sz="700" dirty="0">
                    <a:solidFill>
                      <a:schemeClr val="bg1"/>
                    </a:solidFill>
                    <a:latin typeface="Arial" panose="020B0604020202020204" pitchFamily="34" charset="0"/>
                    <a:cs typeface="Arial" panose="020B0604020202020204" pitchFamily="34" charset="0"/>
                  </a:rPr>
                  <a:t>NTZ for 6 </a:t>
                </a:r>
                <a:r>
                  <a:rPr lang="en-US" sz="700" dirty="0" err="1">
                    <a:solidFill>
                      <a:schemeClr val="bg1"/>
                    </a:solidFill>
                    <a:latin typeface="Arial" panose="020B0604020202020204" pitchFamily="34" charset="0"/>
                    <a:cs typeface="Arial" panose="020B0604020202020204" pitchFamily="34" charset="0"/>
                  </a:rPr>
                  <a:t>wks</a:t>
                </a:r>
                <a:endParaRPr lang="en-US" sz="700" dirty="0">
                  <a:solidFill>
                    <a:schemeClr val="bg1"/>
                  </a:solidFill>
                  <a:latin typeface="Arial" panose="020B0604020202020204" pitchFamily="34" charset="0"/>
                  <a:cs typeface="Arial" panose="020B0604020202020204" pitchFamily="34" charset="0"/>
                </a:endParaRPr>
              </a:p>
            </p:txBody>
          </p:sp>
        </p:grpSp>
        <p:grpSp>
          <p:nvGrpSpPr>
            <p:cNvPr id="6" name="Group 5">
              <a:extLst>
                <a:ext uri="{FF2B5EF4-FFF2-40B4-BE49-F238E27FC236}">
                  <a16:creationId xmlns:a16="http://schemas.microsoft.com/office/drawing/2014/main" id="{EF039703-8FD3-4880-9731-4BAA80D2DB6E}"/>
                </a:ext>
              </a:extLst>
            </p:cNvPr>
            <p:cNvGrpSpPr/>
            <p:nvPr/>
          </p:nvGrpSpPr>
          <p:grpSpPr>
            <a:xfrm>
              <a:off x="5183667" y="2928552"/>
              <a:ext cx="979863" cy="307777"/>
              <a:chOff x="5183667" y="2928552"/>
              <a:chExt cx="979863" cy="307777"/>
            </a:xfrm>
          </p:grpSpPr>
          <p:sp>
            <p:nvSpPr>
              <p:cNvPr id="33" name="Rectangle 32">
                <a:extLst>
                  <a:ext uri="{FF2B5EF4-FFF2-40B4-BE49-F238E27FC236}">
                    <a16:creationId xmlns:a16="http://schemas.microsoft.com/office/drawing/2014/main" id="{89308FB0-74C8-499A-BA92-A3B2936A6A60}"/>
                  </a:ext>
                </a:extLst>
              </p:cNvPr>
              <p:cNvSpPr/>
              <p:nvPr/>
            </p:nvSpPr>
            <p:spPr>
              <a:xfrm>
                <a:off x="5292597" y="2971848"/>
                <a:ext cx="751440" cy="215160"/>
              </a:xfrm>
              <a:prstGeom prst="rect">
                <a:avLst/>
              </a:prstGeom>
              <a:solidFill>
                <a:srgbClr val="0070C0"/>
              </a:solidFill>
              <a:ln w="190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dirty="0">
                  <a:solidFill>
                    <a:schemeClr val="bg1"/>
                  </a:solidFill>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0E03541F-E13D-4A27-AF7E-7AA2AF294BE5}"/>
                  </a:ext>
                </a:extLst>
              </p:cNvPr>
              <p:cNvSpPr txBox="1"/>
              <p:nvPr/>
            </p:nvSpPr>
            <p:spPr>
              <a:xfrm>
                <a:off x="5183667" y="2928552"/>
                <a:ext cx="979863" cy="307777"/>
              </a:xfrm>
              <a:prstGeom prst="rect">
                <a:avLst/>
              </a:prstGeom>
              <a:noFill/>
            </p:spPr>
            <p:txBody>
              <a:bodyPr wrap="square">
                <a:spAutoFit/>
              </a:bodyPr>
              <a:lstStyle/>
              <a:p>
                <a:pPr algn="ctr"/>
                <a:r>
                  <a:rPr lang="en-US" sz="700" dirty="0">
                    <a:solidFill>
                      <a:schemeClr val="bg1"/>
                    </a:solidFill>
                    <a:latin typeface="Arial" panose="020B0604020202020204" pitchFamily="34" charset="0"/>
                    <a:cs typeface="Arial" panose="020B0604020202020204" pitchFamily="34" charset="0"/>
                  </a:rPr>
                  <a:t>NTZ 500 mg q12h for 3.5 mo.</a:t>
                </a:r>
              </a:p>
            </p:txBody>
          </p:sp>
        </p:grpSp>
      </p:grpSp>
      <p:sp>
        <p:nvSpPr>
          <p:cNvPr id="31" name="TextBox 30">
            <a:extLst>
              <a:ext uri="{FF2B5EF4-FFF2-40B4-BE49-F238E27FC236}">
                <a16:creationId xmlns:a16="http://schemas.microsoft.com/office/drawing/2014/main" id="{0FDB5CC8-C87A-401D-BB20-75EED81FE036}"/>
              </a:ext>
            </a:extLst>
          </p:cNvPr>
          <p:cNvSpPr txBox="1"/>
          <p:nvPr/>
        </p:nvSpPr>
        <p:spPr>
          <a:xfrm>
            <a:off x="867997" y="5142499"/>
            <a:ext cx="5048596" cy="400110"/>
          </a:xfrm>
          <a:prstGeom prst="rect">
            <a:avLst/>
          </a:prstGeom>
          <a:noFill/>
        </p:spPr>
        <p:txBody>
          <a:bodyPr wrap="square" rtlCol="0">
            <a:spAutoFit/>
          </a:bodyPr>
          <a:lstStyle/>
          <a:p>
            <a:r>
              <a:rPr lang="en-US" sz="1000" b="1" dirty="0">
                <a:latin typeface="Palatino Linotype" panose="02040502050505030304" pitchFamily="18" charset="0"/>
                <a:cs typeface="Arial" panose="020B0604020202020204" pitchFamily="34" charset="0"/>
              </a:rPr>
              <a:t>Figure S1. </a:t>
            </a:r>
            <a:r>
              <a:rPr lang="en-US" sz="1000" dirty="0">
                <a:latin typeface="Palatino Linotype" panose="02040502050505030304" pitchFamily="18" charset="0"/>
                <a:cs typeface="Arial" panose="020B0604020202020204" pitchFamily="34" charset="0"/>
              </a:rPr>
              <a:t>Course of skin granuloma treatments, amounts of  iVDRV RNA and infectious iVDRV strains in skin lesion biopsies before and after NTZ therapy.</a:t>
            </a:r>
          </a:p>
        </p:txBody>
      </p:sp>
    </p:spTree>
    <p:extLst>
      <p:ext uri="{BB962C8B-B14F-4D97-AF65-F5344CB8AC3E}">
        <p14:creationId xmlns:p14="http://schemas.microsoft.com/office/powerpoint/2010/main" val="17269422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30FE33E8-7D89-4149-B4FC-247E43D7A0A5}"/>
              </a:ext>
            </a:extLst>
          </p:cNvPr>
          <p:cNvGraphicFramePr>
            <a:graphicFrameLocks noChangeAspect="1"/>
          </p:cNvGraphicFramePr>
          <p:nvPr>
            <p:extLst>
              <p:ext uri="{D42A27DB-BD31-4B8C-83A1-F6EECF244321}">
                <p14:modId xmlns:p14="http://schemas.microsoft.com/office/powerpoint/2010/main" val="2812897250"/>
              </p:ext>
            </p:extLst>
          </p:nvPr>
        </p:nvGraphicFramePr>
        <p:xfrm>
          <a:off x="684213" y="1152525"/>
          <a:ext cx="5751512" cy="2947988"/>
        </p:xfrm>
        <a:graphic>
          <a:graphicData uri="http://schemas.openxmlformats.org/presentationml/2006/ole">
            <mc:AlternateContent xmlns:mc="http://schemas.openxmlformats.org/markup-compatibility/2006">
              <mc:Choice xmlns:v="urn:schemas-microsoft-com:vml" Requires="v">
                <p:oleObj spid="_x0000_s2051" name="Prism 8" r:id="rId3" imgW="5752088" imgH="2948581" progId="Prism8.Document">
                  <p:embed/>
                </p:oleObj>
              </mc:Choice>
              <mc:Fallback>
                <p:oleObj name="Prism 8" r:id="rId3" imgW="5752088" imgH="2948581" progId="Prism8.Document">
                  <p:embed/>
                  <p:pic>
                    <p:nvPicPr>
                      <p:cNvPr id="2" name="Object 1">
                        <a:extLst>
                          <a:ext uri="{FF2B5EF4-FFF2-40B4-BE49-F238E27FC236}">
                            <a16:creationId xmlns:a16="http://schemas.microsoft.com/office/drawing/2014/main" id="{30FE33E8-7D89-4149-B4FC-247E43D7A0A5}"/>
                          </a:ext>
                        </a:extLst>
                      </p:cNvPr>
                      <p:cNvPicPr/>
                      <p:nvPr/>
                    </p:nvPicPr>
                    <p:blipFill>
                      <a:blip r:embed="rId4"/>
                      <a:stretch>
                        <a:fillRect/>
                      </a:stretch>
                    </p:blipFill>
                    <p:spPr>
                      <a:xfrm>
                        <a:off x="684213" y="1152525"/>
                        <a:ext cx="5751512" cy="2947988"/>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337F8738-E22F-48ED-9EFA-B8F222219FC0}"/>
              </a:ext>
            </a:extLst>
          </p:cNvPr>
          <p:cNvSpPr txBox="1"/>
          <p:nvPr/>
        </p:nvSpPr>
        <p:spPr>
          <a:xfrm>
            <a:off x="1209376" y="5458571"/>
            <a:ext cx="5048596" cy="861774"/>
          </a:xfrm>
          <a:prstGeom prst="rect">
            <a:avLst/>
          </a:prstGeom>
          <a:noFill/>
        </p:spPr>
        <p:txBody>
          <a:bodyPr wrap="square" rtlCol="0">
            <a:spAutoFit/>
          </a:bodyPr>
          <a:lstStyle/>
          <a:p>
            <a:r>
              <a:rPr lang="en-US" sz="1000" b="1" dirty="0">
                <a:latin typeface="Palatino Linotype" panose="02040502050505030304" pitchFamily="18" charset="0"/>
                <a:cs typeface="Arial" panose="020B0604020202020204" pitchFamily="34" charset="0"/>
              </a:rPr>
              <a:t>Figure S2. </a:t>
            </a:r>
            <a:r>
              <a:rPr lang="en-US" sz="1000" dirty="0">
                <a:latin typeface="Palatino Linotype" panose="02040502050505030304" pitchFamily="18" charset="0"/>
                <a:cs typeface="Arial" panose="020B0604020202020204" pitchFamily="34" charset="0"/>
              </a:rPr>
              <a:t>Inhibition of replication of iVDRV strains isolated from skin lesions before and after the NTZ therapies. A. Dose response analysis of A549 cells treated with tizoxanide and infected with iVDRV strains. Data represent the mean of three (RA27/3, CA strains) or four (RI strains) independent experiments +/- SD. B. Table of IC</a:t>
            </a:r>
            <a:r>
              <a:rPr lang="en-US" sz="1000" baseline="-25000" dirty="0">
                <a:latin typeface="Palatino Linotype" panose="02040502050505030304" pitchFamily="18" charset="0"/>
                <a:cs typeface="Arial" panose="020B0604020202020204" pitchFamily="34" charset="0"/>
              </a:rPr>
              <a:t>50</a:t>
            </a:r>
            <a:r>
              <a:rPr lang="en-US" sz="1000" dirty="0">
                <a:latin typeface="Palatino Linotype" panose="02040502050505030304" pitchFamily="18" charset="0"/>
                <a:cs typeface="Arial" panose="020B0604020202020204" pitchFamily="34" charset="0"/>
              </a:rPr>
              <a:t> and IC</a:t>
            </a:r>
            <a:r>
              <a:rPr lang="en-US" sz="1000" baseline="-25000" dirty="0">
                <a:latin typeface="Palatino Linotype" panose="02040502050505030304" pitchFamily="18" charset="0"/>
                <a:cs typeface="Arial" panose="020B0604020202020204" pitchFamily="34" charset="0"/>
              </a:rPr>
              <a:t>90</a:t>
            </a:r>
            <a:r>
              <a:rPr lang="en-US" sz="1000" dirty="0">
                <a:latin typeface="Palatino Linotype" panose="02040502050505030304" pitchFamily="18" charset="0"/>
                <a:cs typeface="Arial" panose="020B0604020202020204" pitchFamily="34" charset="0"/>
              </a:rPr>
              <a:t> of tizoxanide in A459 cells  infected with iVDRV strains.</a:t>
            </a:r>
          </a:p>
        </p:txBody>
      </p:sp>
      <p:sp>
        <p:nvSpPr>
          <p:cNvPr id="4" name="TextBox 3">
            <a:extLst>
              <a:ext uri="{FF2B5EF4-FFF2-40B4-BE49-F238E27FC236}">
                <a16:creationId xmlns:a16="http://schemas.microsoft.com/office/drawing/2014/main" id="{43C31911-B422-4C9F-BBA0-0BF79E048D5A}"/>
              </a:ext>
            </a:extLst>
          </p:cNvPr>
          <p:cNvSpPr txBox="1"/>
          <p:nvPr/>
        </p:nvSpPr>
        <p:spPr>
          <a:xfrm>
            <a:off x="1193939" y="1063605"/>
            <a:ext cx="1280015" cy="230832"/>
          </a:xfrm>
          <a:prstGeom prst="rect">
            <a:avLst/>
          </a:prstGeom>
          <a:noFill/>
        </p:spPr>
        <p:txBody>
          <a:bodyPr wrap="square" rtlCol="0">
            <a:spAutoFit/>
          </a:bodyPr>
          <a:lstStyle/>
          <a:p>
            <a:r>
              <a:rPr lang="en-US" sz="900" dirty="0"/>
              <a:t>Vaccine virus (control)</a:t>
            </a:r>
          </a:p>
        </p:txBody>
      </p:sp>
      <p:sp>
        <p:nvSpPr>
          <p:cNvPr id="5" name="TextBox 4">
            <a:extLst>
              <a:ext uri="{FF2B5EF4-FFF2-40B4-BE49-F238E27FC236}">
                <a16:creationId xmlns:a16="http://schemas.microsoft.com/office/drawing/2014/main" id="{A3744FED-CD44-487E-82D7-7DBE76FAB682}"/>
              </a:ext>
            </a:extLst>
          </p:cNvPr>
          <p:cNvSpPr txBox="1"/>
          <p:nvPr/>
        </p:nvSpPr>
        <p:spPr>
          <a:xfrm>
            <a:off x="771455" y="963762"/>
            <a:ext cx="293716"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A6BB0859-2A4E-4EC0-9603-099F6F58FC49}"/>
              </a:ext>
            </a:extLst>
          </p:cNvPr>
          <p:cNvSpPr txBox="1"/>
          <p:nvPr/>
        </p:nvSpPr>
        <p:spPr>
          <a:xfrm>
            <a:off x="771455" y="2581042"/>
            <a:ext cx="293716"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218003D1-3D52-452E-BA6A-F372335FF546}"/>
              </a:ext>
            </a:extLst>
          </p:cNvPr>
          <p:cNvSpPr txBox="1"/>
          <p:nvPr/>
        </p:nvSpPr>
        <p:spPr>
          <a:xfrm>
            <a:off x="3059083" y="1063605"/>
            <a:ext cx="739833" cy="230832"/>
          </a:xfrm>
          <a:prstGeom prst="rect">
            <a:avLst/>
          </a:prstGeom>
          <a:noFill/>
        </p:spPr>
        <p:txBody>
          <a:bodyPr wrap="square" rtlCol="0">
            <a:spAutoFit/>
          </a:bodyPr>
          <a:lstStyle/>
          <a:p>
            <a:r>
              <a:rPr lang="en-US" sz="900" dirty="0"/>
              <a:t>CA case</a:t>
            </a:r>
          </a:p>
        </p:txBody>
      </p:sp>
      <p:sp>
        <p:nvSpPr>
          <p:cNvPr id="8" name="TextBox 7">
            <a:extLst>
              <a:ext uri="{FF2B5EF4-FFF2-40B4-BE49-F238E27FC236}">
                <a16:creationId xmlns:a16="http://schemas.microsoft.com/office/drawing/2014/main" id="{2F6B0451-EE37-4714-A3A0-9DE45B78D33C}"/>
              </a:ext>
            </a:extLst>
          </p:cNvPr>
          <p:cNvSpPr txBox="1"/>
          <p:nvPr/>
        </p:nvSpPr>
        <p:spPr>
          <a:xfrm>
            <a:off x="4711687" y="1063605"/>
            <a:ext cx="739833" cy="230832"/>
          </a:xfrm>
          <a:prstGeom prst="rect">
            <a:avLst/>
          </a:prstGeom>
          <a:noFill/>
        </p:spPr>
        <p:txBody>
          <a:bodyPr wrap="square" rtlCol="0">
            <a:spAutoFit/>
          </a:bodyPr>
          <a:lstStyle/>
          <a:p>
            <a:r>
              <a:rPr lang="en-US" sz="900" dirty="0"/>
              <a:t>RI case</a:t>
            </a:r>
          </a:p>
        </p:txBody>
      </p:sp>
      <p:sp>
        <p:nvSpPr>
          <p:cNvPr id="10" name="Rectangle 9">
            <a:extLst>
              <a:ext uri="{FF2B5EF4-FFF2-40B4-BE49-F238E27FC236}">
                <a16:creationId xmlns:a16="http://schemas.microsoft.com/office/drawing/2014/main" id="{99FE1D6D-1DEB-49CC-A8CB-764A6D69CF15}"/>
              </a:ext>
            </a:extLst>
          </p:cNvPr>
          <p:cNvSpPr/>
          <p:nvPr/>
        </p:nvSpPr>
        <p:spPr>
          <a:xfrm>
            <a:off x="1065171" y="2784620"/>
            <a:ext cx="4251412" cy="13585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2" name="Table 11">
            <a:extLst>
              <a:ext uri="{FF2B5EF4-FFF2-40B4-BE49-F238E27FC236}">
                <a16:creationId xmlns:a16="http://schemas.microsoft.com/office/drawing/2014/main" id="{FDD089F9-E8DF-4C42-AD49-F8F210EF21FF}"/>
              </a:ext>
            </a:extLst>
          </p:cNvPr>
          <p:cNvGraphicFramePr>
            <a:graphicFrameLocks noGrp="1"/>
          </p:cNvGraphicFramePr>
          <p:nvPr>
            <p:extLst>
              <p:ext uri="{D42A27DB-BD31-4B8C-83A1-F6EECF244321}">
                <p14:modId xmlns:p14="http://schemas.microsoft.com/office/powerpoint/2010/main" val="639169155"/>
              </p:ext>
            </p:extLst>
          </p:nvPr>
        </p:nvGraphicFramePr>
        <p:xfrm>
          <a:off x="1065171" y="2827263"/>
          <a:ext cx="3368675" cy="981904"/>
        </p:xfrm>
        <a:graphic>
          <a:graphicData uri="http://schemas.openxmlformats.org/drawingml/2006/table">
            <a:tbl>
              <a:tblPr firstRow="1" firstCol="1" bandRow="1"/>
              <a:tblGrid>
                <a:gridCol w="1139825">
                  <a:extLst>
                    <a:ext uri="{9D8B030D-6E8A-4147-A177-3AD203B41FA5}">
                      <a16:colId xmlns:a16="http://schemas.microsoft.com/office/drawing/2014/main" val="543704896"/>
                    </a:ext>
                  </a:extLst>
                </a:gridCol>
                <a:gridCol w="1143000">
                  <a:extLst>
                    <a:ext uri="{9D8B030D-6E8A-4147-A177-3AD203B41FA5}">
                      <a16:colId xmlns:a16="http://schemas.microsoft.com/office/drawing/2014/main" val="720083861"/>
                    </a:ext>
                  </a:extLst>
                </a:gridCol>
                <a:gridCol w="1085850">
                  <a:extLst>
                    <a:ext uri="{9D8B030D-6E8A-4147-A177-3AD203B41FA5}">
                      <a16:colId xmlns:a16="http://schemas.microsoft.com/office/drawing/2014/main" val="734493090"/>
                    </a:ext>
                  </a:extLst>
                </a:gridCol>
              </a:tblGrid>
              <a:tr h="0">
                <a:tc>
                  <a:txBody>
                    <a:bodyPr/>
                    <a:lstStyle/>
                    <a:p>
                      <a:pPr marL="0" marR="0" algn="ctr">
                        <a:lnSpc>
                          <a:spcPct val="107000"/>
                        </a:lnSpc>
                        <a:spcBef>
                          <a:spcPts val="0"/>
                        </a:spcBef>
                        <a:spcAft>
                          <a:spcPts val="0"/>
                        </a:spcAft>
                      </a:pPr>
                      <a:r>
                        <a:rPr lang="en-US" sz="900" b="1">
                          <a:effectLst/>
                          <a:latin typeface="Calibri" panose="020F0502020204030204" pitchFamily="34" charset="0"/>
                          <a:ea typeface="Calibri" panose="020F0502020204030204" pitchFamily="34" charset="0"/>
                          <a:cs typeface="Times New Roman" panose="02020603050405020304" pitchFamily="18" charset="0"/>
                        </a:rPr>
                        <a:t>Virus Strain</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9050" cap="flat" cmpd="sng" algn="ctr">
                      <a:solidFill>
                        <a:srgbClr val="666666"/>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Calibri" panose="020F0502020204030204" pitchFamily="34" charset="0"/>
                          <a:ea typeface="Calibri" panose="020F0502020204030204" pitchFamily="34" charset="0"/>
                          <a:cs typeface="Times New Roman" panose="02020603050405020304" pitchFamily="18" charset="0"/>
                        </a:rPr>
                        <a:t>IC</a:t>
                      </a:r>
                      <a:r>
                        <a:rPr lang="en-US" sz="900" b="1" baseline="-25000">
                          <a:effectLst/>
                          <a:latin typeface="Calibri" panose="020F0502020204030204" pitchFamily="34" charset="0"/>
                          <a:ea typeface="Calibri" panose="020F0502020204030204" pitchFamily="34" charset="0"/>
                          <a:cs typeface="Times New Roman" panose="02020603050405020304" pitchFamily="18" charset="0"/>
                        </a:rPr>
                        <a:t>5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9050" cap="flat" cmpd="sng" algn="ctr">
                      <a:solidFill>
                        <a:srgbClr val="666666"/>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Calibri" panose="020F0502020204030204" pitchFamily="34" charset="0"/>
                          <a:ea typeface="Calibri" panose="020F0502020204030204" pitchFamily="34" charset="0"/>
                          <a:cs typeface="Times New Roman" panose="02020603050405020304" pitchFamily="18" charset="0"/>
                        </a:rPr>
                        <a:t>IC</a:t>
                      </a:r>
                      <a:r>
                        <a:rPr lang="en-US" sz="900" b="1" baseline="-25000">
                          <a:effectLst/>
                          <a:latin typeface="Calibri" panose="020F0502020204030204" pitchFamily="34" charset="0"/>
                          <a:ea typeface="Calibri" panose="020F0502020204030204" pitchFamily="34" charset="0"/>
                          <a:cs typeface="Times New Roman" panose="02020603050405020304" pitchFamily="18" charset="0"/>
                        </a:rPr>
                        <a:t>9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9050" cap="flat" cmpd="sng" algn="ctr">
                      <a:solidFill>
                        <a:srgbClr val="666666"/>
                      </a:solidFill>
                      <a:prstDash val="solid"/>
                      <a:round/>
                      <a:headEnd type="none" w="med" len="med"/>
                      <a:tailEnd type="none" w="med" len="med"/>
                    </a:lnB>
                  </a:tcPr>
                </a:tc>
                <a:extLst>
                  <a:ext uri="{0D108BD9-81ED-4DB2-BD59-A6C34878D82A}">
                    <a16:rowId xmlns:a16="http://schemas.microsoft.com/office/drawing/2014/main" val="1995234345"/>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RA27/3</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9050" cap="flat" cmpd="sng" algn="ctr">
                      <a:solidFill>
                        <a:srgbClr val="666666"/>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0.15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9050" cap="flat" cmpd="sng" algn="ctr">
                      <a:solidFill>
                        <a:srgbClr val="666666"/>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1.37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9050" cap="flat" cmpd="sng" algn="ctr">
                      <a:solidFill>
                        <a:srgbClr val="666666"/>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189533884"/>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CA6944</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3.62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11.45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1445362589"/>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CA6598</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1.88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23.17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717879745"/>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RI6318</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1.43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 43.65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3119303556"/>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RI5787</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2.05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  34.99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863697303"/>
                  </a:ext>
                </a:extLst>
              </a:tr>
              <a:tr h="0">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RI3211</a:t>
                      </a: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Calibri" panose="020F0502020204030204" pitchFamily="34" charset="0"/>
                          <a:ea typeface="Calibri" panose="020F0502020204030204" pitchFamily="34" charset="0"/>
                          <a:cs typeface="Times New Roman" panose="02020603050405020304" pitchFamily="18" charset="0"/>
                        </a:rPr>
                        <a:t>7.76 </a:t>
                      </a:r>
                      <a:r>
                        <a:rPr lang="en-US" sz="900">
                          <a:effectLst/>
                          <a:latin typeface="Symbol" panose="05050102010706020507" pitchFamily="18" charset="2"/>
                          <a:ea typeface="Calibri" panose="020F0502020204030204" pitchFamily="34" charset="0"/>
                          <a:cs typeface="Times New Roman" panose="02020603050405020304" pitchFamily="18" charset="0"/>
                        </a:rPr>
                        <a:t>m</a:t>
                      </a:r>
                      <a:r>
                        <a:rPr lang="en-US" sz="900">
                          <a:effectLst/>
                          <a:latin typeface="Calibri" panose="020F0502020204030204" pitchFamily="34" charset="0"/>
                          <a:ea typeface="Calibri" panose="020F0502020204030204" pitchFamily="34" charset="0"/>
                          <a:cs typeface="Calibri" panose="020F0502020204030204" pitchFamily="34" charset="0"/>
                        </a:rPr>
                        <a:t>M</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effectLst/>
                          <a:latin typeface="Calibri" panose="020F0502020204030204" pitchFamily="34" charset="0"/>
                          <a:ea typeface="Calibri" panose="020F0502020204030204" pitchFamily="34" charset="0"/>
                          <a:cs typeface="Times New Roman" panose="02020603050405020304" pitchFamily="18" charset="0"/>
                        </a:rPr>
                        <a:t>12.76 </a:t>
                      </a:r>
                      <a:r>
                        <a:rPr lang="en-US" sz="900" dirty="0">
                          <a:effectLst/>
                          <a:latin typeface="Symbol" panose="05050102010706020507" pitchFamily="18" charset="2"/>
                          <a:ea typeface="Calibri" panose="020F0502020204030204" pitchFamily="34" charset="0"/>
                          <a:cs typeface="Times New Roman" panose="02020603050405020304" pitchFamily="18" charset="0"/>
                        </a:rPr>
                        <a:t>m</a:t>
                      </a:r>
                      <a:r>
                        <a:rPr lang="en-US" sz="900" dirty="0">
                          <a:effectLst/>
                          <a:latin typeface="Calibri" panose="020F0502020204030204" pitchFamily="34" charset="0"/>
                          <a:ea typeface="Calibri" panose="020F0502020204030204" pitchFamily="34" charset="0"/>
                          <a:cs typeface="Calibri" panose="020F0502020204030204" pitchFamily="34" charset="0"/>
                        </a:rPr>
                        <a:t>M</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999999"/>
                      </a:solidFill>
                      <a:prstDash val="solid"/>
                      <a:round/>
                      <a:headEnd type="none" w="med" len="med"/>
                      <a:tailEnd type="none" w="med" len="med"/>
                    </a:lnL>
                    <a:lnR w="12700" cap="flat" cmpd="sng" algn="ctr">
                      <a:solidFill>
                        <a:srgbClr val="999999"/>
                      </a:solidFill>
                      <a:prstDash val="solid"/>
                      <a:round/>
                      <a:headEnd type="none" w="med" len="med"/>
                      <a:tailEnd type="none" w="med" len="med"/>
                    </a:lnR>
                    <a:lnT w="12700" cap="flat" cmpd="sng" algn="ctr">
                      <a:solidFill>
                        <a:srgbClr val="999999"/>
                      </a:solidFill>
                      <a:prstDash val="solid"/>
                      <a:round/>
                      <a:headEnd type="none" w="med" len="med"/>
                      <a:tailEnd type="none" w="med" len="med"/>
                    </a:lnT>
                    <a:lnB w="12700" cap="flat" cmpd="sng" algn="ctr">
                      <a:solidFill>
                        <a:srgbClr val="999999"/>
                      </a:solidFill>
                      <a:prstDash val="solid"/>
                      <a:round/>
                      <a:headEnd type="none" w="med" len="med"/>
                      <a:tailEnd type="none" w="med" len="med"/>
                    </a:lnB>
                  </a:tcPr>
                </a:tc>
                <a:extLst>
                  <a:ext uri="{0D108BD9-81ED-4DB2-BD59-A6C34878D82A}">
                    <a16:rowId xmlns:a16="http://schemas.microsoft.com/office/drawing/2014/main" val="869804589"/>
                  </a:ext>
                </a:extLst>
              </a:tr>
            </a:tbl>
          </a:graphicData>
        </a:graphic>
      </p:graphicFrame>
    </p:spTree>
    <p:extLst>
      <p:ext uri="{BB962C8B-B14F-4D97-AF65-F5344CB8AC3E}">
        <p14:creationId xmlns:p14="http://schemas.microsoft.com/office/powerpoint/2010/main" val="35130495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5F8C4D2-91FA-45EE-A853-F7E40B93AE51}"/>
              </a:ext>
            </a:extLst>
          </p:cNvPr>
          <p:cNvSpPr txBox="1"/>
          <p:nvPr/>
        </p:nvSpPr>
        <p:spPr>
          <a:xfrm>
            <a:off x="680218" y="6405229"/>
            <a:ext cx="5319061" cy="1679627"/>
          </a:xfrm>
          <a:prstGeom prst="rect">
            <a:avLst/>
          </a:prstGeom>
          <a:noFill/>
        </p:spPr>
        <p:txBody>
          <a:bodyPr wrap="square" rtlCol="0">
            <a:spAutoFit/>
          </a:bodyPr>
          <a:lstStyle/>
          <a:p>
            <a:pPr>
              <a:lnSpc>
                <a:spcPct val="150000"/>
              </a:lnSpc>
            </a:pPr>
            <a:r>
              <a:rPr lang="en-US" sz="1000" b="1" dirty="0">
                <a:latin typeface="Arial" panose="020B0604020202020204" pitchFamily="34" charset="0"/>
                <a:cs typeface="Arial" panose="020B0604020202020204" pitchFamily="34" charset="0"/>
              </a:rPr>
              <a:t>Figure S3. </a:t>
            </a:r>
            <a:r>
              <a:rPr lang="en-US" sz="1000" dirty="0">
                <a:latin typeface="Arial" panose="020B0604020202020204" pitchFamily="34" charset="0"/>
                <a:cs typeface="Arial" panose="020B0604020202020204" pitchFamily="34" charset="0"/>
              </a:rPr>
              <a:t>Diversity of iVDRV  consensus sequences.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Nucleotide and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amino acid substitutions in iVDRV genomes relative to parental RA27/3 virus (GenBank #FJ211588) are depicted as vertical lines. The positions of the coding sequences (CDS) of the nonstructural and structural precursors (yellow pointed bars) and mature protein CDSs (green pointed bars) in the genomic sequence are indicated below the RA27/3 reference sequence. The total number of substitutions are shown for each iVDRV in the table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number of ambiguous disagreements are in parenesis. </a:t>
            </a:r>
          </a:p>
        </p:txBody>
      </p:sp>
      <p:pic>
        <p:nvPicPr>
          <p:cNvPr id="14" name="Picture 13" descr="Timeline&#10;&#10;Description automatically generated with medium confidence">
            <a:extLst>
              <a:ext uri="{FF2B5EF4-FFF2-40B4-BE49-F238E27FC236}">
                <a16:creationId xmlns:a16="http://schemas.microsoft.com/office/drawing/2014/main" id="{160A2E07-4B21-4669-8B25-8B49BC1DD09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8544" y="2506570"/>
            <a:ext cx="5595730" cy="975846"/>
          </a:xfrm>
          <a:prstGeom prst="rect">
            <a:avLst/>
          </a:prstGeom>
        </p:spPr>
      </p:pic>
      <p:pic>
        <p:nvPicPr>
          <p:cNvPr id="18" name="Picture 17" descr="A picture containing diagram&#10;&#10;Description automatically generated">
            <a:extLst>
              <a:ext uri="{FF2B5EF4-FFF2-40B4-BE49-F238E27FC236}">
                <a16:creationId xmlns:a16="http://schemas.microsoft.com/office/drawing/2014/main" id="{8BD43898-10D6-4518-BDD0-505A854D182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6573" y="1128327"/>
            <a:ext cx="5595730" cy="975846"/>
          </a:xfrm>
          <a:prstGeom prst="rect">
            <a:avLst/>
          </a:prstGeom>
        </p:spPr>
      </p:pic>
      <p:graphicFrame>
        <p:nvGraphicFramePr>
          <p:cNvPr id="3" name="Table 2">
            <a:extLst>
              <a:ext uri="{FF2B5EF4-FFF2-40B4-BE49-F238E27FC236}">
                <a16:creationId xmlns:a16="http://schemas.microsoft.com/office/drawing/2014/main" id="{618FF06B-4D82-408A-B002-DEED8867C78D}"/>
              </a:ext>
            </a:extLst>
          </p:cNvPr>
          <p:cNvGraphicFramePr>
            <a:graphicFrameLocks noGrp="1"/>
          </p:cNvGraphicFramePr>
          <p:nvPr>
            <p:extLst>
              <p:ext uri="{D42A27DB-BD31-4B8C-83A1-F6EECF244321}">
                <p14:modId xmlns:p14="http://schemas.microsoft.com/office/powerpoint/2010/main" val="2053603797"/>
              </p:ext>
            </p:extLst>
          </p:nvPr>
        </p:nvGraphicFramePr>
        <p:xfrm>
          <a:off x="816316" y="3793359"/>
          <a:ext cx="4709271" cy="1868226"/>
        </p:xfrm>
        <a:graphic>
          <a:graphicData uri="http://schemas.openxmlformats.org/drawingml/2006/table">
            <a:tbl>
              <a:tblPr/>
              <a:tblGrid>
                <a:gridCol w="404349">
                  <a:extLst>
                    <a:ext uri="{9D8B030D-6E8A-4147-A177-3AD203B41FA5}">
                      <a16:colId xmlns:a16="http://schemas.microsoft.com/office/drawing/2014/main" val="4253227937"/>
                    </a:ext>
                  </a:extLst>
                </a:gridCol>
                <a:gridCol w="784298">
                  <a:extLst>
                    <a:ext uri="{9D8B030D-6E8A-4147-A177-3AD203B41FA5}">
                      <a16:colId xmlns:a16="http://schemas.microsoft.com/office/drawing/2014/main" val="975058414"/>
                    </a:ext>
                  </a:extLst>
                </a:gridCol>
                <a:gridCol w="948130">
                  <a:extLst>
                    <a:ext uri="{9D8B030D-6E8A-4147-A177-3AD203B41FA5}">
                      <a16:colId xmlns:a16="http://schemas.microsoft.com/office/drawing/2014/main" val="1263596478"/>
                    </a:ext>
                  </a:extLst>
                </a:gridCol>
                <a:gridCol w="428749">
                  <a:extLst>
                    <a:ext uri="{9D8B030D-6E8A-4147-A177-3AD203B41FA5}">
                      <a16:colId xmlns:a16="http://schemas.microsoft.com/office/drawing/2014/main" val="889886580"/>
                    </a:ext>
                  </a:extLst>
                </a:gridCol>
                <a:gridCol w="428749">
                  <a:extLst>
                    <a:ext uri="{9D8B030D-6E8A-4147-A177-3AD203B41FA5}">
                      <a16:colId xmlns:a16="http://schemas.microsoft.com/office/drawing/2014/main" val="2703142762"/>
                    </a:ext>
                  </a:extLst>
                </a:gridCol>
                <a:gridCol w="428749">
                  <a:extLst>
                    <a:ext uri="{9D8B030D-6E8A-4147-A177-3AD203B41FA5}">
                      <a16:colId xmlns:a16="http://schemas.microsoft.com/office/drawing/2014/main" val="3693382047"/>
                    </a:ext>
                  </a:extLst>
                </a:gridCol>
                <a:gridCol w="428749">
                  <a:extLst>
                    <a:ext uri="{9D8B030D-6E8A-4147-A177-3AD203B41FA5}">
                      <a16:colId xmlns:a16="http://schemas.microsoft.com/office/drawing/2014/main" val="323846413"/>
                    </a:ext>
                  </a:extLst>
                </a:gridCol>
                <a:gridCol w="428749">
                  <a:extLst>
                    <a:ext uri="{9D8B030D-6E8A-4147-A177-3AD203B41FA5}">
                      <a16:colId xmlns:a16="http://schemas.microsoft.com/office/drawing/2014/main" val="384209995"/>
                    </a:ext>
                  </a:extLst>
                </a:gridCol>
                <a:gridCol w="428749">
                  <a:extLst>
                    <a:ext uri="{9D8B030D-6E8A-4147-A177-3AD203B41FA5}">
                      <a16:colId xmlns:a16="http://schemas.microsoft.com/office/drawing/2014/main" val="1238511364"/>
                    </a:ext>
                  </a:extLst>
                </a:gridCol>
              </a:tblGrid>
              <a:tr h="135284">
                <a:tc rowSpan="2">
                  <a:txBody>
                    <a:bodyPr/>
                    <a:lstStyle/>
                    <a:p>
                      <a:pPr algn="ctr" fontAlgn="ctr"/>
                      <a:r>
                        <a:rPr lang="en-US" sz="800" b="1" i="0" u="none" strike="noStrike" dirty="0">
                          <a:solidFill>
                            <a:srgbClr val="000000"/>
                          </a:solidFill>
                          <a:effectLst/>
                          <a:latin typeface="Palatino Linotype" panose="02040502050505030304" pitchFamily="18" charset="0"/>
                        </a:rPr>
                        <a:t>Case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en-US" sz="800" b="1" i="0" u="none" strike="noStrike" dirty="0">
                          <a:solidFill>
                            <a:srgbClr val="000000"/>
                          </a:solidFill>
                          <a:effectLst/>
                          <a:latin typeface="Palatino Linotype" panose="02040502050505030304" pitchFamily="18" charset="0"/>
                        </a:rPr>
                        <a:t>Compared to</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en-US" sz="800" b="1" i="0" u="none" strike="noStrike" dirty="0">
                          <a:solidFill>
                            <a:srgbClr val="000000"/>
                          </a:solidFill>
                          <a:effectLst/>
                          <a:latin typeface="Palatino Linotype" panose="02040502050505030304" pitchFamily="18" charset="0"/>
                        </a:rPr>
                        <a:t>Total nucleotide substitutions in whole genom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6">
                  <a:txBody>
                    <a:bodyPr/>
                    <a:lstStyle/>
                    <a:p>
                      <a:pPr algn="ctr" fontAlgn="ctr"/>
                      <a:r>
                        <a:rPr lang="en-US" sz="800" b="1" i="0" u="none" strike="noStrike">
                          <a:solidFill>
                            <a:srgbClr val="000000"/>
                          </a:solidFill>
                          <a:effectLst/>
                          <a:latin typeface="Palatino Linotype" panose="02040502050505030304" pitchFamily="18" charset="0"/>
                        </a:rPr>
                        <a:t>Amino acid substitution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211657814"/>
                  </a:ext>
                </a:extLst>
              </a:tr>
              <a:tr h="332276">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fontAlgn="ctr"/>
                      <a:r>
                        <a:rPr lang="en-US" sz="800" b="1" i="0" u="none" strike="noStrike">
                          <a:solidFill>
                            <a:srgbClr val="000000"/>
                          </a:solidFill>
                          <a:effectLst/>
                          <a:latin typeface="Palatino Linotype" panose="02040502050505030304" pitchFamily="18" charset="0"/>
                        </a:rPr>
                        <a:t>E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effectLst/>
                          <a:latin typeface="Palatino Linotype" panose="02040502050505030304" pitchFamily="18" charset="0"/>
                        </a:rPr>
                        <a:t>E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effectLst/>
                          <a:latin typeface="Palatino Linotype" panose="02040502050505030304" pitchFamily="18" charset="0"/>
                        </a:rPr>
                        <a:t>C</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effectLst/>
                          <a:latin typeface="Palatino Linotype" panose="02040502050505030304" pitchFamily="18" charset="0"/>
                        </a:rPr>
                        <a:t>P90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a:solidFill>
                            <a:srgbClr val="000000"/>
                          </a:solidFill>
                          <a:effectLst/>
                          <a:latin typeface="Palatino Linotype" panose="02040502050505030304" pitchFamily="18" charset="0"/>
                        </a:rPr>
                        <a:t>p150</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1" i="0" u="none" strike="noStrike" dirty="0">
                          <a:solidFill>
                            <a:srgbClr val="000000"/>
                          </a:solidFill>
                          <a:effectLst/>
                          <a:latin typeface="Palatino Linotype" panose="02040502050505030304" pitchFamily="18" charset="0"/>
                        </a:rPr>
                        <a:t>tota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8528070"/>
                  </a:ext>
                </a:extLst>
              </a:tr>
              <a:tr h="171906">
                <a:tc>
                  <a:txBody>
                    <a:bodyPr/>
                    <a:lstStyle/>
                    <a:p>
                      <a:pPr algn="l" fontAlgn="b"/>
                      <a:r>
                        <a:rPr lang="en-US" sz="800" b="0" i="0" u="none" strike="noStrike">
                          <a:solidFill>
                            <a:srgbClr val="000000"/>
                          </a:solidFill>
                          <a:effectLst/>
                          <a:latin typeface="Palatino Linotype" panose="02040502050505030304" pitchFamily="18" charset="0"/>
                        </a:rPr>
                        <a:t>CA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0 vs. RA2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11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3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50948629"/>
                  </a:ext>
                </a:extLst>
              </a:tr>
              <a:tr h="171906">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1 vs.RA2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12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3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75327135"/>
                  </a:ext>
                </a:extLst>
              </a:tr>
              <a:tr h="135284">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1 vs.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Palatino Linotype" panose="02040502050505030304" pitchFamily="18" charset="0"/>
                        </a:rPr>
                        <a:t>21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2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6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40535613"/>
                  </a:ext>
                </a:extLst>
              </a:tr>
              <a:tr h="171906">
                <a:tc>
                  <a:txBody>
                    <a:bodyPr/>
                    <a:lstStyle/>
                    <a:p>
                      <a:pPr algn="l" fontAlgn="b"/>
                      <a:r>
                        <a:rPr lang="en-US" sz="800" b="0" i="0" u="none" strike="noStrike">
                          <a:solidFill>
                            <a:srgbClr val="000000"/>
                          </a:solidFill>
                          <a:effectLst/>
                          <a:latin typeface="Palatino Linotype" panose="02040502050505030304" pitchFamily="18" charset="0"/>
                        </a:rPr>
                        <a:t>RI</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0 vs.RA2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Palatino Linotype" panose="02040502050505030304" pitchFamily="18" charset="0"/>
                        </a:rPr>
                        <a:t>24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2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6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00630232"/>
                  </a:ext>
                </a:extLst>
              </a:tr>
              <a:tr h="171906">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1 vs.RA2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24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6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30764920"/>
                  </a:ext>
                </a:extLst>
              </a:tr>
              <a:tr h="171906">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2 vs.RA2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Palatino Linotype" panose="02040502050505030304" pitchFamily="18" charset="0"/>
                        </a:rPr>
                        <a:t>24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2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6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60165594"/>
                  </a:ext>
                </a:extLst>
              </a:tr>
              <a:tr h="135284">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1 vs.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19 (2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0 (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 (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4 (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4033021"/>
                  </a:ext>
                </a:extLst>
              </a:tr>
              <a:tr h="135284">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2 vs.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22 (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0 (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2 (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5 (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96664501"/>
                  </a:ext>
                </a:extLst>
              </a:tr>
              <a:tr h="135284">
                <a:tc>
                  <a:txBody>
                    <a:bodyPr/>
                    <a:lstStyle/>
                    <a:p>
                      <a:pPr algn="l" fontAlgn="b"/>
                      <a:r>
                        <a:rPr lang="en-US" sz="800" b="0" i="0" u="none" strike="noStrike">
                          <a:solidFill>
                            <a:srgbClr val="000000"/>
                          </a:solidFill>
                          <a:effectLst/>
                          <a:latin typeface="Palatino Linotype" panose="02040502050505030304" pitchFamily="18"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Palatino Linotype" panose="02040502050505030304" pitchFamily="18" charset="0"/>
                        </a:rPr>
                        <a:t>T2 vs.T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dirty="0">
                          <a:solidFill>
                            <a:srgbClr val="000000"/>
                          </a:solidFill>
                          <a:effectLst/>
                          <a:latin typeface="Palatino Linotype" panose="02040502050505030304" pitchFamily="18" charset="0"/>
                        </a:rPr>
                        <a:t>37 (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1 (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Palatino Linotype" panose="02040502050505030304" pitchFamily="18" charset="0"/>
                        </a:rPr>
                        <a:t>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2 (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Palatino Linotype" panose="02040502050505030304" pitchFamily="18" charset="0"/>
                        </a:rPr>
                        <a:t>3 (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47078327"/>
                  </a:ext>
                </a:extLst>
              </a:tr>
            </a:tbl>
          </a:graphicData>
        </a:graphic>
      </p:graphicFrame>
      <p:sp>
        <p:nvSpPr>
          <p:cNvPr id="6" name="TextBox 5">
            <a:extLst>
              <a:ext uri="{FF2B5EF4-FFF2-40B4-BE49-F238E27FC236}">
                <a16:creationId xmlns:a16="http://schemas.microsoft.com/office/drawing/2014/main" id="{4EEBF3E1-EAF0-4182-8D43-6E90DBAB9C72}"/>
              </a:ext>
            </a:extLst>
          </p:cNvPr>
          <p:cNvSpPr txBox="1"/>
          <p:nvPr/>
        </p:nvSpPr>
        <p:spPr>
          <a:xfrm>
            <a:off x="552786" y="851328"/>
            <a:ext cx="1549569"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Nucleotides</a:t>
            </a:r>
          </a:p>
        </p:txBody>
      </p:sp>
      <p:sp>
        <p:nvSpPr>
          <p:cNvPr id="8" name="TextBox 7">
            <a:extLst>
              <a:ext uri="{FF2B5EF4-FFF2-40B4-BE49-F238E27FC236}">
                <a16:creationId xmlns:a16="http://schemas.microsoft.com/office/drawing/2014/main" id="{E5DA449E-F502-42F6-9A3D-E68B41B66CF4}"/>
              </a:ext>
            </a:extLst>
          </p:cNvPr>
          <p:cNvSpPr txBox="1"/>
          <p:nvPr/>
        </p:nvSpPr>
        <p:spPr>
          <a:xfrm>
            <a:off x="606572" y="2179397"/>
            <a:ext cx="1549569"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Amino acids</a:t>
            </a:r>
          </a:p>
        </p:txBody>
      </p:sp>
      <p:sp>
        <p:nvSpPr>
          <p:cNvPr id="9" name="TextBox 8">
            <a:extLst>
              <a:ext uri="{FF2B5EF4-FFF2-40B4-BE49-F238E27FC236}">
                <a16:creationId xmlns:a16="http://schemas.microsoft.com/office/drawing/2014/main" id="{DA5AA404-9DD0-4DBC-AE09-C74D01F3050A}"/>
              </a:ext>
            </a:extLst>
          </p:cNvPr>
          <p:cNvSpPr txBox="1"/>
          <p:nvPr/>
        </p:nvSpPr>
        <p:spPr>
          <a:xfrm>
            <a:off x="606572" y="3547138"/>
            <a:ext cx="2324121"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  </a:t>
            </a:r>
            <a:r>
              <a:rPr lang="en-US" sz="1000" dirty="0">
                <a:latin typeface="Arial" panose="020B0604020202020204" pitchFamily="34" charset="0"/>
                <a:cs typeface="Arial" panose="020B0604020202020204" pitchFamily="34" charset="0"/>
              </a:rPr>
              <a:t>Number of substitutions</a:t>
            </a:r>
          </a:p>
        </p:txBody>
      </p:sp>
    </p:spTree>
    <p:extLst>
      <p:ext uri="{BB962C8B-B14F-4D97-AF65-F5344CB8AC3E}">
        <p14:creationId xmlns:p14="http://schemas.microsoft.com/office/powerpoint/2010/main" val="28649075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53FCA661-7CF5-4EA8-8086-7B4F74AE6B0E}"/>
              </a:ext>
            </a:extLst>
          </p:cNvPr>
          <p:cNvSpPr txBox="1"/>
          <p:nvPr/>
        </p:nvSpPr>
        <p:spPr>
          <a:xfrm>
            <a:off x="3735946" y="570791"/>
            <a:ext cx="841167"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RI case</a:t>
            </a:r>
          </a:p>
        </p:txBody>
      </p:sp>
      <p:grpSp>
        <p:nvGrpSpPr>
          <p:cNvPr id="14" name="Group 13">
            <a:extLst>
              <a:ext uri="{FF2B5EF4-FFF2-40B4-BE49-F238E27FC236}">
                <a16:creationId xmlns:a16="http://schemas.microsoft.com/office/drawing/2014/main" id="{CD0A6AC8-32FA-4510-B3C8-2AAA273D4754}"/>
              </a:ext>
            </a:extLst>
          </p:cNvPr>
          <p:cNvGrpSpPr/>
          <p:nvPr/>
        </p:nvGrpSpPr>
        <p:grpSpPr>
          <a:xfrm>
            <a:off x="818535" y="796600"/>
            <a:ext cx="1662018" cy="3044390"/>
            <a:chOff x="818535" y="1754030"/>
            <a:chExt cx="1650218" cy="3238299"/>
          </a:xfrm>
        </p:grpSpPr>
        <p:pic>
          <p:nvPicPr>
            <p:cNvPr id="3" name="Picture 2" descr="A picture containing diagram&#10;&#10;Description automatically generated">
              <a:extLst>
                <a:ext uri="{FF2B5EF4-FFF2-40B4-BE49-F238E27FC236}">
                  <a16:creationId xmlns:a16="http://schemas.microsoft.com/office/drawing/2014/main" id="{017D7002-3432-4BCD-8379-A118EA2DC8F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05056" y="1835256"/>
              <a:ext cx="1463040" cy="3093497"/>
            </a:xfrm>
            <a:prstGeom prst="rect">
              <a:avLst/>
            </a:prstGeom>
          </p:spPr>
        </p:pic>
        <p:sp>
          <p:nvSpPr>
            <p:cNvPr id="8" name="Oval 7">
              <a:extLst>
                <a:ext uri="{FF2B5EF4-FFF2-40B4-BE49-F238E27FC236}">
                  <a16:creationId xmlns:a16="http://schemas.microsoft.com/office/drawing/2014/main" id="{912408BA-6AAF-487B-8103-E03DCF2C0A49}"/>
                </a:ext>
              </a:extLst>
            </p:cNvPr>
            <p:cNvSpPr/>
            <p:nvPr/>
          </p:nvSpPr>
          <p:spPr>
            <a:xfrm>
              <a:off x="970761" y="1877403"/>
              <a:ext cx="277488" cy="462395"/>
            </a:xfrm>
            <a:prstGeom prst="ellipse">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8E32C665-0181-452F-9993-F4D16F633A28}"/>
                </a:ext>
              </a:extLst>
            </p:cNvPr>
            <p:cNvSpPr/>
            <p:nvPr/>
          </p:nvSpPr>
          <p:spPr>
            <a:xfrm>
              <a:off x="970761" y="4017930"/>
              <a:ext cx="277488" cy="327314"/>
            </a:xfrm>
            <a:prstGeom prst="ellipse">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1D94F09C-229E-4439-87BC-A363A0E5C60C}"/>
                </a:ext>
              </a:extLst>
            </p:cNvPr>
            <p:cNvSpPr/>
            <p:nvPr/>
          </p:nvSpPr>
          <p:spPr>
            <a:xfrm>
              <a:off x="818535" y="1754030"/>
              <a:ext cx="1650218" cy="3238299"/>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3" name="Group 12">
            <a:extLst>
              <a:ext uri="{FF2B5EF4-FFF2-40B4-BE49-F238E27FC236}">
                <a16:creationId xmlns:a16="http://schemas.microsoft.com/office/drawing/2014/main" id="{E22169B2-A3F4-40EB-83D4-6FCC1039A0A1}"/>
              </a:ext>
            </a:extLst>
          </p:cNvPr>
          <p:cNvGrpSpPr/>
          <p:nvPr/>
        </p:nvGrpSpPr>
        <p:grpSpPr>
          <a:xfrm>
            <a:off x="2568101" y="796599"/>
            <a:ext cx="3109618" cy="1932235"/>
            <a:chOff x="2501733" y="2123767"/>
            <a:chExt cx="3109618" cy="1932235"/>
          </a:xfrm>
        </p:grpSpPr>
        <p:pic>
          <p:nvPicPr>
            <p:cNvPr id="5" name="Picture 4" descr="Chart, scatter chart&#10;&#10;Description automatically generated">
              <a:extLst>
                <a:ext uri="{FF2B5EF4-FFF2-40B4-BE49-F238E27FC236}">
                  <a16:creationId xmlns:a16="http://schemas.microsoft.com/office/drawing/2014/main" id="{624CBDB6-D0B3-4E82-9D73-E1F035A107E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02391" y="2220259"/>
              <a:ext cx="3108960" cy="1835743"/>
            </a:xfrm>
            <a:prstGeom prst="rect">
              <a:avLst/>
            </a:prstGeom>
          </p:spPr>
        </p:pic>
        <p:sp>
          <p:nvSpPr>
            <p:cNvPr id="6" name="Oval 5">
              <a:extLst>
                <a:ext uri="{FF2B5EF4-FFF2-40B4-BE49-F238E27FC236}">
                  <a16:creationId xmlns:a16="http://schemas.microsoft.com/office/drawing/2014/main" id="{532EE440-FE70-4B88-9CA0-A67BBED3C564}"/>
                </a:ext>
              </a:extLst>
            </p:cNvPr>
            <p:cNvSpPr/>
            <p:nvPr/>
          </p:nvSpPr>
          <p:spPr>
            <a:xfrm>
              <a:off x="5035735" y="2906103"/>
              <a:ext cx="389660" cy="290946"/>
            </a:xfrm>
            <a:prstGeom prst="ellipse">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6A349AB3-2188-4D13-9605-20EFC83228DB}"/>
                </a:ext>
              </a:extLst>
            </p:cNvPr>
            <p:cNvSpPr/>
            <p:nvPr/>
          </p:nvSpPr>
          <p:spPr>
            <a:xfrm rot="19670948">
              <a:off x="4412466" y="2504503"/>
              <a:ext cx="406977" cy="286924"/>
            </a:xfrm>
            <a:prstGeom prst="ellipse">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AA0381B7-5BC9-4922-973E-59471817D675}"/>
                </a:ext>
              </a:extLst>
            </p:cNvPr>
            <p:cNvSpPr/>
            <p:nvPr/>
          </p:nvSpPr>
          <p:spPr>
            <a:xfrm>
              <a:off x="2501733" y="2123767"/>
              <a:ext cx="3109617" cy="1932235"/>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TextBox 14">
            <a:extLst>
              <a:ext uri="{FF2B5EF4-FFF2-40B4-BE49-F238E27FC236}">
                <a16:creationId xmlns:a16="http://schemas.microsoft.com/office/drawing/2014/main" id="{1179887A-73E5-4A7D-A6B1-332F43AA631E}"/>
              </a:ext>
            </a:extLst>
          </p:cNvPr>
          <p:cNvSpPr txBox="1"/>
          <p:nvPr/>
        </p:nvSpPr>
        <p:spPr>
          <a:xfrm>
            <a:off x="2569990" y="2796517"/>
            <a:ext cx="3107727" cy="1015663"/>
          </a:xfrm>
          <a:prstGeom prst="rect">
            <a:avLst/>
          </a:prstGeom>
          <a:noFill/>
          <a:ln w="6350">
            <a:solidFill>
              <a:schemeClr val="tx1"/>
            </a:solidFill>
          </a:ln>
        </p:spPr>
        <p:txBody>
          <a:bodyPr wrap="square" rtlCol="0">
            <a:spAutoFit/>
          </a:bodyPr>
          <a:lstStyle/>
          <a:p>
            <a:pPr defTabSz="346075">
              <a:tabLst>
                <a:tab pos="631825" algn="l"/>
              </a:tabLst>
            </a:pPr>
            <a:r>
              <a:rPr lang="en-US" sz="1000" dirty="0">
                <a:latin typeface="Arial" panose="020B0604020202020204" pitchFamily="34" charset="0"/>
                <a:cs typeface="Arial" panose="020B0604020202020204" pitchFamily="34" charset="0"/>
              </a:rPr>
              <a:t>Red         	T0 – no treatment</a:t>
            </a:r>
          </a:p>
          <a:p>
            <a:pPr defTabSz="346075">
              <a:tabLst>
                <a:tab pos="631825" algn="l"/>
              </a:tabLst>
            </a:pPr>
            <a:r>
              <a:rPr lang="en-US" sz="1000" dirty="0">
                <a:latin typeface="Arial" panose="020B0604020202020204" pitchFamily="34" charset="0"/>
                <a:cs typeface="Arial" panose="020B0604020202020204" pitchFamily="34" charset="0"/>
              </a:rPr>
              <a:t>Green      	T1 - after NTZ therapy</a:t>
            </a:r>
          </a:p>
          <a:p>
            <a:pPr defTabSz="346075">
              <a:tabLst>
                <a:tab pos="631825" algn="l"/>
              </a:tabLst>
            </a:pPr>
            <a:r>
              <a:rPr lang="en-US" sz="1000" dirty="0">
                <a:latin typeface="Arial" panose="020B0604020202020204" pitchFamily="34" charset="0"/>
                <a:cs typeface="Arial" panose="020B0604020202020204" pitchFamily="34" charset="0"/>
              </a:rPr>
              <a:t>Blue         	T2 - after NTZ therapy</a:t>
            </a:r>
          </a:p>
          <a:p>
            <a:pPr defTabSz="346075">
              <a:tabLst>
                <a:tab pos="631825" algn="l"/>
              </a:tabLst>
            </a:pPr>
            <a:r>
              <a:rPr lang="en-US" sz="1000" dirty="0">
                <a:latin typeface="Arial" panose="020B0604020202020204" pitchFamily="34" charset="0"/>
                <a:cs typeface="Arial" panose="020B0604020202020204" pitchFamily="34" charset="0"/>
              </a:rPr>
              <a:t>Circle       	RVi - E1 sequences in isolated</a:t>
            </a:r>
          </a:p>
          <a:p>
            <a:pPr defTabSz="346075">
              <a:tabLst>
                <a:tab pos="631825" algn="l"/>
              </a:tabLst>
            </a:pPr>
            <a:r>
              <a:rPr lang="en-US" sz="1000" dirty="0">
                <a:latin typeface="Arial" panose="020B0604020202020204" pitchFamily="34" charset="0"/>
                <a:cs typeface="Arial" panose="020B0604020202020204" pitchFamily="34" charset="0"/>
              </a:rPr>
              <a:t>Triangle   	RVs - E1 sequences in granulomas</a:t>
            </a:r>
          </a:p>
          <a:p>
            <a:pPr defTabSz="346075">
              <a:tabLst>
                <a:tab pos="631825" algn="l"/>
              </a:tabLst>
            </a:pPr>
            <a:r>
              <a:rPr lang="en-US" sz="1000" dirty="0">
                <a:latin typeface="Arial" panose="020B0604020202020204" pitchFamily="34" charset="0"/>
                <a:cs typeface="Arial" panose="020B0604020202020204" pitchFamily="34" charset="0"/>
              </a:rPr>
              <a:t>Scale bar   0.002 base substitutions per site</a:t>
            </a:r>
          </a:p>
        </p:txBody>
      </p:sp>
      <p:sp>
        <p:nvSpPr>
          <p:cNvPr id="16" name="TextBox 15">
            <a:extLst>
              <a:ext uri="{FF2B5EF4-FFF2-40B4-BE49-F238E27FC236}">
                <a16:creationId xmlns:a16="http://schemas.microsoft.com/office/drawing/2014/main" id="{D7AC37FD-2D02-4B02-BF1A-879A215C3E1B}"/>
              </a:ext>
            </a:extLst>
          </p:cNvPr>
          <p:cNvSpPr txBox="1"/>
          <p:nvPr/>
        </p:nvSpPr>
        <p:spPr>
          <a:xfrm>
            <a:off x="735414" y="6138090"/>
            <a:ext cx="5709791" cy="1452449"/>
          </a:xfrm>
          <a:prstGeom prst="rect">
            <a:avLst/>
          </a:prstGeom>
          <a:noFill/>
        </p:spPr>
        <p:txBody>
          <a:bodyPr wrap="square" rtlCol="0">
            <a:spAutoFit/>
          </a:bodyPr>
          <a:lstStyle/>
          <a:p>
            <a:pPr>
              <a:lnSpc>
                <a:spcPct val="150000"/>
              </a:lnSpc>
            </a:pPr>
            <a:r>
              <a:rPr lang="en-US" sz="1000" b="1" dirty="0">
                <a:latin typeface="Arial" panose="020B0604020202020204" pitchFamily="34" charset="0"/>
                <a:cs typeface="Arial" panose="020B0604020202020204" pitchFamily="34" charset="0"/>
              </a:rPr>
              <a:t>Figure S4. </a:t>
            </a:r>
            <a:r>
              <a:rPr lang="en-US" sz="1000" dirty="0">
                <a:latin typeface="Arial" panose="020B0604020202020204" pitchFamily="34" charset="0"/>
                <a:cs typeface="Arial" panose="020B0604020202020204" pitchFamily="34" charset="0"/>
              </a:rPr>
              <a:t>iVDRV quasispecies in tissues and viral isolates before and after NTZ therapy. </a:t>
            </a:r>
            <a:r>
              <a:rPr lang="en-US" sz="1000" b="1" dirty="0">
                <a:latin typeface="Arial" panose="020B0604020202020204" pitchFamily="34" charset="0"/>
                <a:cs typeface="Arial" panose="020B0604020202020204" pitchFamily="34" charset="0"/>
              </a:rPr>
              <a:t>A</a:t>
            </a:r>
            <a:r>
              <a:rPr lang="en-US" sz="1000" dirty="0">
                <a:latin typeface="Arial" panose="020B0604020202020204" pitchFamily="34" charset="0"/>
                <a:cs typeface="Arial" panose="020B0604020202020204" pitchFamily="34" charset="0"/>
              </a:rPr>
              <a:t>. </a:t>
            </a:r>
            <a:r>
              <a:rPr lang="en-US" sz="1000" dirty="0">
                <a:latin typeface="Arial" panose="020B0604020202020204" pitchFamily="34" charset="0"/>
                <a:ea typeface="Calibri" panose="020F0502020204030204" pitchFamily="34" charset="0"/>
                <a:cs typeface="Arial" panose="020B0604020202020204" pitchFamily="34" charset="0"/>
              </a:rPr>
              <a:t>Neighbor-</a:t>
            </a:r>
            <a:r>
              <a:rPr lang="en-US" sz="1000" dirty="0">
                <a:latin typeface="Arial" panose="020B0604020202020204" pitchFamily="34" charset="0"/>
                <a:cs typeface="Arial" panose="020B0604020202020204" pitchFamily="34" charset="0"/>
              </a:rPr>
              <a:t>joining tree (non-rooted) for quasispecies within the granuloma samples (triangles) and virus isolates (circles) from the CA and RI cases. </a:t>
            </a:r>
            <a:r>
              <a:rPr lang="en-US" sz="1000" dirty="0">
                <a:latin typeface="Arial" panose="020B0604020202020204" pitchFamily="34" charset="0"/>
                <a:ea typeface="Calibri" panose="020F0502020204030204" pitchFamily="34" charset="0"/>
                <a:cs typeface="Arial" panose="020B0604020202020204" pitchFamily="34" charset="0"/>
              </a:rPr>
              <a:t>The genetic distances were computed using the Maximum Composite Likelihood method and phylogenetic trees were constructed using Mega10 software. B. Diversity parameters of quasispecies in skin lesions. C. Quasispecies diversity in virus isolates.</a:t>
            </a:r>
            <a:endParaRPr lang="en-US" sz="1000" dirty="0"/>
          </a:p>
        </p:txBody>
      </p:sp>
      <p:grpSp>
        <p:nvGrpSpPr>
          <p:cNvPr id="23" name="Group 22">
            <a:extLst>
              <a:ext uri="{FF2B5EF4-FFF2-40B4-BE49-F238E27FC236}">
                <a16:creationId xmlns:a16="http://schemas.microsoft.com/office/drawing/2014/main" id="{68B25D1D-9189-4507-AF5C-7F2B42FDD9B7}"/>
              </a:ext>
            </a:extLst>
          </p:cNvPr>
          <p:cNvGrpSpPr/>
          <p:nvPr/>
        </p:nvGrpSpPr>
        <p:grpSpPr>
          <a:xfrm>
            <a:off x="3643957" y="4044330"/>
            <a:ext cx="2109492" cy="1715471"/>
            <a:chOff x="818534" y="4894914"/>
            <a:chExt cx="2109492" cy="1715471"/>
          </a:xfrm>
        </p:grpSpPr>
        <p:graphicFrame>
          <p:nvGraphicFramePr>
            <p:cNvPr id="17" name="Chart 16">
              <a:extLst>
                <a:ext uri="{FF2B5EF4-FFF2-40B4-BE49-F238E27FC236}">
                  <a16:creationId xmlns:a16="http://schemas.microsoft.com/office/drawing/2014/main" id="{B6BFFCD5-B4DA-402E-BFA2-0927937055F1}"/>
                </a:ext>
              </a:extLst>
            </p:cNvPr>
            <p:cNvGraphicFramePr>
              <a:graphicFrameLocks/>
            </p:cNvGraphicFramePr>
            <p:nvPr>
              <p:extLst>
                <p:ext uri="{D42A27DB-BD31-4B8C-83A1-F6EECF244321}">
                  <p14:modId xmlns:p14="http://schemas.microsoft.com/office/powerpoint/2010/main" val="3560248314"/>
                </p:ext>
              </p:extLst>
            </p:nvPr>
          </p:nvGraphicFramePr>
          <p:xfrm>
            <a:off x="818534" y="4894914"/>
            <a:ext cx="2109492" cy="1481154"/>
          </p:xfrm>
          <a:graphic>
            <a:graphicData uri="http://schemas.openxmlformats.org/drawingml/2006/chart">
              <c:chart xmlns:c="http://schemas.openxmlformats.org/drawingml/2006/chart" xmlns:r="http://schemas.openxmlformats.org/officeDocument/2006/relationships" r:id="rId5"/>
            </a:graphicData>
          </a:graphic>
        </p:graphicFrame>
        <p:sp>
          <p:nvSpPr>
            <p:cNvPr id="2" name="TextBox 1">
              <a:extLst>
                <a:ext uri="{FF2B5EF4-FFF2-40B4-BE49-F238E27FC236}">
                  <a16:creationId xmlns:a16="http://schemas.microsoft.com/office/drawing/2014/main" id="{EE9A5737-B3E6-47B9-8889-B1C6A58C5930}"/>
                </a:ext>
              </a:extLst>
            </p:cNvPr>
            <p:cNvSpPr txBox="1"/>
            <p:nvPr/>
          </p:nvSpPr>
          <p:spPr>
            <a:xfrm>
              <a:off x="1416081" y="6379553"/>
              <a:ext cx="59754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CA RVi </a:t>
              </a:r>
            </a:p>
          </p:txBody>
        </p:sp>
        <p:sp>
          <p:nvSpPr>
            <p:cNvPr id="18" name="TextBox 17">
              <a:extLst>
                <a:ext uri="{FF2B5EF4-FFF2-40B4-BE49-F238E27FC236}">
                  <a16:creationId xmlns:a16="http://schemas.microsoft.com/office/drawing/2014/main" id="{A49E3989-E18D-4A08-A893-615EE9685BD0}"/>
                </a:ext>
              </a:extLst>
            </p:cNvPr>
            <p:cNvSpPr txBox="1"/>
            <p:nvPr/>
          </p:nvSpPr>
          <p:spPr>
            <a:xfrm>
              <a:off x="2090789" y="6379553"/>
              <a:ext cx="59754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I RVi </a:t>
              </a:r>
            </a:p>
          </p:txBody>
        </p:sp>
        <p:cxnSp>
          <p:nvCxnSpPr>
            <p:cNvPr id="21" name="Straight Connector 20">
              <a:extLst>
                <a:ext uri="{FF2B5EF4-FFF2-40B4-BE49-F238E27FC236}">
                  <a16:creationId xmlns:a16="http://schemas.microsoft.com/office/drawing/2014/main" id="{951EFD1B-9388-46FE-A5AF-E4306378FCA6}"/>
                </a:ext>
              </a:extLst>
            </p:cNvPr>
            <p:cNvCxnSpPr>
              <a:cxnSpLocks/>
            </p:cNvCxnSpPr>
            <p:nvPr/>
          </p:nvCxnSpPr>
          <p:spPr>
            <a:xfrm>
              <a:off x="1442941" y="6376068"/>
              <a:ext cx="4572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4D713FD3-24B6-4BB1-A284-C4DDC5FDE57D}"/>
                </a:ext>
              </a:extLst>
            </p:cNvPr>
            <p:cNvCxnSpPr>
              <a:cxnSpLocks/>
            </p:cNvCxnSpPr>
            <p:nvPr/>
          </p:nvCxnSpPr>
          <p:spPr>
            <a:xfrm>
              <a:off x="1992848" y="6376068"/>
              <a:ext cx="73152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aphicFrame>
        <p:nvGraphicFramePr>
          <p:cNvPr id="28" name="Object 27">
            <a:extLst>
              <a:ext uri="{FF2B5EF4-FFF2-40B4-BE49-F238E27FC236}">
                <a16:creationId xmlns:a16="http://schemas.microsoft.com/office/drawing/2014/main" id="{E9533548-8D9D-400A-A97A-06E3097E32CD}"/>
              </a:ext>
            </a:extLst>
          </p:cNvPr>
          <p:cNvGraphicFramePr>
            <a:graphicFrameLocks noChangeAspect="1"/>
          </p:cNvGraphicFramePr>
          <p:nvPr>
            <p:extLst>
              <p:ext uri="{D42A27DB-BD31-4B8C-83A1-F6EECF244321}">
                <p14:modId xmlns:p14="http://schemas.microsoft.com/office/powerpoint/2010/main" val="2006355473"/>
              </p:ext>
            </p:extLst>
          </p:nvPr>
        </p:nvGraphicFramePr>
        <p:xfrm>
          <a:off x="818535" y="4150971"/>
          <a:ext cx="2771775" cy="1343025"/>
        </p:xfrm>
        <a:graphic>
          <a:graphicData uri="http://schemas.openxmlformats.org/presentationml/2006/ole">
            <mc:AlternateContent xmlns:mc="http://schemas.openxmlformats.org/markup-compatibility/2006">
              <mc:Choice xmlns:v="urn:schemas-microsoft-com:vml" Requires="v">
                <p:oleObj spid="_x0000_s3075" name="Worksheet" r:id="rId6" imgW="2771656" imgH="1342871" progId="Excel.Sheet.12">
                  <p:embed/>
                </p:oleObj>
              </mc:Choice>
              <mc:Fallback>
                <p:oleObj name="Worksheet" r:id="rId6" imgW="2771656" imgH="1342871" progId="Excel.Sheet.12">
                  <p:embed/>
                  <p:pic>
                    <p:nvPicPr>
                      <p:cNvPr id="28" name="Object 27">
                        <a:extLst>
                          <a:ext uri="{FF2B5EF4-FFF2-40B4-BE49-F238E27FC236}">
                            <a16:creationId xmlns:a16="http://schemas.microsoft.com/office/drawing/2014/main" id="{E9533548-8D9D-400A-A97A-06E3097E32CD}"/>
                          </a:ext>
                        </a:extLst>
                      </p:cNvPr>
                      <p:cNvPicPr/>
                      <p:nvPr/>
                    </p:nvPicPr>
                    <p:blipFill>
                      <a:blip r:embed="rId7"/>
                      <a:stretch>
                        <a:fillRect/>
                      </a:stretch>
                    </p:blipFill>
                    <p:spPr>
                      <a:xfrm>
                        <a:off x="818535" y="4150971"/>
                        <a:ext cx="2771775" cy="1343025"/>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0D97A794-93DF-4132-A57A-9F177761E2E0}"/>
              </a:ext>
            </a:extLst>
          </p:cNvPr>
          <p:cNvSpPr txBox="1"/>
          <p:nvPr/>
        </p:nvSpPr>
        <p:spPr>
          <a:xfrm>
            <a:off x="1371083" y="570792"/>
            <a:ext cx="95277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 case</a:t>
            </a:r>
          </a:p>
        </p:txBody>
      </p:sp>
      <p:sp>
        <p:nvSpPr>
          <p:cNvPr id="29" name="TextBox 28">
            <a:extLst>
              <a:ext uri="{FF2B5EF4-FFF2-40B4-BE49-F238E27FC236}">
                <a16:creationId xmlns:a16="http://schemas.microsoft.com/office/drawing/2014/main" id="{3D2D728A-FC60-450A-AEF9-9E500AF5D238}"/>
              </a:ext>
            </a:extLst>
          </p:cNvPr>
          <p:cNvSpPr txBox="1"/>
          <p:nvPr/>
        </p:nvSpPr>
        <p:spPr>
          <a:xfrm>
            <a:off x="754123" y="570401"/>
            <a:ext cx="293716"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30" name="TextBox 29">
            <a:extLst>
              <a:ext uri="{FF2B5EF4-FFF2-40B4-BE49-F238E27FC236}">
                <a16:creationId xmlns:a16="http://schemas.microsoft.com/office/drawing/2014/main" id="{F7210DD3-2D86-47FE-A22F-70ACEAE51D2A}"/>
              </a:ext>
            </a:extLst>
          </p:cNvPr>
          <p:cNvSpPr txBox="1"/>
          <p:nvPr/>
        </p:nvSpPr>
        <p:spPr>
          <a:xfrm>
            <a:off x="754123" y="3904750"/>
            <a:ext cx="293716"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32" name="TextBox 31">
            <a:extLst>
              <a:ext uri="{FF2B5EF4-FFF2-40B4-BE49-F238E27FC236}">
                <a16:creationId xmlns:a16="http://schemas.microsoft.com/office/drawing/2014/main" id="{8E94FC1B-4F01-4D77-B3C8-38682C1B1F37}"/>
              </a:ext>
            </a:extLst>
          </p:cNvPr>
          <p:cNvSpPr txBox="1"/>
          <p:nvPr/>
        </p:nvSpPr>
        <p:spPr>
          <a:xfrm>
            <a:off x="3702325" y="3878016"/>
            <a:ext cx="293716"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sp>
        <p:nvSpPr>
          <p:cNvPr id="33" name="TextBox 32">
            <a:extLst>
              <a:ext uri="{FF2B5EF4-FFF2-40B4-BE49-F238E27FC236}">
                <a16:creationId xmlns:a16="http://schemas.microsoft.com/office/drawing/2014/main" id="{7EE23045-7D33-490D-9227-BD224C2CB564}"/>
              </a:ext>
            </a:extLst>
          </p:cNvPr>
          <p:cNvSpPr txBox="1"/>
          <p:nvPr/>
        </p:nvSpPr>
        <p:spPr>
          <a:xfrm>
            <a:off x="866487" y="1345427"/>
            <a:ext cx="524050"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Vi</a:t>
            </a:r>
          </a:p>
        </p:txBody>
      </p:sp>
      <p:sp>
        <p:nvSpPr>
          <p:cNvPr id="34" name="TextBox 33">
            <a:extLst>
              <a:ext uri="{FF2B5EF4-FFF2-40B4-BE49-F238E27FC236}">
                <a16:creationId xmlns:a16="http://schemas.microsoft.com/office/drawing/2014/main" id="{8D3EA077-3C5D-48B8-BCB8-7CEE539FBF8F}"/>
              </a:ext>
            </a:extLst>
          </p:cNvPr>
          <p:cNvSpPr txBox="1"/>
          <p:nvPr/>
        </p:nvSpPr>
        <p:spPr>
          <a:xfrm>
            <a:off x="811798" y="3213198"/>
            <a:ext cx="387862"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Vi</a:t>
            </a:r>
          </a:p>
        </p:txBody>
      </p:sp>
      <p:sp>
        <p:nvSpPr>
          <p:cNvPr id="35" name="TextBox 34">
            <a:extLst>
              <a:ext uri="{FF2B5EF4-FFF2-40B4-BE49-F238E27FC236}">
                <a16:creationId xmlns:a16="http://schemas.microsoft.com/office/drawing/2014/main" id="{95300F00-EEF5-45DD-A5A3-B6E56578259C}"/>
              </a:ext>
            </a:extLst>
          </p:cNvPr>
          <p:cNvSpPr txBox="1"/>
          <p:nvPr/>
        </p:nvSpPr>
        <p:spPr>
          <a:xfrm>
            <a:off x="4268364" y="983326"/>
            <a:ext cx="387862"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Vi</a:t>
            </a:r>
          </a:p>
        </p:txBody>
      </p:sp>
      <p:sp>
        <p:nvSpPr>
          <p:cNvPr id="36" name="TextBox 35">
            <a:extLst>
              <a:ext uri="{FF2B5EF4-FFF2-40B4-BE49-F238E27FC236}">
                <a16:creationId xmlns:a16="http://schemas.microsoft.com/office/drawing/2014/main" id="{32A03A23-0E38-4FC8-9A2B-51F66E9F3AB8}"/>
              </a:ext>
            </a:extLst>
          </p:cNvPr>
          <p:cNvSpPr txBox="1"/>
          <p:nvPr/>
        </p:nvSpPr>
        <p:spPr>
          <a:xfrm>
            <a:off x="5326920" y="1805430"/>
            <a:ext cx="392121"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Vi</a:t>
            </a:r>
          </a:p>
        </p:txBody>
      </p:sp>
    </p:spTree>
    <p:extLst>
      <p:ext uri="{BB962C8B-B14F-4D97-AF65-F5344CB8AC3E}">
        <p14:creationId xmlns:p14="http://schemas.microsoft.com/office/powerpoint/2010/main" val="16649746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169</TotalTime>
  <Words>623</Words>
  <Application>Microsoft Office PowerPoint</Application>
  <PresentationFormat>Letter Paper (8.5x11 in)</PresentationFormat>
  <Paragraphs>161</Paragraphs>
  <Slides>4</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2</vt:i4>
      </vt:variant>
      <vt:variant>
        <vt:lpstr>Slide Titles</vt:lpstr>
      </vt:variant>
      <vt:variant>
        <vt:i4>4</vt:i4>
      </vt:variant>
    </vt:vector>
  </HeadingPairs>
  <TitlesOfParts>
    <vt:vector size="13" baseType="lpstr">
      <vt:lpstr>Arial</vt:lpstr>
      <vt:lpstr>Calibri</vt:lpstr>
      <vt:lpstr>Calibri Light</vt:lpstr>
      <vt:lpstr>Palatino Linotype</vt:lpstr>
      <vt:lpstr>Symbol</vt:lpstr>
      <vt:lpstr>Times New Roman</vt:lpstr>
      <vt:lpstr>Office Theme</vt:lpstr>
      <vt:lpstr>Prism 8</vt:lpstr>
      <vt:lpstr>Worksheet</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relygina, Ludmila M. (CDC/DDID/NCIRD/DVD)</dc:creator>
  <cp:lastModifiedBy>MDPI</cp:lastModifiedBy>
  <cp:revision>9</cp:revision>
  <cp:lastPrinted>2021-12-02T19:37:45Z</cp:lastPrinted>
  <dcterms:created xsi:type="dcterms:W3CDTF">2021-11-03T15:25:01Z</dcterms:created>
  <dcterms:modified xsi:type="dcterms:W3CDTF">2022-03-11T06:39: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b94a7b8-f06c-4dfe-bdcc-9b548fd58c31_Enabled">
    <vt:lpwstr>true</vt:lpwstr>
  </property>
  <property fmtid="{D5CDD505-2E9C-101B-9397-08002B2CF9AE}" pid="3" name="MSIP_Label_7b94a7b8-f06c-4dfe-bdcc-9b548fd58c31_SetDate">
    <vt:lpwstr>2021-11-03T16:12:58Z</vt:lpwstr>
  </property>
  <property fmtid="{D5CDD505-2E9C-101B-9397-08002B2CF9AE}" pid="4" name="MSIP_Label_7b94a7b8-f06c-4dfe-bdcc-9b548fd58c31_Method">
    <vt:lpwstr>Privileged</vt:lpwstr>
  </property>
  <property fmtid="{D5CDD505-2E9C-101B-9397-08002B2CF9AE}" pid="5" name="MSIP_Label_7b94a7b8-f06c-4dfe-bdcc-9b548fd58c31_Name">
    <vt:lpwstr>7b94a7b8-f06c-4dfe-bdcc-9b548fd58c31</vt:lpwstr>
  </property>
  <property fmtid="{D5CDD505-2E9C-101B-9397-08002B2CF9AE}" pid="6" name="MSIP_Label_7b94a7b8-f06c-4dfe-bdcc-9b548fd58c31_SiteId">
    <vt:lpwstr>9ce70869-60db-44fd-abe8-d2767077fc8f</vt:lpwstr>
  </property>
  <property fmtid="{D5CDD505-2E9C-101B-9397-08002B2CF9AE}" pid="7" name="MSIP_Label_7b94a7b8-f06c-4dfe-bdcc-9b548fd58c31_ActionId">
    <vt:lpwstr>d20c814d-6bf3-4af6-9d22-f737e00beeb3</vt:lpwstr>
  </property>
  <property fmtid="{D5CDD505-2E9C-101B-9397-08002B2CF9AE}" pid="8" name="MSIP_Label_7b94a7b8-f06c-4dfe-bdcc-9b548fd58c31_ContentBits">
    <vt:lpwstr>0</vt:lpwstr>
  </property>
</Properties>
</file>